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644" r:id="rId2"/>
    <p:sldId id="262" r:id="rId3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70000"/>
    <a:srgbClr val="3A6143"/>
    <a:srgbClr val="A54545"/>
    <a:srgbClr val="3737FF"/>
    <a:srgbClr val="589466"/>
    <a:srgbClr val="923D3D"/>
    <a:srgbClr val="FF6565"/>
    <a:srgbClr val="9DC3E6"/>
    <a:srgbClr val="003EFF"/>
    <a:srgbClr val="00E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043E759-3652-4405-AE6D-739452E8DA23}" v="120" dt="2020-10-13T05:47:09.68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6327"/>
  </p:normalViewPr>
  <p:slideViewPr>
    <p:cSldViewPr snapToGrid="0">
      <p:cViewPr varScale="1">
        <p:scale>
          <a:sx n="81" d="100"/>
          <a:sy n="81" d="100"/>
        </p:scale>
        <p:origin x="70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handoutMaster" Target="handoutMasters/handoutMaster1.xml"/><Relationship Id="rId10" Type="http://schemas.microsoft.com/office/2016/11/relationships/changesInfo" Target="changesInfos/changesInfo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김 남혁" userId="492584a0ac289ca9" providerId="LiveId" clId="{49873D2D-38D0-4BE6-BCE1-B09ED5D73E5A}"/>
    <pc:docChg chg="modSld">
      <pc:chgData name="김 남혁" userId="492584a0ac289ca9" providerId="LiveId" clId="{49873D2D-38D0-4BE6-BCE1-B09ED5D73E5A}" dt="2020-05-30T07:35:00.638" v="1" actId="208"/>
      <pc:docMkLst>
        <pc:docMk/>
      </pc:docMkLst>
      <pc:sldChg chg="modSp mod">
        <pc:chgData name="김 남혁" userId="492584a0ac289ca9" providerId="LiveId" clId="{49873D2D-38D0-4BE6-BCE1-B09ED5D73E5A}" dt="2020-05-30T07:35:00.638" v="1" actId="208"/>
        <pc:sldMkLst>
          <pc:docMk/>
          <pc:sldMk cId="1442773572" sldId="641"/>
        </pc:sldMkLst>
        <pc:spChg chg="mod">
          <ac:chgData name="김 남혁" userId="492584a0ac289ca9" providerId="LiveId" clId="{49873D2D-38D0-4BE6-BCE1-B09ED5D73E5A}" dt="2020-05-30T07:35:00.638" v="1" actId="208"/>
          <ac:spMkLst>
            <pc:docMk/>
            <pc:sldMk cId="1442773572" sldId="641"/>
            <ac:spMk id="30" creationId="{B4F3ED55-8866-4AFD-A293-E09D78253966}"/>
          </ac:spMkLst>
        </pc:spChg>
        <pc:graphicFrameChg chg="mod">
          <ac:chgData name="김 남혁" userId="492584a0ac289ca9" providerId="LiveId" clId="{49873D2D-38D0-4BE6-BCE1-B09ED5D73E5A}" dt="2020-05-30T07:34:18.913" v="0"/>
          <ac:graphicFrameMkLst>
            <pc:docMk/>
            <pc:sldMk cId="1442773572" sldId="641"/>
            <ac:graphicFrameMk id="32" creationId="{B4903C0E-E766-4B5C-9873-35404887C265}"/>
          </ac:graphicFrameMkLst>
        </pc:graphicFrameChg>
      </pc:sldChg>
    </pc:docChg>
  </pc:docChgLst>
  <pc:docChgLst>
    <pc:chgData name="김 남혁" userId="492584a0ac289ca9" providerId="LiveId" clId="{AB207A6A-A80F-4080-95D2-8BA8A3C2D01F}"/>
    <pc:docChg chg="delSld modSld sldOrd">
      <pc:chgData name="김 남혁" userId="492584a0ac289ca9" providerId="LiveId" clId="{AB207A6A-A80F-4080-95D2-8BA8A3C2D01F}" dt="2019-10-29T01:37:19.198" v="1" actId="2696"/>
      <pc:docMkLst>
        <pc:docMk/>
      </pc:docMkLst>
      <pc:sldChg chg="ord">
        <pc:chgData name="김 남혁" userId="492584a0ac289ca9" providerId="LiveId" clId="{AB207A6A-A80F-4080-95D2-8BA8A3C2D01F}" dt="2019-10-29T01:37:16.969" v="0"/>
        <pc:sldMkLst>
          <pc:docMk/>
          <pc:sldMk cId="2188182994" sldId="630"/>
        </pc:sldMkLst>
      </pc:sldChg>
      <pc:sldChg chg="del">
        <pc:chgData name="김 남혁" userId="492584a0ac289ca9" providerId="LiveId" clId="{AB207A6A-A80F-4080-95D2-8BA8A3C2D01F}" dt="2019-10-29T01:37:19.198" v="1" actId="2696"/>
        <pc:sldMkLst>
          <pc:docMk/>
          <pc:sldMk cId="1741929009" sldId="632"/>
        </pc:sldMkLst>
      </pc:sldChg>
    </pc:docChg>
  </pc:docChgLst>
  <pc:docChgLst>
    <pc:chgData name="김 남혁" userId="492584a0ac289ca9" providerId="LiveId" clId="{8671DAD7-E17F-46EE-8DFB-AEFBFA97E524}"/>
    <pc:docChg chg="undo custSel modSld">
      <pc:chgData name="김 남혁" userId="492584a0ac289ca9" providerId="LiveId" clId="{8671DAD7-E17F-46EE-8DFB-AEFBFA97E524}" dt="2019-12-19T06:07:06.868" v="34" actId="1076"/>
      <pc:docMkLst>
        <pc:docMk/>
      </pc:docMkLst>
      <pc:sldChg chg="addSp modSp">
        <pc:chgData name="김 남혁" userId="492584a0ac289ca9" providerId="LiveId" clId="{8671DAD7-E17F-46EE-8DFB-AEFBFA97E524}" dt="2019-12-19T06:06:49.071" v="25" actId="14100"/>
        <pc:sldMkLst>
          <pc:docMk/>
          <pc:sldMk cId="3598135459" sldId="632"/>
        </pc:sldMkLst>
        <pc:spChg chg="add mod">
          <ac:chgData name="김 남혁" userId="492584a0ac289ca9" providerId="LiveId" clId="{8671DAD7-E17F-46EE-8DFB-AEFBFA97E524}" dt="2019-12-19T06:06:49.071" v="25" actId="14100"/>
          <ac:spMkLst>
            <pc:docMk/>
            <pc:sldMk cId="3598135459" sldId="632"/>
            <ac:spMk id="3" creationId="{38C9AE9F-9721-459A-9EDB-075FB8C27020}"/>
          </ac:spMkLst>
        </pc:spChg>
      </pc:sldChg>
      <pc:sldChg chg="addSp modSp">
        <pc:chgData name="김 남혁" userId="492584a0ac289ca9" providerId="LiveId" clId="{8671DAD7-E17F-46EE-8DFB-AEFBFA97E524}" dt="2019-12-19T06:06:52.834" v="27" actId="20577"/>
        <pc:sldMkLst>
          <pc:docMk/>
          <pc:sldMk cId="17353670" sldId="634"/>
        </pc:sldMkLst>
        <pc:spChg chg="add mod">
          <ac:chgData name="김 남혁" userId="492584a0ac289ca9" providerId="LiveId" clId="{8671DAD7-E17F-46EE-8DFB-AEFBFA97E524}" dt="2019-12-19T06:06:52.834" v="27" actId="20577"/>
          <ac:spMkLst>
            <pc:docMk/>
            <pc:sldMk cId="17353670" sldId="634"/>
            <ac:spMk id="19" creationId="{C625CBCA-A77E-4592-9604-87FBD1BE4BE9}"/>
          </ac:spMkLst>
        </pc:spChg>
      </pc:sldChg>
      <pc:sldChg chg="addSp modSp">
        <pc:chgData name="김 남혁" userId="492584a0ac289ca9" providerId="LiveId" clId="{8671DAD7-E17F-46EE-8DFB-AEFBFA97E524}" dt="2019-12-19T06:07:06.868" v="34" actId="1076"/>
        <pc:sldMkLst>
          <pc:docMk/>
          <pc:sldMk cId="26628413" sldId="635"/>
        </pc:sldMkLst>
        <pc:spChg chg="add mod">
          <ac:chgData name="김 남혁" userId="492584a0ac289ca9" providerId="LiveId" clId="{8671DAD7-E17F-46EE-8DFB-AEFBFA97E524}" dt="2019-12-19T06:07:06.868" v="34" actId="1076"/>
          <ac:spMkLst>
            <pc:docMk/>
            <pc:sldMk cId="26628413" sldId="635"/>
            <ac:spMk id="9" creationId="{EA34BEF1-73C6-416B-A1D5-551DF1C05ABF}"/>
          </ac:spMkLst>
        </pc:spChg>
      </pc:sldChg>
      <pc:sldChg chg="addSp modSp">
        <pc:chgData name="김 남혁" userId="492584a0ac289ca9" providerId="LiveId" clId="{8671DAD7-E17F-46EE-8DFB-AEFBFA97E524}" dt="2019-12-19T06:07:02.424" v="32" actId="2711"/>
        <pc:sldMkLst>
          <pc:docMk/>
          <pc:sldMk cId="4038532872" sldId="636"/>
        </pc:sldMkLst>
        <pc:spChg chg="add mod">
          <ac:chgData name="김 남혁" userId="492584a0ac289ca9" providerId="LiveId" clId="{8671DAD7-E17F-46EE-8DFB-AEFBFA97E524}" dt="2019-12-19T06:07:02.424" v="32" actId="2711"/>
          <ac:spMkLst>
            <pc:docMk/>
            <pc:sldMk cId="4038532872" sldId="636"/>
            <ac:spMk id="22" creationId="{0C0551AF-87B9-4411-9595-D1971A0A53A0}"/>
          </ac:spMkLst>
        </pc:spChg>
      </pc:sldChg>
    </pc:docChg>
  </pc:docChgLst>
  <pc:docChgLst>
    <pc:chgData name="김 남혁" userId="492584a0ac289ca9" providerId="LiveId" clId="{795AA17F-C8FD-4E18-9812-5165A4FA6DEC}"/>
    <pc:docChg chg="undo custSel modSld">
      <pc:chgData name="김 남혁" userId="492584a0ac289ca9" providerId="LiveId" clId="{795AA17F-C8FD-4E18-9812-5165A4FA6DEC}" dt="2019-12-09T05:23:03.602" v="39"/>
      <pc:docMkLst>
        <pc:docMk/>
      </pc:docMkLst>
      <pc:sldChg chg="modSp">
        <pc:chgData name="김 남혁" userId="492584a0ac289ca9" providerId="LiveId" clId="{795AA17F-C8FD-4E18-9812-5165A4FA6DEC}" dt="2019-12-09T05:13:25.022" v="19" actId="1037"/>
        <pc:sldMkLst>
          <pc:docMk/>
          <pc:sldMk cId="3598135459" sldId="632"/>
        </pc:sldMkLst>
        <pc:spChg chg="mod">
          <ac:chgData name="김 남혁" userId="492584a0ac289ca9" providerId="LiveId" clId="{795AA17F-C8FD-4E18-9812-5165A4FA6DEC}" dt="2019-12-09T05:13:25.022" v="19" actId="1037"/>
          <ac:spMkLst>
            <pc:docMk/>
            <pc:sldMk cId="3598135459" sldId="632"/>
            <ac:spMk id="75" creationId="{0C81FDFE-FAAE-454F-B575-4604757C74CA}"/>
          </ac:spMkLst>
        </pc:spChg>
      </pc:sldChg>
      <pc:sldChg chg="modSp">
        <pc:chgData name="김 남혁" userId="492584a0ac289ca9" providerId="LiveId" clId="{795AA17F-C8FD-4E18-9812-5165A4FA6DEC}" dt="2019-12-09T05:23:03.602" v="39"/>
        <pc:sldMkLst>
          <pc:docMk/>
          <pc:sldMk cId="17353670" sldId="634"/>
        </pc:sldMkLst>
        <pc:grpChg chg="mod">
          <ac:chgData name="김 남혁" userId="492584a0ac289ca9" providerId="LiveId" clId="{795AA17F-C8FD-4E18-9812-5165A4FA6DEC}" dt="2019-12-09T05:14:05.216" v="24"/>
          <ac:grpSpMkLst>
            <pc:docMk/>
            <pc:sldMk cId="17353670" sldId="634"/>
            <ac:grpSpMk id="41" creationId="{73A7F7E1-598E-4C7A-AACE-B3B1CB97DF18}"/>
          </ac:grpSpMkLst>
        </pc:grpChg>
        <pc:graphicFrameChg chg="mod">
          <ac:chgData name="김 남혁" userId="492584a0ac289ca9" providerId="LiveId" clId="{795AA17F-C8FD-4E18-9812-5165A4FA6DEC}" dt="2019-12-09T05:14:10.096" v="26" actId="1076"/>
          <ac:graphicFrameMkLst>
            <pc:docMk/>
            <pc:sldMk cId="17353670" sldId="634"/>
            <ac:graphicFrameMk id="39" creationId="{CED6118C-39A7-47E2-B18C-3C3012EC7B1A}"/>
          </ac:graphicFrameMkLst>
        </pc:graphicFrameChg>
        <pc:graphicFrameChg chg="mod">
          <ac:chgData name="김 남혁" userId="492584a0ac289ca9" providerId="LiveId" clId="{795AA17F-C8FD-4E18-9812-5165A4FA6DEC}" dt="2019-12-09T05:23:03.602" v="39"/>
          <ac:graphicFrameMkLst>
            <pc:docMk/>
            <pc:sldMk cId="17353670" sldId="634"/>
            <ac:graphicFrameMk id="40" creationId="{B9303DDE-6752-4455-9EBD-04B48715EA2A}"/>
          </ac:graphicFrameMkLst>
        </pc:graphicFrameChg>
      </pc:sldChg>
      <pc:sldChg chg="modSp">
        <pc:chgData name="김 남혁" userId="492584a0ac289ca9" providerId="LiveId" clId="{795AA17F-C8FD-4E18-9812-5165A4FA6DEC}" dt="2019-12-09T05:15:57.743" v="32"/>
        <pc:sldMkLst>
          <pc:docMk/>
          <pc:sldMk cId="26628413" sldId="635"/>
        </pc:sldMkLst>
        <pc:grpChg chg="mod">
          <ac:chgData name="김 남혁" userId="492584a0ac289ca9" providerId="LiveId" clId="{795AA17F-C8FD-4E18-9812-5165A4FA6DEC}" dt="2019-12-09T05:15:57.743" v="32"/>
          <ac:grpSpMkLst>
            <pc:docMk/>
            <pc:sldMk cId="26628413" sldId="635"/>
            <ac:grpSpMk id="5" creationId="{1B7BDBE5-CD30-4BAF-ABC6-340F95A4CED5}"/>
          </ac:grpSpMkLst>
        </pc:grpChg>
        <pc:graphicFrameChg chg="mod">
          <ac:chgData name="김 남혁" userId="492584a0ac289ca9" providerId="LiveId" clId="{795AA17F-C8FD-4E18-9812-5165A4FA6DEC}" dt="2019-12-09T05:15:21.262" v="30"/>
          <ac:graphicFrameMkLst>
            <pc:docMk/>
            <pc:sldMk cId="26628413" sldId="635"/>
            <ac:graphicFrameMk id="2" creationId="{21A7C6FD-9141-4F2D-9321-6FC0E39403C5}"/>
          </ac:graphicFrameMkLst>
        </pc:graphicFrameChg>
        <pc:graphicFrameChg chg="mod">
          <ac:chgData name="김 남혁" userId="492584a0ac289ca9" providerId="LiveId" clId="{795AA17F-C8FD-4E18-9812-5165A4FA6DEC}" dt="2019-12-09T05:14:46.018" v="28"/>
          <ac:graphicFrameMkLst>
            <pc:docMk/>
            <pc:sldMk cId="26628413" sldId="635"/>
            <ac:graphicFrameMk id="3" creationId="{90B80EF5-57E1-49EE-9BC6-27450068D9FA}"/>
          </ac:graphicFrameMkLst>
        </pc:graphicFrameChg>
        <pc:graphicFrameChg chg="mod">
          <ac:chgData name="김 남혁" userId="492584a0ac289ca9" providerId="LiveId" clId="{795AA17F-C8FD-4E18-9812-5165A4FA6DEC}" dt="2019-12-09T05:15:57.743" v="32"/>
          <ac:graphicFrameMkLst>
            <pc:docMk/>
            <pc:sldMk cId="26628413" sldId="635"/>
            <ac:graphicFrameMk id="4" creationId="{B8502BAC-F7A1-4458-B4E7-7969B38C2F1C}"/>
          </ac:graphicFrameMkLst>
        </pc:graphicFrameChg>
      </pc:sldChg>
      <pc:sldChg chg="modSp">
        <pc:chgData name="김 남혁" userId="492584a0ac289ca9" providerId="LiveId" clId="{795AA17F-C8FD-4E18-9812-5165A4FA6DEC}" dt="2019-12-09T05:16:48.502" v="38"/>
        <pc:sldMkLst>
          <pc:docMk/>
          <pc:sldMk cId="4038532872" sldId="636"/>
        </pc:sldMkLst>
        <pc:graphicFrameChg chg="mod">
          <ac:chgData name="김 남혁" userId="492584a0ac289ca9" providerId="LiveId" clId="{795AA17F-C8FD-4E18-9812-5165A4FA6DEC}" dt="2019-12-09T05:16:19.021" v="34"/>
          <ac:graphicFrameMkLst>
            <pc:docMk/>
            <pc:sldMk cId="4038532872" sldId="636"/>
            <ac:graphicFrameMk id="12" creationId="{A7AF75B3-8F40-455D-A919-C1E4A4325169}"/>
          </ac:graphicFrameMkLst>
        </pc:graphicFrameChg>
        <pc:graphicFrameChg chg="mod">
          <ac:chgData name="김 남혁" userId="492584a0ac289ca9" providerId="LiveId" clId="{795AA17F-C8FD-4E18-9812-5165A4FA6DEC}" dt="2019-12-09T05:16:36.437" v="36"/>
          <ac:graphicFrameMkLst>
            <pc:docMk/>
            <pc:sldMk cId="4038532872" sldId="636"/>
            <ac:graphicFrameMk id="13" creationId="{F003A92B-7DCB-4565-A11E-833C1DD9A4CD}"/>
          </ac:graphicFrameMkLst>
        </pc:graphicFrameChg>
        <pc:graphicFrameChg chg="mod">
          <ac:chgData name="김 남혁" userId="492584a0ac289ca9" providerId="LiveId" clId="{795AA17F-C8FD-4E18-9812-5165A4FA6DEC}" dt="2019-12-09T05:16:48.502" v="38"/>
          <ac:graphicFrameMkLst>
            <pc:docMk/>
            <pc:sldMk cId="4038532872" sldId="636"/>
            <ac:graphicFrameMk id="14" creationId="{6E0CA994-9329-4561-8DE1-1FA7CFA4C71A}"/>
          </ac:graphicFrameMkLst>
        </pc:graphicFrameChg>
      </pc:sldChg>
    </pc:docChg>
  </pc:docChgLst>
  <pc:docChgLst>
    <pc:chgData name="김 남혁" userId="492584a0ac289ca9" providerId="LiveId" clId="{1DF90D81-A5DC-3948-9DAC-D3263BAB6040}"/>
    <pc:docChg chg="undo redo custSel addSld delSld modSld">
      <pc:chgData name="김 남혁" userId="492584a0ac289ca9" providerId="LiveId" clId="{1DF90D81-A5DC-3948-9DAC-D3263BAB6040}" dt="2020-04-16T06:27:29.864" v="1134" actId="2696"/>
      <pc:docMkLst>
        <pc:docMk/>
      </pc:docMkLst>
      <pc:sldChg chg="addSp delSp del">
        <pc:chgData name="김 남혁" userId="492584a0ac289ca9" providerId="LiveId" clId="{1DF90D81-A5DC-3948-9DAC-D3263BAB6040}" dt="2020-04-16T06:27:29.864" v="1134" actId="2696"/>
        <pc:sldMkLst>
          <pc:docMk/>
          <pc:sldMk cId="3598135459" sldId="632"/>
        </pc:sldMkLst>
        <pc:spChg chg="add del">
          <ac:chgData name="김 남혁" userId="492584a0ac289ca9" providerId="LiveId" clId="{1DF90D81-A5DC-3948-9DAC-D3263BAB6040}" dt="2020-04-16T06:11:19.489" v="555" actId="478"/>
          <ac:spMkLst>
            <pc:docMk/>
            <pc:sldMk cId="3598135459" sldId="632"/>
            <ac:spMk id="81" creationId="{ECF27217-B4F6-774A-931F-7C43E3249716}"/>
          </ac:spMkLst>
        </pc:spChg>
      </pc:sldChg>
      <pc:sldChg chg="addSp delSp modSp add del">
        <pc:chgData name="김 남혁" userId="492584a0ac289ca9" providerId="LiveId" clId="{1DF90D81-A5DC-3948-9DAC-D3263BAB6040}" dt="2020-04-16T06:26:45.425" v="1128" actId="2696"/>
        <pc:sldMkLst>
          <pc:docMk/>
          <pc:sldMk cId="459829726" sldId="637"/>
        </pc:sldMkLst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2" creationId="{42227046-54F3-FA47-8606-419608B530C5}"/>
          </ac:spMkLst>
        </pc:spChg>
        <pc:spChg chg="del">
          <ac:chgData name="김 남혁" userId="492584a0ac289ca9" providerId="LiveId" clId="{1DF90D81-A5DC-3948-9DAC-D3263BAB6040}" dt="2020-04-16T05:13:43.511" v="1" actId="478"/>
          <ac:spMkLst>
            <pc:docMk/>
            <pc:sldMk cId="459829726" sldId="637"/>
            <ac:spMk id="2" creationId="{8D9FA9A5-1FB4-C14D-9FA9-3DEE93C9D34B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3" creationId="{3221D2EC-B3B4-D549-8E0A-422171ED2557}"/>
          </ac:spMkLst>
        </pc:spChg>
        <pc:spChg chg="del">
          <ac:chgData name="김 남혁" userId="492584a0ac289ca9" providerId="LiveId" clId="{1DF90D81-A5DC-3948-9DAC-D3263BAB6040}" dt="2020-04-16T05:13:43.511" v="1" actId="478"/>
          <ac:spMkLst>
            <pc:docMk/>
            <pc:sldMk cId="459829726" sldId="637"/>
            <ac:spMk id="3" creationId="{6F35A8C2-9931-2F4A-8AA4-24C1E1D4E86F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4" creationId="{1A4060DE-35C6-E640-9C74-80789789F3A6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8" creationId="{CA4A57B3-E2A4-7A4F-81B4-CB8D16EB6FD2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9" creationId="{B46CA754-B221-9542-93D5-E3CD5A3AFB12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10" creationId="{14CC0CB0-06A0-6E4C-9DDF-A43727CE9865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11" creationId="{4FE036C2-21B8-454D-88B1-920847913BD7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12" creationId="{C7DD50B3-74DD-D84C-B6BB-6B3D8B07F716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13" creationId="{8097D5DD-647B-DE4E-BAC5-7B02B7DEFD0E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14" creationId="{FA8D67C6-C007-0345-BCB3-AE9C3B61B75B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15" creationId="{E58DADA3-4EB0-2A47-AD53-A5540A280DBF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18" creationId="{204CD047-474C-7446-A68B-6F73E7A0148A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24" creationId="{A6D5F5AC-BF30-7441-BB8A-9C757AB743AB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25" creationId="{A30349C2-8358-0C43-A3FC-1C671F5A741E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30" creationId="{D5D6D9A9-1A4E-124E-AAF4-466296F917F2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31" creationId="{55A722A2-66E6-9542-A462-F1DF994E2F9D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34" creationId="{EDCF5975-4D99-5646-9835-7A3B0143849D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41" creationId="{3E34F7AF-08EA-1D46-9A9A-C48C33B61297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42" creationId="{A016A2DD-051B-784E-A5E0-B788E457130F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43" creationId="{48EF3EB6-C9F5-B84A-BFA0-3CD3DA395993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44" creationId="{6658C688-F87D-B643-8B5C-230E8F5EF19F}"/>
          </ac:spMkLst>
        </pc:spChg>
        <pc:spChg chg="add mod">
          <ac:chgData name="김 남혁" userId="492584a0ac289ca9" providerId="LiveId" clId="{1DF90D81-A5DC-3948-9DAC-D3263BAB6040}" dt="2020-04-16T06:22:22.187" v="963" actId="164"/>
          <ac:spMkLst>
            <pc:docMk/>
            <pc:sldMk cId="459829726" sldId="637"/>
            <ac:spMk id="45" creationId="{020D9A6C-4032-4648-8C22-501A6B4D249B}"/>
          </ac:spMkLst>
        </pc:spChg>
        <pc:grpChg chg="add mod">
          <ac:chgData name="김 남혁" userId="492584a0ac289ca9" providerId="LiveId" clId="{1DF90D81-A5DC-3948-9DAC-D3263BAB6040}" dt="2020-04-16T06:22:22.187" v="963" actId="164"/>
          <ac:grpSpMkLst>
            <pc:docMk/>
            <pc:sldMk cId="459829726" sldId="637"/>
            <ac:grpSpMk id="46" creationId="{377FB015-EB50-5345-9616-5789E798D63D}"/>
          </ac:grpSpMkLst>
        </pc:grpChg>
        <pc:cxnChg chg="add mod">
          <ac:chgData name="김 남혁" userId="492584a0ac289ca9" providerId="LiveId" clId="{1DF90D81-A5DC-3948-9DAC-D3263BAB6040}" dt="2020-04-16T06:22:22.187" v="963" actId="164"/>
          <ac:cxnSpMkLst>
            <pc:docMk/>
            <pc:sldMk cId="459829726" sldId="637"/>
            <ac:cxnSpMk id="6" creationId="{BBC90B74-984C-374A-9138-248B2B31C0D6}"/>
          </ac:cxnSpMkLst>
        </pc:cxnChg>
        <pc:cxnChg chg="add mod">
          <ac:chgData name="김 남혁" userId="492584a0ac289ca9" providerId="LiveId" clId="{1DF90D81-A5DC-3948-9DAC-D3263BAB6040}" dt="2020-04-16T06:22:22.187" v="963" actId="164"/>
          <ac:cxnSpMkLst>
            <pc:docMk/>
            <pc:sldMk cId="459829726" sldId="637"/>
            <ac:cxnSpMk id="20" creationId="{7EB26EE4-69E2-9F44-8189-277811AAFE77}"/>
          </ac:cxnSpMkLst>
        </pc:cxnChg>
        <pc:cxnChg chg="add mod">
          <ac:chgData name="김 남혁" userId="492584a0ac289ca9" providerId="LiveId" clId="{1DF90D81-A5DC-3948-9DAC-D3263BAB6040}" dt="2020-04-16T06:22:22.187" v="963" actId="164"/>
          <ac:cxnSpMkLst>
            <pc:docMk/>
            <pc:sldMk cId="459829726" sldId="637"/>
            <ac:cxnSpMk id="21" creationId="{0A06E6F3-3AE4-B34F-9D5D-A4F46D3811B8}"/>
          </ac:cxnSpMkLst>
        </pc:cxnChg>
        <pc:cxnChg chg="add mod">
          <ac:chgData name="김 남혁" userId="492584a0ac289ca9" providerId="LiveId" clId="{1DF90D81-A5DC-3948-9DAC-D3263BAB6040}" dt="2020-04-16T06:22:22.187" v="963" actId="164"/>
          <ac:cxnSpMkLst>
            <pc:docMk/>
            <pc:sldMk cId="459829726" sldId="637"/>
            <ac:cxnSpMk id="27" creationId="{D96A70FC-39F8-754E-97D6-E090ED31477E}"/>
          </ac:cxnSpMkLst>
        </pc:cxnChg>
        <pc:cxnChg chg="add mod">
          <ac:chgData name="김 남혁" userId="492584a0ac289ca9" providerId="LiveId" clId="{1DF90D81-A5DC-3948-9DAC-D3263BAB6040}" dt="2020-04-16T06:22:22.187" v="963" actId="164"/>
          <ac:cxnSpMkLst>
            <pc:docMk/>
            <pc:sldMk cId="459829726" sldId="637"/>
            <ac:cxnSpMk id="29" creationId="{32E0DB6F-D5C7-DE48-97E2-1421E569943D}"/>
          </ac:cxnSpMkLst>
        </pc:cxnChg>
        <pc:cxnChg chg="add del mod">
          <ac:chgData name="김 남혁" userId="492584a0ac289ca9" providerId="LiveId" clId="{1DF90D81-A5DC-3948-9DAC-D3263BAB6040}" dt="2020-04-16T06:22:22.187" v="963" actId="164"/>
          <ac:cxnSpMkLst>
            <pc:docMk/>
            <pc:sldMk cId="459829726" sldId="637"/>
            <ac:cxnSpMk id="33" creationId="{472F1494-A1A1-E443-A204-8AF920FBBD90}"/>
          </ac:cxnSpMkLst>
        </pc:cxnChg>
        <pc:cxnChg chg="add mod">
          <ac:chgData name="김 남혁" userId="492584a0ac289ca9" providerId="LiveId" clId="{1DF90D81-A5DC-3948-9DAC-D3263BAB6040}" dt="2020-04-16T06:22:22.187" v="963" actId="164"/>
          <ac:cxnSpMkLst>
            <pc:docMk/>
            <pc:sldMk cId="459829726" sldId="637"/>
            <ac:cxnSpMk id="35" creationId="{34BC38A4-8645-8B45-894D-B09F487DA712}"/>
          </ac:cxnSpMkLst>
        </pc:cxnChg>
        <pc:cxnChg chg="add del mod">
          <ac:chgData name="김 남혁" userId="492584a0ac289ca9" providerId="LiveId" clId="{1DF90D81-A5DC-3948-9DAC-D3263BAB6040}" dt="2020-04-16T06:00:18.836" v="447" actId="478"/>
          <ac:cxnSpMkLst>
            <pc:docMk/>
            <pc:sldMk cId="459829726" sldId="637"/>
            <ac:cxnSpMk id="37" creationId="{359085D6-C1B1-D147-86F3-08EACB95A051}"/>
          </ac:cxnSpMkLst>
        </pc:cxnChg>
        <pc:cxnChg chg="add del mod">
          <ac:chgData name="김 남혁" userId="492584a0ac289ca9" providerId="LiveId" clId="{1DF90D81-A5DC-3948-9DAC-D3263BAB6040}" dt="2020-04-16T06:00:15.339" v="446" actId="478"/>
          <ac:cxnSpMkLst>
            <pc:docMk/>
            <pc:sldMk cId="459829726" sldId="637"/>
            <ac:cxnSpMk id="39" creationId="{94C85430-D7F4-3E42-B9DB-431B2B0BB809}"/>
          </ac:cxnSpMkLst>
        </pc:cxnChg>
      </pc:sldChg>
      <pc:sldChg chg="addSp delSp add del">
        <pc:chgData name="김 남혁" userId="492584a0ac289ca9" providerId="LiveId" clId="{1DF90D81-A5DC-3948-9DAC-D3263BAB6040}" dt="2020-04-16T06:26:44.426" v="1127" actId="2696"/>
        <pc:sldMkLst>
          <pc:docMk/>
          <pc:sldMk cId="1574728008" sldId="638"/>
        </pc:sldMkLst>
        <pc:spChg chg="del">
          <ac:chgData name="김 남혁" userId="492584a0ac289ca9" providerId="LiveId" clId="{1DF90D81-A5DC-3948-9DAC-D3263BAB6040}" dt="2020-04-16T05:27:06.341" v="21" actId="478"/>
          <ac:spMkLst>
            <pc:docMk/>
            <pc:sldMk cId="1574728008" sldId="638"/>
            <ac:spMk id="2" creationId="{42227046-54F3-FA47-8606-419608B530C5}"/>
          </ac:spMkLst>
        </pc:spChg>
        <pc:spChg chg="del">
          <ac:chgData name="김 남혁" userId="492584a0ac289ca9" providerId="LiveId" clId="{1DF90D81-A5DC-3948-9DAC-D3263BAB6040}" dt="2020-04-16T05:27:06.341" v="21" actId="478"/>
          <ac:spMkLst>
            <pc:docMk/>
            <pc:sldMk cId="1574728008" sldId="638"/>
            <ac:spMk id="3" creationId="{3221D2EC-B3B4-D549-8E0A-422171ED2557}"/>
          </ac:spMkLst>
        </pc:spChg>
        <pc:spChg chg="del">
          <ac:chgData name="김 남혁" userId="492584a0ac289ca9" providerId="LiveId" clId="{1DF90D81-A5DC-3948-9DAC-D3263BAB6040}" dt="2020-04-16T05:27:06.341" v="21" actId="478"/>
          <ac:spMkLst>
            <pc:docMk/>
            <pc:sldMk cId="1574728008" sldId="638"/>
            <ac:spMk id="4" creationId="{1A4060DE-35C6-E640-9C74-80789789F3A6}"/>
          </ac:spMkLst>
        </pc:spChg>
        <pc:picChg chg="add">
          <ac:chgData name="김 남혁" userId="492584a0ac289ca9" providerId="LiveId" clId="{1DF90D81-A5DC-3948-9DAC-D3263BAB6040}" dt="2020-04-16T05:29:20.786" v="22"/>
          <ac:picMkLst>
            <pc:docMk/>
            <pc:sldMk cId="1574728008" sldId="638"/>
            <ac:picMk id="5" creationId="{2CFFECCE-6E9E-1E4A-98E7-4A1FE85C7501}"/>
          </ac:picMkLst>
        </pc:picChg>
        <pc:cxnChg chg="del">
          <ac:chgData name="김 남혁" userId="492584a0ac289ca9" providerId="LiveId" clId="{1DF90D81-A5DC-3948-9DAC-D3263BAB6040}" dt="2020-04-16T05:27:06.341" v="21" actId="478"/>
          <ac:cxnSpMkLst>
            <pc:docMk/>
            <pc:sldMk cId="1574728008" sldId="638"/>
            <ac:cxnSpMk id="6" creationId="{BBC90B74-984C-374A-9138-248B2B31C0D6}"/>
          </ac:cxnSpMkLst>
        </pc:cxnChg>
      </pc:sldChg>
      <pc:sldChg chg="addSp delSp modSp add">
        <pc:chgData name="김 남혁" userId="492584a0ac289ca9" providerId="LiveId" clId="{1DF90D81-A5DC-3948-9DAC-D3263BAB6040}" dt="2020-04-16T06:27:15.781" v="1133" actId="1037"/>
        <pc:sldMkLst>
          <pc:docMk/>
          <pc:sldMk cId="1356419714" sldId="639"/>
        </pc:sldMkLst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6" creationId="{92C202BB-F027-48AE-A9C3-139ADC809563}"/>
          </ac:spMkLst>
        </pc:spChg>
        <pc:spChg chg="mod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7" creationId="{4B728A01-1F1A-4163-AB86-E4E46E1E1476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9" creationId="{3272BB27-81D5-49DA-AC02-D2E8C518C7FD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26" creationId="{6B428FB0-7849-4671-B2CD-D64051DD78D9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27" creationId="{7E3DEEA7-903B-4008-948C-E427B0371F41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28" creationId="{F74EE607-3725-49A2-BB0A-711473E71F02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29" creationId="{E889EB6A-6C6D-4787-999E-CA8BE7C89379}"/>
          </ac:spMkLst>
        </pc:spChg>
        <pc:spChg chg="mod topLvl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30" creationId="{B4F3ED55-8866-4AFD-A293-E09D78253966}"/>
          </ac:spMkLst>
        </pc:spChg>
        <pc:spChg chg="mod topLvl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33" creationId="{2E10BA94-5A33-4686-A943-92537E72B093}"/>
          </ac:spMkLst>
        </pc:spChg>
        <pc:spChg chg="mod topLvl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35" creationId="{9415D4DC-0168-4505-B997-96598B93B1F5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40" creationId="{DEB50ED1-F03E-4F3D-A199-1734F1969BC2}"/>
          </ac:spMkLst>
        </pc:spChg>
        <pc:spChg chg="mod topLvl">
          <ac:chgData name="김 남혁" userId="492584a0ac289ca9" providerId="LiveId" clId="{1DF90D81-A5DC-3948-9DAC-D3263BAB6040}" dt="2020-04-16T06:20:52.898" v="948" actId="1076"/>
          <ac:spMkLst>
            <pc:docMk/>
            <pc:sldMk cId="1356419714" sldId="639"/>
            <ac:spMk id="41" creationId="{E9855229-E513-4908-AA7A-8A987C599C59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42" creationId="{6BCE8209-76D5-48F2-AD9B-33F3FDF9DCA8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43" creationId="{8F3AF298-A116-4122-9A55-9FC2DB60BC9D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44" creationId="{D1EAD08B-619E-479C-9EEF-EDFB0658EA9C}"/>
          </ac:spMkLst>
        </pc:spChg>
        <pc:spChg chg="mod topLvl">
          <ac:chgData name="김 남혁" userId="492584a0ac289ca9" providerId="LiveId" clId="{1DF90D81-A5DC-3948-9DAC-D3263BAB6040}" dt="2020-04-16T06:21:24.745" v="955" actId="1076"/>
          <ac:spMkLst>
            <pc:docMk/>
            <pc:sldMk cId="1356419714" sldId="639"/>
            <ac:spMk id="45" creationId="{A22016CF-7CF1-419E-BA00-5951D1E148FC}"/>
          </ac:spMkLst>
        </pc:spChg>
        <pc:spChg chg="add del mod">
          <ac:chgData name="김 남혁" userId="492584a0ac289ca9" providerId="LiveId" clId="{1DF90D81-A5DC-3948-9DAC-D3263BAB6040}" dt="2020-04-16T06:20:58.123" v="950" actId="767"/>
          <ac:spMkLst>
            <pc:docMk/>
            <pc:sldMk cId="1356419714" sldId="639"/>
            <ac:spMk id="50" creationId="{7A20C0AB-09EB-3D44-9B91-B421065BF1B5}"/>
          </ac:spMkLst>
        </pc:spChg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52" creationId="{30FDB558-2EDA-4F6E-868C-196FC5B9A59D}"/>
          </ac:spMkLst>
        </pc:spChg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53" creationId="{9AA2CCAA-4857-4631-90C0-DE0614D015BB}"/>
          </ac:spMkLst>
        </pc:spChg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54" creationId="{40FCCFF0-2815-4B25-85E7-858C46D7C4AC}"/>
          </ac:spMkLst>
        </pc:spChg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55" creationId="{8095BC85-93BB-4E7E-AA25-11DF9455613B}"/>
          </ac:spMkLst>
        </pc:spChg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62" creationId="{A89CAF13-4433-43C9-B3B6-6E6837E4FC4A}"/>
          </ac:spMkLst>
        </pc:spChg>
        <pc:spChg chg="del">
          <ac:chgData name="김 남혁" userId="492584a0ac289ca9" providerId="LiveId" clId="{1DF90D81-A5DC-3948-9DAC-D3263BAB6040}" dt="2020-04-16T06:14:41.588" v="627" actId="478"/>
          <ac:spMkLst>
            <pc:docMk/>
            <pc:sldMk cId="1356419714" sldId="639"/>
            <ac:spMk id="65" creationId="{DE78B96C-8710-4A99-B695-7B4D705BBD31}"/>
          </ac:spMkLst>
        </pc:spChg>
        <pc:spChg chg="del">
          <ac:chgData name="김 남혁" userId="492584a0ac289ca9" providerId="LiveId" clId="{1DF90D81-A5DC-3948-9DAC-D3263BAB6040}" dt="2020-04-16T06:14:41.588" v="627" actId="478"/>
          <ac:spMkLst>
            <pc:docMk/>
            <pc:sldMk cId="1356419714" sldId="639"/>
            <ac:spMk id="66" creationId="{9530CD86-7E0E-4EB2-9D20-B98154BCBC05}"/>
          </ac:spMkLst>
        </pc:spChg>
        <pc:spChg chg="del">
          <ac:chgData name="김 남혁" userId="492584a0ac289ca9" providerId="LiveId" clId="{1DF90D81-A5DC-3948-9DAC-D3263BAB6040}" dt="2020-04-16T06:14:41.588" v="627" actId="478"/>
          <ac:spMkLst>
            <pc:docMk/>
            <pc:sldMk cId="1356419714" sldId="639"/>
            <ac:spMk id="67" creationId="{25A34C66-528D-4F60-BA21-71D21711E6B9}"/>
          </ac:spMkLst>
        </pc:spChg>
        <pc:spChg chg="del">
          <ac:chgData name="김 남혁" userId="492584a0ac289ca9" providerId="LiveId" clId="{1DF90D81-A5DC-3948-9DAC-D3263BAB6040}" dt="2020-04-16T06:14:41.588" v="627" actId="478"/>
          <ac:spMkLst>
            <pc:docMk/>
            <pc:sldMk cId="1356419714" sldId="639"/>
            <ac:spMk id="68" creationId="{ECA122AD-F52D-4DE9-9FBA-77D6F864720B}"/>
          </ac:spMkLst>
        </pc:spChg>
        <pc:spChg chg="del">
          <ac:chgData name="김 남혁" userId="492584a0ac289ca9" providerId="LiveId" clId="{1DF90D81-A5DC-3948-9DAC-D3263BAB6040}" dt="2020-04-16T06:14:44.045" v="628" actId="478"/>
          <ac:spMkLst>
            <pc:docMk/>
            <pc:sldMk cId="1356419714" sldId="639"/>
            <ac:spMk id="73" creationId="{AE665CFA-445F-4D2D-AFF7-5B6B53A53885}"/>
          </ac:spMkLst>
        </pc:spChg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75" creationId="{0C81FDFE-FAAE-454F-B575-4604757C74CA}"/>
          </ac:spMkLst>
        </pc:spChg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76" creationId="{504947F9-C87E-403A-9412-53924F76D20F}"/>
          </ac:spMkLst>
        </pc:spChg>
        <pc:spChg chg="del">
          <ac:chgData name="김 남혁" userId="492584a0ac289ca9" providerId="LiveId" clId="{1DF90D81-A5DC-3948-9DAC-D3263BAB6040}" dt="2020-04-16T06:14:38.272" v="626" actId="478"/>
          <ac:spMkLst>
            <pc:docMk/>
            <pc:sldMk cId="1356419714" sldId="639"/>
            <ac:spMk id="77" creationId="{57F7901F-D820-42B7-8E15-9020DCE645EE}"/>
          </ac:spMkLst>
        </pc:spChg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78" creationId="{C1A2D8E3-A1B3-4A4E-AEC1-1EE34655BF54}"/>
          </ac:spMkLst>
        </pc:spChg>
        <pc:spChg chg="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79" creationId="{408F63AF-0A40-4264-B002-A25020FA5697}"/>
          </ac:spMkLst>
        </pc:spChg>
        <pc:spChg chg="mod">
          <ac:chgData name="김 남혁" userId="492584a0ac289ca9" providerId="LiveId" clId="{1DF90D81-A5DC-3948-9DAC-D3263BAB6040}" dt="2020-04-16T06:27:15.781" v="1133" actId="1037"/>
          <ac:spMkLst>
            <pc:docMk/>
            <pc:sldMk cId="1356419714" sldId="639"/>
            <ac:spMk id="80" creationId="{952C1C04-DB7A-4D76-ADD4-87BAB324E957}"/>
          </ac:spMkLst>
        </pc:spChg>
        <pc:spChg chg="del">
          <ac:chgData name="김 남혁" userId="492584a0ac289ca9" providerId="LiveId" clId="{1DF90D81-A5DC-3948-9DAC-D3263BAB6040}" dt="2020-04-16T06:11:22.674" v="556" actId="478"/>
          <ac:spMkLst>
            <pc:docMk/>
            <pc:sldMk cId="1356419714" sldId="639"/>
            <ac:spMk id="81" creationId="{ECF27217-B4F6-774A-931F-7C43E3249716}"/>
          </ac:spMkLst>
        </pc:spChg>
        <pc:spChg chg="add mod">
          <ac:chgData name="김 남혁" userId="492584a0ac289ca9" providerId="LiveId" clId="{1DF90D81-A5DC-3948-9DAC-D3263BAB6040}" dt="2020-04-16T06:20:29.081" v="942" actId="1038"/>
          <ac:spMkLst>
            <pc:docMk/>
            <pc:sldMk cId="1356419714" sldId="639"/>
            <ac:spMk id="82" creationId="{7ABC30EC-C54F-5444-93AC-44B7568055DC}"/>
          </ac:spMkLst>
        </pc:spChg>
        <pc:spChg chg="add del">
          <ac:chgData name="김 남혁" userId="492584a0ac289ca9" providerId="LiveId" clId="{1DF90D81-A5DC-3948-9DAC-D3263BAB6040}" dt="2020-04-16T06:21:31.612" v="957"/>
          <ac:spMkLst>
            <pc:docMk/>
            <pc:sldMk cId="1356419714" sldId="639"/>
            <ac:spMk id="83" creationId="{AB62A5FF-C22F-C041-9A09-CCA44839C85D}"/>
          </ac:spMkLst>
        </pc:spChg>
        <pc:spChg chg="add mod">
          <ac:chgData name="김 남혁" userId="492584a0ac289ca9" providerId="LiveId" clId="{1DF90D81-A5DC-3948-9DAC-D3263BAB6040}" dt="2020-04-16T06:22:11.460" v="962" actId="20577"/>
          <ac:spMkLst>
            <pc:docMk/>
            <pc:sldMk cId="1356419714" sldId="639"/>
            <ac:spMk id="84" creationId="{20095281-880F-8343-8A5A-80C583353FB8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87" creationId="{8D8C6C24-2D6B-E94C-BDCE-C7F392C32B82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88" creationId="{378BFE93-D407-4E4D-8149-539993848B2F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89" creationId="{6DF439C2-04F5-E640-B6BD-73EBA763E7E1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90" creationId="{EA41C7CF-51D7-8142-9D90-3743ADD79C9C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91" creationId="{01420367-80FF-174A-9169-D48CB9BC602C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92" creationId="{7551A16F-2F5A-CE45-A918-9A5C869A6536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93" creationId="{9C1E595F-BC10-3741-A705-FF813375EBE3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94" creationId="{D0F3E9DA-5F29-1C4D-AA36-A4E76A6B7A83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95" creationId="{47A410D3-A89D-FF42-B4C4-9263D10CF26E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96" creationId="{F41AEEBE-BECE-A442-ACA1-E534BFA735B2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97" creationId="{45F317FC-92DC-814B-8EA9-8C7C145AF11F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98" creationId="{896BF139-1BA4-B342-A0DB-AD3A2FC9B78B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101" creationId="{F85D52AB-8643-5648-9707-98D28C93FC76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102" creationId="{E268B682-DA53-744A-87CA-CB945376624B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105" creationId="{ADE4294E-0760-9A41-BD7E-53D10EEAA62F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106" creationId="{09E2ADA1-FD15-6043-9B2C-CC1EFCBB88A5}"/>
          </ac:spMkLst>
        </pc:spChg>
        <pc:spChg chg="mod">
          <ac:chgData name="김 남혁" userId="492584a0ac289ca9" providerId="LiveId" clId="{1DF90D81-A5DC-3948-9DAC-D3263BAB6040}" dt="2020-04-16T06:24:16.314" v="1108" actId="1037"/>
          <ac:spMkLst>
            <pc:docMk/>
            <pc:sldMk cId="1356419714" sldId="639"/>
            <ac:spMk id="108" creationId="{B2E43AC1-91BD-CA4E-8D0D-A73A93733C0B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110" creationId="{32DDCD41-8211-804D-B1BC-09D10398F32F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111" creationId="{D6AC80B3-F966-4D47-80FE-60B3DE45E983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112" creationId="{870E1354-0EC5-374E-A3DC-40C928303857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113" creationId="{647BC473-0A0F-FE48-A505-D9DFE6E7534C}"/>
          </ac:spMkLst>
        </pc:spChg>
        <pc:spChg chg="mod">
          <ac:chgData name="김 남혁" userId="492584a0ac289ca9" providerId="LiveId" clId="{1DF90D81-A5DC-3948-9DAC-D3263BAB6040}" dt="2020-04-16T06:22:51.198" v="971" actId="255"/>
          <ac:spMkLst>
            <pc:docMk/>
            <pc:sldMk cId="1356419714" sldId="639"/>
            <ac:spMk id="114" creationId="{0B33134E-2AEC-1A4A-896E-AE0C0018A379}"/>
          </ac:spMkLst>
        </pc:spChg>
        <pc:grpChg chg="del">
          <ac:chgData name="김 남혁" userId="492584a0ac289ca9" providerId="LiveId" clId="{1DF90D81-A5DC-3948-9DAC-D3263BAB6040}" dt="2020-04-16T06:19:26.982" v="768" actId="165"/>
          <ac:grpSpMkLst>
            <pc:docMk/>
            <pc:sldMk cId="1356419714" sldId="639"/>
            <ac:grpSpMk id="2" creationId="{267269D4-157C-4BB7-AF5B-1E513430E48A}"/>
          </ac:grpSpMkLst>
        </pc:grpChg>
        <pc:grpChg chg="mod topLvl">
          <ac:chgData name="김 남혁" userId="492584a0ac289ca9" providerId="LiveId" clId="{1DF90D81-A5DC-3948-9DAC-D3263BAB6040}" dt="2020-04-16T06:21:24.745" v="955" actId="1076"/>
          <ac:grpSpMkLst>
            <pc:docMk/>
            <pc:sldMk cId="1356419714" sldId="639"/>
            <ac:grpSpMk id="10" creationId="{CD9981C9-B3FC-4DDF-B456-0B9FF86FA4F0}"/>
          </ac:grpSpMkLst>
        </pc:grpChg>
        <pc:grpChg chg="mod topLvl">
          <ac:chgData name="김 남혁" userId="492584a0ac289ca9" providerId="LiveId" clId="{1DF90D81-A5DC-3948-9DAC-D3263BAB6040}" dt="2020-04-16T06:21:24.745" v="955" actId="1076"/>
          <ac:grpSpMkLst>
            <pc:docMk/>
            <pc:sldMk cId="1356419714" sldId="639"/>
            <ac:grpSpMk id="14" creationId="{691D2D72-6215-4BC0-84D6-55AE98F63ADE}"/>
          </ac:grpSpMkLst>
        </pc:grpChg>
        <pc:grpChg chg="mod topLvl">
          <ac:chgData name="김 남혁" userId="492584a0ac289ca9" providerId="LiveId" clId="{1DF90D81-A5DC-3948-9DAC-D3263BAB6040}" dt="2020-04-16T06:21:24.745" v="955" actId="1076"/>
          <ac:grpSpMkLst>
            <pc:docMk/>
            <pc:sldMk cId="1356419714" sldId="639"/>
            <ac:grpSpMk id="18" creationId="{0FC0D2D4-2FC3-4291-B27D-3A3A3A927E88}"/>
          </ac:grpSpMkLst>
        </pc:grpChg>
        <pc:grpChg chg="mod topLvl">
          <ac:chgData name="김 남혁" userId="492584a0ac289ca9" providerId="LiveId" clId="{1DF90D81-A5DC-3948-9DAC-D3263BAB6040}" dt="2020-04-16T06:21:24.745" v="955" actId="1076"/>
          <ac:grpSpMkLst>
            <pc:docMk/>
            <pc:sldMk cId="1356419714" sldId="639"/>
            <ac:grpSpMk id="22" creationId="{2855D960-7DFD-4BDF-8EC3-9A88A135F6B7}"/>
          </ac:grpSpMkLst>
        </pc:grpChg>
        <pc:grpChg chg="add mod">
          <ac:chgData name="김 남혁" userId="492584a0ac289ca9" providerId="LiveId" clId="{1DF90D81-A5DC-3948-9DAC-D3263BAB6040}" dt="2020-04-16T06:23:40.024" v="1055" actId="1038"/>
          <ac:grpSpMkLst>
            <pc:docMk/>
            <pc:sldMk cId="1356419714" sldId="639"/>
            <ac:grpSpMk id="85" creationId="{6D9DA67A-ACFA-A545-A6F8-CA7C4FCECA5A}"/>
          </ac:grpSpMkLst>
        </pc:grpChg>
        <pc:graphicFrameChg chg="mod">
          <ac:chgData name="김 남혁" userId="492584a0ac289ca9" providerId="LiveId" clId="{1DF90D81-A5DC-3948-9DAC-D3263BAB6040}" dt="2020-04-16T06:20:29.081" v="942" actId="1038"/>
          <ac:graphicFrameMkLst>
            <pc:docMk/>
            <pc:sldMk cId="1356419714" sldId="639"/>
            <ac:graphicFrameMk id="8" creationId="{FE907455-0C66-4709-9718-561D73F4009C}"/>
          </ac:graphicFrameMkLst>
        </pc:graphicFrameChg>
        <pc:graphicFrameChg chg="mod topLvl">
          <ac:chgData name="김 남혁" userId="492584a0ac289ca9" providerId="LiveId" clId="{1DF90D81-A5DC-3948-9DAC-D3263BAB6040}" dt="2020-04-16T06:20:29.081" v="942" actId="1038"/>
          <ac:graphicFrameMkLst>
            <pc:docMk/>
            <pc:sldMk cId="1356419714" sldId="639"/>
            <ac:graphicFrameMk id="32" creationId="{B4903C0E-E766-4B5C-9873-35404887C265}"/>
          </ac:graphicFrameMkLst>
        </pc:graphicFrameChg>
        <pc:graphicFrameChg chg="mod">
          <ac:chgData name="김 남혁" userId="492584a0ac289ca9" providerId="LiveId" clId="{1DF90D81-A5DC-3948-9DAC-D3263BAB6040}" dt="2020-04-16T06:20:29.081" v="942" actId="1038"/>
          <ac:graphicFrameMkLst>
            <pc:docMk/>
            <pc:sldMk cId="1356419714" sldId="639"/>
            <ac:graphicFrameMk id="74" creationId="{61171AA9-60C7-42F2-8C0A-0A6E94FC1460}"/>
          </ac:graphicFrameMkLst>
        </pc:graphicFrameChg>
        <pc:picChg chg="mod topLvl">
          <ac:chgData name="김 남혁" userId="492584a0ac289ca9" providerId="LiveId" clId="{1DF90D81-A5DC-3948-9DAC-D3263BAB6040}" dt="2020-04-16T06:21:24.745" v="955" actId="1076"/>
          <ac:picMkLst>
            <pc:docMk/>
            <pc:sldMk cId="1356419714" sldId="639"/>
            <ac:picMk id="4" creationId="{7A68EC50-457D-450A-874D-70689F9B989C}"/>
          </ac:picMkLst>
        </pc:picChg>
        <pc:picChg chg="mod topLvl">
          <ac:chgData name="김 남혁" userId="492584a0ac289ca9" providerId="LiveId" clId="{1DF90D81-A5DC-3948-9DAC-D3263BAB6040}" dt="2020-04-16T06:21:24.745" v="955" actId="1076"/>
          <ac:picMkLst>
            <pc:docMk/>
            <pc:sldMk cId="1356419714" sldId="639"/>
            <ac:picMk id="5" creationId="{CEE0FF5C-DF00-429E-AF1E-7C883DFDF3C2}"/>
          </ac:picMkLst>
        </pc:picChg>
        <pc:picChg chg="mod topLvl">
          <ac:chgData name="김 남혁" userId="492584a0ac289ca9" providerId="LiveId" clId="{1DF90D81-A5DC-3948-9DAC-D3263BAB6040}" dt="2020-04-16T06:20:29.081" v="942" actId="1038"/>
          <ac:picMkLst>
            <pc:docMk/>
            <pc:sldMk cId="1356419714" sldId="639"/>
            <ac:picMk id="34" creationId="{3F9642FF-C9D1-4F7F-8498-DFE3A09D9B3C}"/>
          </ac:picMkLst>
        </pc:picChg>
        <pc:picChg chg="mod modCrop">
          <ac:chgData name="김 남혁" userId="492584a0ac289ca9" providerId="LiveId" clId="{1DF90D81-A5DC-3948-9DAC-D3263BAB6040}" dt="2020-04-16T06:20:29.081" v="942" actId="1038"/>
          <ac:picMkLst>
            <pc:docMk/>
            <pc:sldMk cId="1356419714" sldId="639"/>
            <ac:picMk id="51" creationId="{5BC1CEB2-4FBF-47D3-BD72-BAF361885FA3}"/>
          </ac:picMkLst>
        </pc:picChg>
        <pc:picChg chg="mod modCrop">
          <ac:chgData name="김 남혁" userId="492584a0ac289ca9" providerId="LiveId" clId="{1DF90D81-A5DC-3948-9DAC-D3263BAB6040}" dt="2020-04-16T06:20:29.081" v="942" actId="1038"/>
          <ac:picMkLst>
            <pc:docMk/>
            <pc:sldMk cId="1356419714" sldId="639"/>
            <ac:picMk id="61" creationId="{A486F532-7FF8-470A-9D33-E9D81D655EE4}"/>
          </ac:picMkLst>
        </pc:picChg>
        <pc:picChg chg="mod modCrop">
          <ac:chgData name="김 남혁" userId="492584a0ac289ca9" providerId="LiveId" clId="{1DF90D81-A5DC-3948-9DAC-D3263BAB6040}" dt="2020-04-16T06:20:29.081" v="942" actId="1038"/>
          <ac:picMkLst>
            <pc:docMk/>
            <pc:sldMk cId="1356419714" sldId="639"/>
            <ac:picMk id="63" creationId="{BBA60586-AAE4-45F7-AB4F-354005AD3939}"/>
          </ac:picMkLst>
        </pc:picChg>
        <pc:picChg chg="del">
          <ac:chgData name="김 남혁" userId="492584a0ac289ca9" providerId="LiveId" clId="{1DF90D81-A5DC-3948-9DAC-D3263BAB6040}" dt="2020-04-16T06:14:38.272" v="626" actId="478"/>
          <ac:picMkLst>
            <pc:docMk/>
            <pc:sldMk cId="1356419714" sldId="639"/>
            <ac:picMk id="64" creationId="{E6DBA898-4506-4E82-A7F5-F1C7B362AFA5}"/>
          </ac:picMkLst>
        </pc:picChg>
        <pc:cxnChg chg="mod topLvl">
          <ac:chgData name="김 남혁" userId="492584a0ac289ca9" providerId="LiveId" clId="{1DF90D81-A5DC-3948-9DAC-D3263BAB6040}" dt="2020-04-16T06:20:29.081" v="942" actId="1038"/>
          <ac:cxnSpMkLst>
            <pc:docMk/>
            <pc:sldMk cId="1356419714" sldId="639"/>
            <ac:cxnSpMk id="31" creationId="{91F69F0D-4361-46E8-A9F0-F740B10428AE}"/>
          </ac:cxnSpMkLst>
        </pc:cxnChg>
        <pc:cxnChg chg="add del mod">
          <ac:chgData name="김 남혁" userId="492584a0ac289ca9" providerId="LiveId" clId="{1DF90D81-A5DC-3948-9DAC-D3263BAB6040}" dt="2020-04-16T06:17:26.449" v="681" actId="11529"/>
          <ac:cxnSpMkLst>
            <pc:docMk/>
            <pc:sldMk cId="1356419714" sldId="639"/>
            <ac:cxnSpMk id="37" creationId="{468D5AC9-9EE0-3A43-B14E-FAF2A4655819}"/>
          </ac:cxnSpMkLst>
        </pc:cxnChg>
        <pc:cxnChg chg="add mod">
          <ac:chgData name="김 남혁" userId="492584a0ac289ca9" providerId="LiveId" clId="{1DF90D81-A5DC-3948-9DAC-D3263BAB6040}" dt="2020-04-16T06:20:29.081" v="942" actId="1038"/>
          <ac:cxnSpMkLst>
            <pc:docMk/>
            <pc:sldMk cId="1356419714" sldId="639"/>
            <ac:cxnSpMk id="39" creationId="{569A6CFE-450F-FD40-AAB6-1EB3478F95E0}"/>
          </ac:cxnSpMkLst>
        </pc:cxnChg>
        <pc:cxnChg chg="mod topLvl">
          <ac:chgData name="김 남혁" userId="492584a0ac289ca9" providerId="LiveId" clId="{1DF90D81-A5DC-3948-9DAC-D3263BAB6040}" dt="2020-04-16T06:21:24.745" v="955" actId="1076"/>
          <ac:cxnSpMkLst>
            <pc:docMk/>
            <pc:sldMk cId="1356419714" sldId="639"/>
            <ac:cxnSpMk id="46" creationId="{7E6171A7-8E5A-43C3-8142-F9DB3064D7B9}"/>
          </ac:cxnSpMkLst>
        </pc:cxnChg>
        <pc:cxnChg chg="mod topLvl">
          <ac:chgData name="김 남혁" userId="492584a0ac289ca9" providerId="LiveId" clId="{1DF90D81-A5DC-3948-9DAC-D3263BAB6040}" dt="2020-04-16T06:21:24.745" v="955" actId="1076"/>
          <ac:cxnSpMkLst>
            <pc:docMk/>
            <pc:sldMk cId="1356419714" sldId="639"/>
            <ac:cxnSpMk id="47" creationId="{5C6D4E48-9919-442C-B4FC-02B888C4667D}"/>
          </ac:cxnSpMkLst>
        </pc:cxnChg>
        <pc:cxnChg chg="mod topLvl">
          <ac:chgData name="김 남혁" userId="492584a0ac289ca9" providerId="LiveId" clId="{1DF90D81-A5DC-3948-9DAC-D3263BAB6040}" dt="2020-04-16T06:21:24.745" v="955" actId="1076"/>
          <ac:cxnSpMkLst>
            <pc:docMk/>
            <pc:sldMk cId="1356419714" sldId="639"/>
            <ac:cxnSpMk id="48" creationId="{9A97DF8E-BF39-4C2F-88A0-25EE6E6B4344}"/>
          </ac:cxnSpMkLst>
        </pc:cxnChg>
        <pc:cxnChg chg="mod topLvl">
          <ac:chgData name="김 남혁" userId="492584a0ac289ca9" providerId="LiveId" clId="{1DF90D81-A5DC-3948-9DAC-D3263BAB6040}" dt="2020-04-16T06:21:24.745" v="955" actId="1076"/>
          <ac:cxnSpMkLst>
            <pc:docMk/>
            <pc:sldMk cId="1356419714" sldId="639"/>
            <ac:cxnSpMk id="49" creationId="{AC1DC84D-023F-46CC-9687-C08D07FB63B1}"/>
          </ac:cxnSpMkLst>
        </pc:cxnChg>
        <pc:cxnChg chg="mod">
          <ac:chgData name="김 남혁" userId="492584a0ac289ca9" providerId="LiveId" clId="{1DF90D81-A5DC-3948-9DAC-D3263BAB6040}" dt="2020-04-16T06:20:29.081" v="942" actId="1038"/>
          <ac:cxnSpMkLst>
            <pc:docMk/>
            <pc:sldMk cId="1356419714" sldId="639"/>
            <ac:cxnSpMk id="57" creationId="{5F09FB74-4A73-42C9-B284-364D9F3781A6}"/>
          </ac:cxnSpMkLst>
        </pc:cxnChg>
        <pc:cxnChg chg="mod">
          <ac:chgData name="김 남혁" userId="492584a0ac289ca9" providerId="LiveId" clId="{1DF90D81-A5DC-3948-9DAC-D3263BAB6040}" dt="2020-04-16T06:20:29.081" v="942" actId="1038"/>
          <ac:cxnSpMkLst>
            <pc:docMk/>
            <pc:sldMk cId="1356419714" sldId="639"/>
            <ac:cxnSpMk id="58" creationId="{B1A3E002-87AB-41C3-BC4B-46C7DA3FDFD7}"/>
          </ac:cxnSpMkLst>
        </pc:cxnChg>
        <pc:cxnChg chg="mod">
          <ac:chgData name="김 남혁" userId="492584a0ac289ca9" providerId="LiveId" clId="{1DF90D81-A5DC-3948-9DAC-D3263BAB6040}" dt="2020-04-16T06:20:29.081" v="942" actId="1038"/>
          <ac:cxnSpMkLst>
            <pc:docMk/>
            <pc:sldMk cId="1356419714" sldId="639"/>
            <ac:cxnSpMk id="59" creationId="{3D6563E2-05DF-44A1-9BAB-7125BE7194C7}"/>
          </ac:cxnSpMkLst>
        </pc:cxnChg>
        <pc:cxnChg chg="mod">
          <ac:chgData name="김 남혁" userId="492584a0ac289ca9" providerId="LiveId" clId="{1DF90D81-A5DC-3948-9DAC-D3263BAB6040}" dt="2020-04-16T06:20:29.081" v="942" actId="1038"/>
          <ac:cxnSpMkLst>
            <pc:docMk/>
            <pc:sldMk cId="1356419714" sldId="639"/>
            <ac:cxnSpMk id="60" creationId="{E76BC347-9B8F-4AA0-8EFE-F29B884A3976}"/>
          </ac:cxnSpMkLst>
        </pc:cxnChg>
        <pc:cxnChg chg="del">
          <ac:chgData name="김 남혁" userId="492584a0ac289ca9" providerId="LiveId" clId="{1DF90D81-A5DC-3948-9DAC-D3263BAB6040}" dt="2020-04-16T06:14:41.588" v="627" actId="478"/>
          <ac:cxnSpMkLst>
            <pc:docMk/>
            <pc:sldMk cId="1356419714" sldId="639"/>
            <ac:cxnSpMk id="69" creationId="{38D084A2-2979-4CEF-A915-311B1B01EC8F}"/>
          </ac:cxnSpMkLst>
        </pc:cxnChg>
        <pc:cxnChg chg="del">
          <ac:chgData name="김 남혁" userId="492584a0ac289ca9" providerId="LiveId" clId="{1DF90D81-A5DC-3948-9DAC-D3263BAB6040}" dt="2020-04-16T06:14:41.588" v="627" actId="478"/>
          <ac:cxnSpMkLst>
            <pc:docMk/>
            <pc:sldMk cId="1356419714" sldId="639"/>
            <ac:cxnSpMk id="70" creationId="{AFBC33CE-240E-477B-BB1B-CE133F6ECC9E}"/>
          </ac:cxnSpMkLst>
        </pc:cxnChg>
        <pc:cxnChg chg="del">
          <ac:chgData name="김 남혁" userId="492584a0ac289ca9" providerId="LiveId" clId="{1DF90D81-A5DC-3948-9DAC-D3263BAB6040}" dt="2020-04-16T06:14:41.588" v="627" actId="478"/>
          <ac:cxnSpMkLst>
            <pc:docMk/>
            <pc:sldMk cId="1356419714" sldId="639"/>
            <ac:cxnSpMk id="71" creationId="{948375E7-3790-4AF5-B35E-AB689A7105FB}"/>
          </ac:cxnSpMkLst>
        </pc:cxnChg>
        <pc:cxnChg chg="del">
          <ac:chgData name="김 남혁" userId="492584a0ac289ca9" providerId="LiveId" clId="{1DF90D81-A5DC-3948-9DAC-D3263BAB6040}" dt="2020-04-16T06:14:41.588" v="627" actId="478"/>
          <ac:cxnSpMkLst>
            <pc:docMk/>
            <pc:sldMk cId="1356419714" sldId="639"/>
            <ac:cxnSpMk id="72" creationId="{D93FF0E8-644A-4B8D-A84C-121E62D30003}"/>
          </ac:cxnSpMkLst>
        </pc:cxnChg>
        <pc:cxnChg chg="mod">
          <ac:chgData name="김 남혁" userId="492584a0ac289ca9" providerId="LiveId" clId="{1DF90D81-A5DC-3948-9DAC-D3263BAB6040}" dt="2020-04-16T06:23:25.816" v="1014" actId="1037"/>
          <ac:cxnSpMkLst>
            <pc:docMk/>
            <pc:sldMk cId="1356419714" sldId="639"/>
            <ac:cxnSpMk id="86" creationId="{78090105-82F3-904F-A9BE-011E326E4DDE}"/>
          </ac:cxnSpMkLst>
        </pc:cxnChg>
        <pc:cxnChg chg="mod">
          <ac:chgData name="김 남혁" userId="492584a0ac289ca9" providerId="LiveId" clId="{1DF90D81-A5DC-3948-9DAC-D3263BAB6040}" dt="2020-04-16T06:24:21.478" v="1126" actId="1038"/>
          <ac:cxnSpMkLst>
            <pc:docMk/>
            <pc:sldMk cId="1356419714" sldId="639"/>
            <ac:cxnSpMk id="107" creationId="{804CC293-CA0D-CD4C-A112-BA2E749E6D9F}"/>
          </ac:cxnSpMkLst>
        </pc:cxnChg>
      </pc:sldChg>
    </pc:docChg>
  </pc:docChgLst>
  <pc:docChgLst>
    <pc:chgData name="김 남혁" userId="492584a0ac289ca9" providerId="LiveId" clId="{9043E759-3652-4405-AE6D-739452E8DA23}"/>
    <pc:docChg chg="undo custSel addSld delSld modSld">
      <pc:chgData name="김 남혁" userId="492584a0ac289ca9" providerId="LiveId" clId="{9043E759-3652-4405-AE6D-739452E8DA23}" dt="2020-10-13T05:48:27.746" v="333" actId="1076"/>
      <pc:docMkLst>
        <pc:docMk/>
      </pc:docMkLst>
      <pc:sldChg chg="addSp delSp modSp add mod">
        <pc:chgData name="김 남혁" userId="492584a0ac289ca9" providerId="LiveId" clId="{9043E759-3652-4405-AE6D-739452E8DA23}" dt="2020-10-13T05:48:27.746" v="333" actId="1076"/>
        <pc:sldMkLst>
          <pc:docMk/>
          <pc:sldMk cId="1265087927" sldId="262"/>
        </pc:sldMkLst>
        <pc:spChg chg="mod">
          <ac:chgData name="김 남혁" userId="492584a0ac289ca9" providerId="LiveId" clId="{9043E759-3652-4405-AE6D-739452E8DA23}" dt="2020-10-13T05:48:27.746" v="333" actId="1076"/>
          <ac:spMkLst>
            <pc:docMk/>
            <pc:sldMk cId="1265087927" sldId="262"/>
            <ac:spMk id="4" creationId="{2025C43C-A6F4-4573-81C0-2B4039A97B45}"/>
          </ac:spMkLst>
        </pc:spChg>
        <pc:spChg chg="add">
          <ac:chgData name="김 남혁" userId="492584a0ac289ca9" providerId="LiveId" clId="{9043E759-3652-4405-AE6D-739452E8DA23}" dt="2020-10-13T05:39:07.413" v="232" actId="22"/>
          <ac:spMkLst>
            <pc:docMk/>
            <pc:sldMk cId="1265087927" sldId="262"/>
            <ac:spMk id="6" creationId="{EBEC7300-B861-4745-AE4E-67AF57713FD7}"/>
          </ac:spMkLst>
        </pc:spChg>
        <pc:spChg chg="add mod">
          <ac:chgData name="김 남혁" userId="492584a0ac289ca9" providerId="LiveId" clId="{9043E759-3652-4405-AE6D-739452E8DA23}" dt="2020-10-13T05:39:11.007" v="237" actId="20577"/>
          <ac:spMkLst>
            <pc:docMk/>
            <pc:sldMk cId="1265087927" sldId="262"/>
            <ac:spMk id="8" creationId="{B6047127-9382-4E2C-B592-356D97D96C1E}"/>
          </ac:spMkLst>
        </pc:spChg>
        <pc:graphicFrameChg chg="mod modGraphic">
          <ac:chgData name="김 남혁" userId="492584a0ac289ca9" providerId="LiveId" clId="{9043E759-3652-4405-AE6D-739452E8DA23}" dt="2020-10-13T05:48:16.601" v="332" actId="20577"/>
          <ac:graphicFrameMkLst>
            <pc:docMk/>
            <pc:sldMk cId="1265087927" sldId="262"/>
            <ac:graphicFrameMk id="3" creationId="{BF131C7E-034C-4029-A2C1-2822A8FA2917}"/>
          </ac:graphicFrameMkLst>
        </pc:graphicFrameChg>
        <pc:graphicFrameChg chg="add del mod">
          <ac:chgData name="김 남혁" userId="492584a0ac289ca9" providerId="LiveId" clId="{9043E759-3652-4405-AE6D-739452E8DA23}" dt="2020-10-13T05:46:30.509" v="292"/>
          <ac:graphicFrameMkLst>
            <pc:docMk/>
            <pc:sldMk cId="1265087927" sldId="262"/>
            <ac:graphicFrameMk id="9" creationId="{5F78BE9F-8628-4FA0-AD53-29FA248C8035}"/>
          </ac:graphicFrameMkLst>
        </pc:graphicFrameChg>
        <pc:graphicFrameChg chg="add del mod">
          <ac:chgData name="김 남혁" userId="492584a0ac289ca9" providerId="LiveId" clId="{9043E759-3652-4405-AE6D-739452E8DA23}" dt="2020-10-13T05:46:57.057" v="296"/>
          <ac:graphicFrameMkLst>
            <pc:docMk/>
            <pc:sldMk cId="1265087927" sldId="262"/>
            <ac:graphicFrameMk id="10" creationId="{5422564A-7F30-4D2B-908B-17E22AE59D78}"/>
          </ac:graphicFrameMkLst>
        </pc:graphicFrameChg>
      </pc:sldChg>
      <pc:sldChg chg="addSp delSp modSp mod">
        <pc:chgData name="김 남혁" userId="492584a0ac289ca9" providerId="LiveId" clId="{9043E759-3652-4405-AE6D-739452E8DA23}" dt="2020-10-12T08:00:21.725" v="199"/>
        <pc:sldMkLst>
          <pc:docMk/>
          <pc:sldMk cId="17353670" sldId="634"/>
        </pc:sldMkLst>
        <pc:spChg chg="add del mod">
          <ac:chgData name="김 남혁" userId="492584a0ac289ca9" providerId="LiveId" clId="{9043E759-3652-4405-AE6D-739452E8DA23}" dt="2020-10-12T06:52:45.626" v="56" actId="21"/>
          <ac:spMkLst>
            <pc:docMk/>
            <pc:sldMk cId="17353670" sldId="634"/>
            <ac:spMk id="23" creationId="{EC87A68F-43A7-4604-960E-D7B48C4CB9CD}"/>
          </ac:spMkLst>
        </pc:spChg>
        <pc:spChg chg="add del mod">
          <ac:chgData name="김 남혁" userId="492584a0ac289ca9" providerId="LiveId" clId="{9043E759-3652-4405-AE6D-739452E8DA23}" dt="2020-10-12T06:52:45.626" v="56" actId="21"/>
          <ac:spMkLst>
            <pc:docMk/>
            <pc:sldMk cId="17353670" sldId="634"/>
            <ac:spMk id="24" creationId="{FAA9FE66-0306-4D90-8D82-20EE5586A9B2}"/>
          </ac:spMkLst>
        </pc:spChg>
        <pc:spChg chg="add del mod">
          <ac:chgData name="김 남혁" userId="492584a0ac289ca9" providerId="LiveId" clId="{9043E759-3652-4405-AE6D-739452E8DA23}" dt="2020-10-12T06:52:45.626" v="56" actId="21"/>
          <ac:spMkLst>
            <pc:docMk/>
            <pc:sldMk cId="17353670" sldId="634"/>
            <ac:spMk id="25" creationId="{F2B74AAC-1EE0-4AFE-927D-32BDB19487F9}"/>
          </ac:spMkLst>
        </pc:spChg>
        <pc:spChg chg="add del mod">
          <ac:chgData name="김 남혁" userId="492584a0ac289ca9" providerId="LiveId" clId="{9043E759-3652-4405-AE6D-739452E8DA23}" dt="2020-10-12T06:52:45.626" v="56" actId="21"/>
          <ac:spMkLst>
            <pc:docMk/>
            <pc:sldMk cId="17353670" sldId="634"/>
            <ac:spMk id="26" creationId="{AE38F76D-E590-42BD-81DE-D9546D79009D}"/>
          </ac:spMkLst>
        </pc:spChg>
        <pc:spChg chg="mod">
          <ac:chgData name="김 남혁" userId="492584a0ac289ca9" providerId="LiveId" clId="{9043E759-3652-4405-AE6D-739452E8DA23}" dt="2020-10-12T06:53:53.742" v="84" actId="1038"/>
          <ac:spMkLst>
            <pc:docMk/>
            <pc:sldMk cId="17353670" sldId="634"/>
            <ac:spMk id="42" creationId="{77B25049-B463-4326-BD46-917DC05465CF}"/>
          </ac:spMkLst>
        </pc:spChg>
        <pc:spChg chg="mod">
          <ac:chgData name="김 남혁" userId="492584a0ac289ca9" providerId="LiveId" clId="{9043E759-3652-4405-AE6D-739452E8DA23}" dt="2020-10-12T06:53:53.742" v="84" actId="1038"/>
          <ac:spMkLst>
            <pc:docMk/>
            <pc:sldMk cId="17353670" sldId="634"/>
            <ac:spMk id="43" creationId="{A1E12E79-71E7-4FF6-AA3B-5F320FF501BB}"/>
          </ac:spMkLst>
        </pc:spChg>
        <pc:spChg chg="mod">
          <ac:chgData name="김 남혁" userId="492584a0ac289ca9" providerId="LiveId" clId="{9043E759-3652-4405-AE6D-739452E8DA23}" dt="2020-10-12T06:53:53.742" v="84" actId="1038"/>
          <ac:spMkLst>
            <pc:docMk/>
            <pc:sldMk cId="17353670" sldId="634"/>
            <ac:spMk id="44" creationId="{CD8277A5-36C1-4F2E-AACF-4EA665EAD829}"/>
          </ac:spMkLst>
        </pc:spChg>
        <pc:spChg chg="add del mod">
          <ac:chgData name="김 남혁" userId="492584a0ac289ca9" providerId="LiveId" clId="{9043E759-3652-4405-AE6D-739452E8DA23}" dt="2020-10-12T06:52:45.626" v="56" actId="21"/>
          <ac:spMkLst>
            <pc:docMk/>
            <pc:sldMk cId="17353670" sldId="634"/>
            <ac:spMk id="46" creationId="{64D40420-1064-44CE-BA70-AF4761428247}"/>
          </ac:spMkLst>
        </pc:spChg>
        <pc:spChg chg="add del mod">
          <ac:chgData name="김 남혁" userId="492584a0ac289ca9" providerId="LiveId" clId="{9043E759-3652-4405-AE6D-739452E8DA23}" dt="2020-10-12T06:53:20.072" v="64"/>
          <ac:spMkLst>
            <pc:docMk/>
            <pc:sldMk cId="17353670" sldId="634"/>
            <ac:spMk id="48" creationId="{84000E8A-A32B-48BD-92CA-0EB4C0FEF2D7}"/>
          </ac:spMkLst>
        </pc:spChg>
        <pc:spChg chg="add del mod">
          <ac:chgData name="김 남혁" userId="492584a0ac289ca9" providerId="LiveId" clId="{9043E759-3652-4405-AE6D-739452E8DA23}" dt="2020-10-12T06:53:20.072" v="64"/>
          <ac:spMkLst>
            <pc:docMk/>
            <pc:sldMk cId="17353670" sldId="634"/>
            <ac:spMk id="49" creationId="{EDBE116F-E95B-4F0A-9701-C10AD0448DD9}"/>
          </ac:spMkLst>
        </pc:spChg>
        <pc:spChg chg="add del mod">
          <ac:chgData name="김 남혁" userId="492584a0ac289ca9" providerId="LiveId" clId="{9043E759-3652-4405-AE6D-739452E8DA23}" dt="2020-10-12T06:53:20.072" v="64"/>
          <ac:spMkLst>
            <pc:docMk/>
            <pc:sldMk cId="17353670" sldId="634"/>
            <ac:spMk id="50" creationId="{C41EB5F1-93C1-4252-B6DD-81A9FD7C8337}"/>
          </ac:spMkLst>
        </pc:spChg>
        <pc:spChg chg="add del mod">
          <ac:chgData name="김 남혁" userId="492584a0ac289ca9" providerId="LiveId" clId="{9043E759-3652-4405-AE6D-739452E8DA23}" dt="2020-10-12T06:53:20.072" v="64"/>
          <ac:spMkLst>
            <pc:docMk/>
            <pc:sldMk cId="17353670" sldId="634"/>
            <ac:spMk id="51" creationId="{4656B082-27EA-4B54-BF2B-526E296A7238}"/>
          </ac:spMkLst>
        </pc:spChg>
        <pc:spChg chg="add del mod">
          <ac:chgData name="김 남혁" userId="492584a0ac289ca9" providerId="LiveId" clId="{9043E759-3652-4405-AE6D-739452E8DA23}" dt="2020-10-12T06:53:20.072" v="64"/>
          <ac:spMkLst>
            <pc:docMk/>
            <pc:sldMk cId="17353670" sldId="634"/>
            <ac:spMk id="56" creationId="{1EA486A6-5CF1-4981-A2A4-7CB178F2B02A}"/>
          </ac:spMkLst>
        </pc:spChg>
        <pc:spChg chg="add mod">
          <ac:chgData name="김 남혁" userId="492584a0ac289ca9" providerId="LiveId" clId="{9043E759-3652-4405-AE6D-739452E8DA23}" dt="2020-10-12T06:53:33.284" v="68" actId="164"/>
          <ac:spMkLst>
            <pc:docMk/>
            <pc:sldMk cId="17353670" sldId="634"/>
            <ac:spMk id="58" creationId="{083330F4-B5D7-4054-BE32-F22B75CF9AC6}"/>
          </ac:spMkLst>
        </pc:spChg>
        <pc:spChg chg="add mod">
          <ac:chgData name="김 남혁" userId="492584a0ac289ca9" providerId="LiveId" clId="{9043E759-3652-4405-AE6D-739452E8DA23}" dt="2020-10-12T06:53:33.284" v="68" actId="164"/>
          <ac:spMkLst>
            <pc:docMk/>
            <pc:sldMk cId="17353670" sldId="634"/>
            <ac:spMk id="59" creationId="{45B44838-2234-4980-9A4D-3379BE1B3842}"/>
          </ac:spMkLst>
        </pc:spChg>
        <pc:spChg chg="add mod">
          <ac:chgData name="김 남혁" userId="492584a0ac289ca9" providerId="LiveId" clId="{9043E759-3652-4405-AE6D-739452E8DA23}" dt="2020-10-12T06:53:33.284" v="68" actId="164"/>
          <ac:spMkLst>
            <pc:docMk/>
            <pc:sldMk cId="17353670" sldId="634"/>
            <ac:spMk id="60" creationId="{525D1A28-0B27-4E29-A7B9-0FBC49F71314}"/>
          </ac:spMkLst>
        </pc:spChg>
        <pc:spChg chg="add mod">
          <ac:chgData name="김 남혁" userId="492584a0ac289ca9" providerId="LiveId" clId="{9043E759-3652-4405-AE6D-739452E8DA23}" dt="2020-10-12T06:53:33.284" v="68" actId="164"/>
          <ac:spMkLst>
            <pc:docMk/>
            <pc:sldMk cId="17353670" sldId="634"/>
            <ac:spMk id="61" creationId="{53CA417E-F293-4522-AF3B-1D4EC4A9A617}"/>
          </ac:spMkLst>
        </pc:spChg>
        <pc:spChg chg="add mod">
          <ac:chgData name="김 남혁" userId="492584a0ac289ca9" providerId="LiveId" clId="{9043E759-3652-4405-AE6D-739452E8DA23}" dt="2020-10-12T06:53:33.284" v="68" actId="164"/>
          <ac:spMkLst>
            <pc:docMk/>
            <pc:sldMk cId="17353670" sldId="634"/>
            <ac:spMk id="66" creationId="{D29A41D2-C0AA-4F37-9E88-1A9BCC7C1861}"/>
          </ac:spMkLst>
        </pc:spChg>
        <pc:grpChg chg="add mod ord">
          <ac:chgData name="김 남혁" userId="492584a0ac289ca9" providerId="LiveId" clId="{9043E759-3652-4405-AE6D-739452E8DA23}" dt="2020-10-12T06:53:53.742" v="84" actId="1038"/>
          <ac:grpSpMkLst>
            <pc:docMk/>
            <pc:sldMk cId="17353670" sldId="634"/>
            <ac:grpSpMk id="5" creationId="{A597B7E4-21E1-4474-9866-5159FEF6C330}"/>
          </ac:grpSpMkLst>
        </pc:grpChg>
        <pc:grpChg chg="add del">
          <ac:chgData name="김 남혁" userId="492584a0ac289ca9" providerId="LiveId" clId="{9043E759-3652-4405-AE6D-739452E8DA23}" dt="2020-10-12T06:53:38.461" v="70" actId="478"/>
          <ac:grpSpMkLst>
            <pc:docMk/>
            <pc:sldMk cId="17353670" sldId="634"/>
            <ac:grpSpMk id="28" creationId="{DFB058E4-33D6-4E38-BE6F-DE5A9EFC8526}"/>
          </ac:grpSpMkLst>
        </pc:grpChg>
        <pc:graphicFrameChg chg="del">
          <ac:chgData name="김 남혁" userId="492584a0ac289ca9" providerId="LiveId" clId="{9043E759-3652-4405-AE6D-739452E8DA23}" dt="2020-10-12T06:49:56.596" v="4" actId="478"/>
          <ac:graphicFrameMkLst>
            <pc:docMk/>
            <pc:sldMk cId="17353670" sldId="634"/>
            <ac:graphicFrameMk id="2" creationId="{4B99D47B-F71F-44F7-8B89-351F4C8B8C3F}"/>
          </ac:graphicFrameMkLst>
        </pc:graphicFrameChg>
        <pc:graphicFrameChg chg="add mod ord">
          <ac:chgData name="김 남혁" userId="492584a0ac289ca9" providerId="LiveId" clId="{9043E759-3652-4405-AE6D-739452E8DA23}" dt="2020-10-12T07:51:37.515" v="197"/>
          <ac:graphicFrameMkLst>
            <pc:docMk/>
            <pc:sldMk cId="17353670" sldId="634"/>
            <ac:graphicFrameMk id="3" creationId="{88CEDEC1-4EAA-4F07-B11C-68BFC09172D8}"/>
          </ac:graphicFrameMkLst>
        </pc:graphicFrameChg>
        <pc:graphicFrameChg chg="add mod ord">
          <ac:chgData name="김 남혁" userId="492584a0ac289ca9" providerId="LiveId" clId="{9043E759-3652-4405-AE6D-739452E8DA23}" dt="2020-10-12T08:00:21.725" v="199"/>
          <ac:graphicFrameMkLst>
            <pc:docMk/>
            <pc:sldMk cId="17353670" sldId="634"/>
            <ac:graphicFrameMk id="4" creationId="{2BEA1450-6B8F-4FB9-9657-0132BF1A322F}"/>
          </ac:graphicFrameMkLst>
        </pc:graphicFrameChg>
        <pc:graphicFrameChg chg="del">
          <ac:chgData name="김 남혁" userId="492584a0ac289ca9" providerId="LiveId" clId="{9043E759-3652-4405-AE6D-739452E8DA23}" dt="2020-10-12T06:50:35.501" v="11" actId="478"/>
          <ac:graphicFrameMkLst>
            <pc:docMk/>
            <pc:sldMk cId="17353670" sldId="634"/>
            <ac:graphicFrameMk id="40" creationId="{B9303DDE-6752-4455-9EBD-04B48715EA2A}"/>
          </ac:graphicFrameMkLst>
        </pc:graphicFrameChg>
        <pc:picChg chg="del">
          <ac:chgData name="김 남혁" userId="492584a0ac289ca9" providerId="LiveId" clId="{9043E759-3652-4405-AE6D-739452E8DA23}" dt="2020-10-12T06:53:39.689" v="71" actId="478"/>
          <ac:picMkLst>
            <pc:docMk/>
            <pc:sldMk cId="17353670" sldId="634"/>
            <ac:picMk id="20" creationId="{8079E4E3-5F8E-45D8-952A-5E972186F948}"/>
          </ac:picMkLst>
        </pc:picChg>
        <pc:picChg chg="add del mod modCrop">
          <ac:chgData name="김 남혁" userId="492584a0ac289ca9" providerId="LiveId" clId="{9043E759-3652-4405-AE6D-739452E8DA23}" dt="2020-10-12T06:52:45.626" v="56" actId="21"/>
          <ac:picMkLst>
            <pc:docMk/>
            <pc:sldMk cId="17353670" sldId="634"/>
            <ac:picMk id="22" creationId="{A2F1076B-8DD5-4F5F-9C82-AF32842EA469}"/>
          </ac:picMkLst>
        </pc:picChg>
        <pc:picChg chg="add del mod">
          <ac:chgData name="김 남혁" userId="492584a0ac289ca9" providerId="LiveId" clId="{9043E759-3652-4405-AE6D-739452E8DA23}" dt="2020-10-12T06:53:20.072" v="64"/>
          <ac:picMkLst>
            <pc:docMk/>
            <pc:sldMk cId="17353670" sldId="634"/>
            <ac:picMk id="47" creationId="{F27122BE-8943-41C9-9F75-0CE22BA2226F}"/>
          </ac:picMkLst>
        </pc:picChg>
        <pc:picChg chg="add mod">
          <ac:chgData name="김 남혁" userId="492584a0ac289ca9" providerId="LiveId" clId="{9043E759-3652-4405-AE6D-739452E8DA23}" dt="2020-10-12T06:53:33.284" v="68" actId="164"/>
          <ac:picMkLst>
            <pc:docMk/>
            <pc:sldMk cId="17353670" sldId="634"/>
            <ac:picMk id="57" creationId="{B1D48195-67EE-4201-8ADD-0F957EBC5DD8}"/>
          </ac:picMkLst>
        </pc:picChg>
        <pc:cxnChg chg="add del mod">
          <ac:chgData name="김 남혁" userId="492584a0ac289ca9" providerId="LiveId" clId="{9043E759-3652-4405-AE6D-739452E8DA23}" dt="2020-10-12T06:52:45.626" v="56" actId="21"/>
          <ac:cxnSpMkLst>
            <pc:docMk/>
            <pc:sldMk cId="17353670" sldId="634"/>
            <ac:cxnSpMk id="27" creationId="{D3223B03-3716-4155-88DC-969668F4097E}"/>
          </ac:cxnSpMkLst>
        </pc:cxnChg>
        <pc:cxnChg chg="add del mod">
          <ac:chgData name="김 남혁" userId="492584a0ac289ca9" providerId="LiveId" clId="{9043E759-3652-4405-AE6D-739452E8DA23}" dt="2020-10-12T06:52:45.626" v="56" actId="21"/>
          <ac:cxnSpMkLst>
            <pc:docMk/>
            <pc:sldMk cId="17353670" sldId="634"/>
            <ac:cxnSpMk id="39" creationId="{00D20B11-B96E-40B4-8239-16D57805FA5D}"/>
          </ac:cxnSpMkLst>
        </pc:cxnChg>
        <pc:cxnChg chg="add del mod">
          <ac:chgData name="김 남혁" userId="492584a0ac289ca9" providerId="LiveId" clId="{9043E759-3652-4405-AE6D-739452E8DA23}" dt="2020-10-12T06:52:45.626" v="56" actId="21"/>
          <ac:cxnSpMkLst>
            <pc:docMk/>
            <pc:sldMk cId="17353670" sldId="634"/>
            <ac:cxnSpMk id="41" creationId="{D6AE1688-C060-4E1B-A4F7-0EC41FF29A75}"/>
          </ac:cxnSpMkLst>
        </pc:cxnChg>
        <pc:cxnChg chg="add del mod">
          <ac:chgData name="김 남혁" userId="492584a0ac289ca9" providerId="LiveId" clId="{9043E759-3652-4405-AE6D-739452E8DA23}" dt="2020-10-12T06:52:45.626" v="56" actId="21"/>
          <ac:cxnSpMkLst>
            <pc:docMk/>
            <pc:sldMk cId="17353670" sldId="634"/>
            <ac:cxnSpMk id="45" creationId="{A7E8EAA8-3EE9-4C21-AF93-A48B48E1EFA5}"/>
          </ac:cxnSpMkLst>
        </pc:cxnChg>
        <pc:cxnChg chg="add del mod">
          <ac:chgData name="김 남혁" userId="492584a0ac289ca9" providerId="LiveId" clId="{9043E759-3652-4405-AE6D-739452E8DA23}" dt="2020-10-12T06:53:20.072" v="64"/>
          <ac:cxnSpMkLst>
            <pc:docMk/>
            <pc:sldMk cId="17353670" sldId="634"/>
            <ac:cxnSpMk id="52" creationId="{CC98F4D6-1E22-4903-9475-C9F73999F956}"/>
          </ac:cxnSpMkLst>
        </pc:cxnChg>
        <pc:cxnChg chg="add del mod">
          <ac:chgData name="김 남혁" userId="492584a0ac289ca9" providerId="LiveId" clId="{9043E759-3652-4405-AE6D-739452E8DA23}" dt="2020-10-12T06:53:20.072" v="64"/>
          <ac:cxnSpMkLst>
            <pc:docMk/>
            <pc:sldMk cId="17353670" sldId="634"/>
            <ac:cxnSpMk id="53" creationId="{583908C6-919D-45B9-9B75-97370E03103E}"/>
          </ac:cxnSpMkLst>
        </pc:cxnChg>
        <pc:cxnChg chg="add del mod">
          <ac:chgData name="김 남혁" userId="492584a0ac289ca9" providerId="LiveId" clId="{9043E759-3652-4405-AE6D-739452E8DA23}" dt="2020-10-12T06:53:20.072" v="64"/>
          <ac:cxnSpMkLst>
            <pc:docMk/>
            <pc:sldMk cId="17353670" sldId="634"/>
            <ac:cxnSpMk id="54" creationId="{B9F367E8-F400-4407-B2C9-AF5DE21406DB}"/>
          </ac:cxnSpMkLst>
        </pc:cxnChg>
        <pc:cxnChg chg="add del mod">
          <ac:chgData name="김 남혁" userId="492584a0ac289ca9" providerId="LiveId" clId="{9043E759-3652-4405-AE6D-739452E8DA23}" dt="2020-10-12T06:53:20.072" v="64"/>
          <ac:cxnSpMkLst>
            <pc:docMk/>
            <pc:sldMk cId="17353670" sldId="634"/>
            <ac:cxnSpMk id="55" creationId="{7F2DB01C-3416-46D9-937E-428970696E20}"/>
          </ac:cxnSpMkLst>
        </pc:cxnChg>
        <pc:cxnChg chg="add mod">
          <ac:chgData name="김 남혁" userId="492584a0ac289ca9" providerId="LiveId" clId="{9043E759-3652-4405-AE6D-739452E8DA23}" dt="2020-10-12T06:53:33.284" v="68" actId="164"/>
          <ac:cxnSpMkLst>
            <pc:docMk/>
            <pc:sldMk cId="17353670" sldId="634"/>
            <ac:cxnSpMk id="62" creationId="{F5E43360-207F-4B0E-8FA7-7D886DA63EE9}"/>
          </ac:cxnSpMkLst>
        </pc:cxnChg>
        <pc:cxnChg chg="add mod">
          <ac:chgData name="김 남혁" userId="492584a0ac289ca9" providerId="LiveId" clId="{9043E759-3652-4405-AE6D-739452E8DA23}" dt="2020-10-12T06:53:33.284" v="68" actId="164"/>
          <ac:cxnSpMkLst>
            <pc:docMk/>
            <pc:sldMk cId="17353670" sldId="634"/>
            <ac:cxnSpMk id="63" creationId="{4D44B1A5-9DE4-4B1A-98B9-F74A91027A3D}"/>
          </ac:cxnSpMkLst>
        </pc:cxnChg>
        <pc:cxnChg chg="add mod">
          <ac:chgData name="김 남혁" userId="492584a0ac289ca9" providerId="LiveId" clId="{9043E759-3652-4405-AE6D-739452E8DA23}" dt="2020-10-12T06:53:33.284" v="68" actId="164"/>
          <ac:cxnSpMkLst>
            <pc:docMk/>
            <pc:sldMk cId="17353670" sldId="634"/>
            <ac:cxnSpMk id="64" creationId="{B73DD42B-5172-42DB-A7DF-9AE9F1C33A88}"/>
          </ac:cxnSpMkLst>
        </pc:cxnChg>
        <pc:cxnChg chg="add mod">
          <ac:chgData name="김 남혁" userId="492584a0ac289ca9" providerId="LiveId" clId="{9043E759-3652-4405-AE6D-739452E8DA23}" dt="2020-10-12T06:53:33.284" v="68" actId="164"/>
          <ac:cxnSpMkLst>
            <pc:docMk/>
            <pc:sldMk cId="17353670" sldId="634"/>
            <ac:cxnSpMk id="65" creationId="{89E11B1F-3EA0-4E23-A7C3-D95997763B67}"/>
          </ac:cxnSpMkLst>
        </pc:cxnChg>
      </pc:sldChg>
      <pc:sldChg chg="addSp delSp modSp mod">
        <pc:chgData name="김 남혁" userId="492584a0ac289ca9" providerId="LiveId" clId="{9043E759-3652-4405-AE6D-739452E8DA23}" dt="2020-10-12T06:56:18.679" v="124" actId="1037"/>
        <pc:sldMkLst>
          <pc:docMk/>
          <pc:sldMk cId="1442773572" sldId="641"/>
        </pc:sldMkLst>
        <pc:spChg chg="del">
          <ac:chgData name="김 남혁" userId="492584a0ac289ca9" providerId="LiveId" clId="{9043E759-3652-4405-AE6D-739452E8DA23}" dt="2020-10-12T06:56:01.990" v="112" actId="478"/>
          <ac:spMkLst>
            <pc:docMk/>
            <pc:sldMk cId="1442773572" sldId="641"/>
            <ac:spMk id="38" creationId="{1F0BB601-EAC8-435B-98BE-614895FCDD3D}"/>
          </ac:spMkLst>
        </pc:spChg>
        <pc:spChg chg="del">
          <ac:chgData name="김 남혁" userId="492584a0ac289ca9" providerId="LiveId" clId="{9043E759-3652-4405-AE6D-739452E8DA23}" dt="2020-10-12T06:56:10.761" v="115" actId="478"/>
          <ac:spMkLst>
            <pc:docMk/>
            <pc:sldMk cId="1442773572" sldId="641"/>
            <ac:spMk id="52" creationId="{30FDB558-2EDA-4F6E-868C-196FC5B9A59D}"/>
          </ac:spMkLst>
        </pc:spChg>
        <pc:spChg chg="del">
          <ac:chgData name="김 남혁" userId="492584a0ac289ca9" providerId="LiveId" clId="{9043E759-3652-4405-AE6D-739452E8DA23}" dt="2020-10-12T06:56:10.761" v="115" actId="478"/>
          <ac:spMkLst>
            <pc:docMk/>
            <pc:sldMk cId="1442773572" sldId="641"/>
            <ac:spMk id="53" creationId="{9AA2CCAA-4857-4631-90C0-DE0614D015BB}"/>
          </ac:spMkLst>
        </pc:spChg>
        <pc:spChg chg="del">
          <ac:chgData name="김 남혁" userId="492584a0ac289ca9" providerId="LiveId" clId="{9043E759-3652-4405-AE6D-739452E8DA23}" dt="2020-10-12T06:56:10.761" v="115" actId="478"/>
          <ac:spMkLst>
            <pc:docMk/>
            <pc:sldMk cId="1442773572" sldId="641"/>
            <ac:spMk id="54" creationId="{40FCCFF0-2815-4B25-85E7-858C46D7C4AC}"/>
          </ac:spMkLst>
        </pc:spChg>
        <pc:spChg chg="del">
          <ac:chgData name="김 남혁" userId="492584a0ac289ca9" providerId="LiveId" clId="{9043E759-3652-4405-AE6D-739452E8DA23}" dt="2020-10-12T06:56:10.761" v="115" actId="478"/>
          <ac:spMkLst>
            <pc:docMk/>
            <pc:sldMk cId="1442773572" sldId="641"/>
            <ac:spMk id="55" creationId="{8095BC85-93BB-4E7E-AA25-11DF9455613B}"/>
          </ac:spMkLst>
        </pc:spChg>
        <pc:spChg chg="del">
          <ac:chgData name="김 남혁" userId="492584a0ac289ca9" providerId="LiveId" clId="{9043E759-3652-4405-AE6D-739452E8DA23}" dt="2020-10-12T06:56:13.365" v="116" actId="478"/>
          <ac:spMkLst>
            <pc:docMk/>
            <pc:sldMk cId="1442773572" sldId="641"/>
            <ac:spMk id="62" creationId="{A89CAF13-4433-43C9-B3B6-6E6837E4FC4A}"/>
          </ac:spMkLst>
        </pc:spChg>
        <pc:spChg chg="mod">
          <ac:chgData name="김 남혁" userId="492584a0ac289ca9" providerId="LiveId" clId="{9043E759-3652-4405-AE6D-739452E8DA23}" dt="2020-10-12T06:56:18.679" v="124" actId="1037"/>
          <ac:spMkLst>
            <pc:docMk/>
            <pc:sldMk cId="1442773572" sldId="641"/>
            <ac:spMk id="76" creationId="{504947F9-C87E-403A-9412-53924F76D20F}"/>
          </ac:spMkLst>
        </pc:spChg>
        <pc:spChg chg="del">
          <ac:chgData name="김 남혁" userId="492584a0ac289ca9" providerId="LiveId" clId="{9043E759-3652-4405-AE6D-739452E8DA23}" dt="2020-10-12T06:56:06.374" v="114" actId="478"/>
          <ac:spMkLst>
            <pc:docMk/>
            <pc:sldMk cId="1442773572" sldId="641"/>
            <ac:spMk id="82" creationId="{7ABC30EC-C54F-5444-93AC-44B7568055DC}"/>
          </ac:spMkLst>
        </pc:spChg>
        <pc:spChg chg="mod">
          <ac:chgData name="김 남혁" userId="492584a0ac289ca9" providerId="LiveId" clId="{9043E759-3652-4405-AE6D-739452E8DA23}" dt="2020-10-12T06:55:43.802" v="107"/>
          <ac:spMkLst>
            <pc:docMk/>
            <pc:sldMk cId="1442773572" sldId="641"/>
            <ac:spMk id="118" creationId="{3CF3F75C-3EE8-4946-B29A-CBC1EF34F4DD}"/>
          </ac:spMkLst>
        </pc:spChg>
        <pc:spChg chg="mod">
          <ac:chgData name="김 남혁" userId="492584a0ac289ca9" providerId="LiveId" clId="{9043E759-3652-4405-AE6D-739452E8DA23}" dt="2020-10-12T06:55:43.802" v="107"/>
          <ac:spMkLst>
            <pc:docMk/>
            <pc:sldMk cId="1442773572" sldId="641"/>
            <ac:spMk id="119" creationId="{79C3A79E-A485-4145-94BB-A8A922A71DA1}"/>
          </ac:spMkLst>
        </pc:spChg>
        <pc:spChg chg="mod">
          <ac:chgData name="김 남혁" userId="492584a0ac289ca9" providerId="LiveId" clId="{9043E759-3652-4405-AE6D-739452E8DA23}" dt="2020-10-12T06:55:43.802" v="107"/>
          <ac:spMkLst>
            <pc:docMk/>
            <pc:sldMk cId="1442773572" sldId="641"/>
            <ac:spMk id="120" creationId="{3C82F5DE-F51F-4A89-92ED-22CFE056AF3F}"/>
          </ac:spMkLst>
        </pc:spChg>
        <pc:spChg chg="mod">
          <ac:chgData name="김 남혁" userId="492584a0ac289ca9" providerId="LiveId" clId="{9043E759-3652-4405-AE6D-739452E8DA23}" dt="2020-10-12T06:55:43.802" v="107"/>
          <ac:spMkLst>
            <pc:docMk/>
            <pc:sldMk cId="1442773572" sldId="641"/>
            <ac:spMk id="121" creationId="{6768A85A-921B-4666-954B-869C853B693A}"/>
          </ac:spMkLst>
        </pc:spChg>
        <pc:spChg chg="mod">
          <ac:chgData name="김 남혁" userId="492584a0ac289ca9" providerId="LiveId" clId="{9043E759-3652-4405-AE6D-739452E8DA23}" dt="2020-10-12T06:55:43.802" v="107"/>
          <ac:spMkLst>
            <pc:docMk/>
            <pc:sldMk cId="1442773572" sldId="641"/>
            <ac:spMk id="126" creationId="{894F39E6-7BBE-4477-909C-1C5914660BBB}"/>
          </ac:spMkLst>
        </pc:spChg>
        <pc:spChg chg="mod">
          <ac:chgData name="김 남혁" userId="492584a0ac289ca9" providerId="LiveId" clId="{9043E759-3652-4405-AE6D-739452E8DA23}" dt="2020-10-12T06:55:43.802" v="107"/>
          <ac:spMkLst>
            <pc:docMk/>
            <pc:sldMk cId="1442773572" sldId="641"/>
            <ac:spMk id="128" creationId="{3EBB3641-B641-4B3E-B647-10472E4373FA}"/>
          </ac:spMkLst>
        </pc:spChg>
        <pc:grpChg chg="del">
          <ac:chgData name="김 남혁" userId="492584a0ac289ca9" providerId="LiveId" clId="{9043E759-3652-4405-AE6D-739452E8DA23}" dt="2020-10-12T06:55:58.600" v="110" actId="478"/>
          <ac:grpSpMkLst>
            <pc:docMk/>
            <pc:sldMk cId="1442773572" sldId="641"/>
            <ac:grpSpMk id="37" creationId="{5FFDD4D2-060E-406A-AD9C-4E0004EEF4F1}"/>
          </ac:grpSpMkLst>
        </pc:grpChg>
        <pc:grpChg chg="add mod ord">
          <ac:chgData name="김 남혁" userId="492584a0ac289ca9" providerId="LiveId" clId="{9043E759-3652-4405-AE6D-739452E8DA23}" dt="2020-10-12T06:55:56.898" v="109" actId="167"/>
          <ac:grpSpMkLst>
            <pc:docMk/>
            <pc:sldMk cId="1442773572" sldId="641"/>
            <ac:grpSpMk id="116" creationId="{521A2AB5-0C9F-4D63-B5CA-5A3C2876B8E6}"/>
          </ac:grpSpMkLst>
        </pc:grpChg>
        <pc:picChg chg="del">
          <ac:chgData name="김 남혁" userId="492584a0ac289ca9" providerId="LiveId" clId="{9043E759-3652-4405-AE6D-739452E8DA23}" dt="2020-10-12T06:56:03.206" v="113" actId="478"/>
          <ac:picMkLst>
            <pc:docMk/>
            <pc:sldMk cId="1442773572" sldId="641"/>
            <ac:picMk id="61" creationId="{A486F532-7FF8-470A-9D33-E9D81D655EE4}"/>
          </ac:picMkLst>
        </pc:picChg>
        <pc:picChg chg="del">
          <ac:chgData name="김 남혁" userId="492584a0ac289ca9" providerId="LiveId" clId="{9043E759-3652-4405-AE6D-739452E8DA23}" dt="2020-10-12T06:55:59.566" v="111" actId="478"/>
          <ac:picMkLst>
            <pc:docMk/>
            <pc:sldMk cId="1442773572" sldId="641"/>
            <ac:picMk id="63" creationId="{BBA60586-AAE4-45F7-AB4F-354005AD3939}"/>
          </ac:picMkLst>
        </pc:picChg>
        <pc:picChg chg="mod">
          <ac:chgData name="김 남혁" userId="492584a0ac289ca9" providerId="LiveId" clId="{9043E759-3652-4405-AE6D-739452E8DA23}" dt="2020-10-12T06:55:43.802" v="107"/>
          <ac:picMkLst>
            <pc:docMk/>
            <pc:sldMk cId="1442773572" sldId="641"/>
            <ac:picMk id="117" creationId="{C82D2720-2AE0-4B94-AC5E-F80CF31BB90F}"/>
          </ac:picMkLst>
        </pc:picChg>
        <pc:picChg chg="mod">
          <ac:chgData name="김 남혁" userId="492584a0ac289ca9" providerId="LiveId" clId="{9043E759-3652-4405-AE6D-739452E8DA23}" dt="2020-10-12T06:55:43.802" v="107"/>
          <ac:picMkLst>
            <pc:docMk/>
            <pc:sldMk cId="1442773572" sldId="641"/>
            <ac:picMk id="127" creationId="{DE835BC7-D6B9-49E5-B0E2-CAD79B4C8A65}"/>
          </ac:picMkLst>
        </pc:picChg>
        <pc:cxnChg chg="del">
          <ac:chgData name="김 남혁" userId="492584a0ac289ca9" providerId="LiveId" clId="{9043E759-3652-4405-AE6D-739452E8DA23}" dt="2020-10-12T06:56:06.374" v="114" actId="478"/>
          <ac:cxnSpMkLst>
            <pc:docMk/>
            <pc:sldMk cId="1442773572" sldId="641"/>
            <ac:cxnSpMk id="39" creationId="{569A6CFE-450F-FD40-AAB6-1EB3478F95E0}"/>
          </ac:cxnSpMkLst>
        </pc:cxnChg>
        <pc:cxnChg chg="del">
          <ac:chgData name="김 남혁" userId="492584a0ac289ca9" providerId="LiveId" clId="{9043E759-3652-4405-AE6D-739452E8DA23}" dt="2020-10-12T06:56:10.761" v="115" actId="478"/>
          <ac:cxnSpMkLst>
            <pc:docMk/>
            <pc:sldMk cId="1442773572" sldId="641"/>
            <ac:cxnSpMk id="57" creationId="{5F09FB74-4A73-42C9-B284-364D9F3781A6}"/>
          </ac:cxnSpMkLst>
        </pc:cxnChg>
        <pc:cxnChg chg="del">
          <ac:chgData name="김 남혁" userId="492584a0ac289ca9" providerId="LiveId" clId="{9043E759-3652-4405-AE6D-739452E8DA23}" dt="2020-10-12T06:56:10.761" v="115" actId="478"/>
          <ac:cxnSpMkLst>
            <pc:docMk/>
            <pc:sldMk cId="1442773572" sldId="641"/>
            <ac:cxnSpMk id="58" creationId="{B1A3E002-87AB-41C3-BC4B-46C7DA3FDFD7}"/>
          </ac:cxnSpMkLst>
        </pc:cxnChg>
        <pc:cxnChg chg="del">
          <ac:chgData name="김 남혁" userId="492584a0ac289ca9" providerId="LiveId" clId="{9043E759-3652-4405-AE6D-739452E8DA23}" dt="2020-10-12T06:56:10.761" v="115" actId="478"/>
          <ac:cxnSpMkLst>
            <pc:docMk/>
            <pc:sldMk cId="1442773572" sldId="641"/>
            <ac:cxnSpMk id="59" creationId="{3D6563E2-05DF-44A1-9BAB-7125BE7194C7}"/>
          </ac:cxnSpMkLst>
        </pc:cxnChg>
        <pc:cxnChg chg="del">
          <ac:chgData name="김 남혁" userId="492584a0ac289ca9" providerId="LiveId" clId="{9043E759-3652-4405-AE6D-739452E8DA23}" dt="2020-10-12T06:56:10.761" v="115" actId="478"/>
          <ac:cxnSpMkLst>
            <pc:docMk/>
            <pc:sldMk cId="1442773572" sldId="641"/>
            <ac:cxnSpMk id="60" creationId="{E76BC347-9B8F-4AA0-8EFE-F29B884A3976}"/>
          </ac:cxnSpMkLst>
        </pc:cxnChg>
        <pc:cxnChg chg="mod">
          <ac:chgData name="김 남혁" userId="492584a0ac289ca9" providerId="LiveId" clId="{9043E759-3652-4405-AE6D-739452E8DA23}" dt="2020-10-12T06:55:43.802" v="107"/>
          <ac:cxnSpMkLst>
            <pc:docMk/>
            <pc:sldMk cId="1442773572" sldId="641"/>
            <ac:cxnSpMk id="122" creationId="{90BCCF81-92BD-45D4-A1E5-1067B2BA23E0}"/>
          </ac:cxnSpMkLst>
        </pc:cxnChg>
        <pc:cxnChg chg="mod">
          <ac:chgData name="김 남혁" userId="492584a0ac289ca9" providerId="LiveId" clId="{9043E759-3652-4405-AE6D-739452E8DA23}" dt="2020-10-12T06:55:43.802" v="107"/>
          <ac:cxnSpMkLst>
            <pc:docMk/>
            <pc:sldMk cId="1442773572" sldId="641"/>
            <ac:cxnSpMk id="123" creationId="{D70861B4-CA71-4F07-B908-C6CCB6BCCF50}"/>
          </ac:cxnSpMkLst>
        </pc:cxnChg>
        <pc:cxnChg chg="mod">
          <ac:chgData name="김 남혁" userId="492584a0ac289ca9" providerId="LiveId" clId="{9043E759-3652-4405-AE6D-739452E8DA23}" dt="2020-10-12T06:55:43.802" v="107"/>
          <ac:cxnSpMkLst>
            <pc:docMk/>
            <pc:sldMk cId="1442773572" sldId="641"/>
            <ac:cxnSpMk id="124" creationId="{31BA0594-F080-4EB7-8800-F7A89E0D0032}"/>
          </ac:cxnSpMkLst>
        </pc:cxnChg>
        <pc:cxnChg chg="mod">
          <ac:chgData name="김 남혁" userId="492584a0ac289ca9" providerId="LiveId" clId="{9043E759-3652-4405-AE6D-739452E8DA23}" dt="2020-10-12T06:55:43.802" v="107"/>
          <ac:cxnSpMkLst>
            <pc:docMk/>
            <pc:sldMk cId="1442773572" sldId="641"/>
            <ac:cxnSpMk id="125" creationId="{70A657B1-7D70-451B-A9CE-6C882FDA9A94}"/>
          </ac:cxnSpMkLst>
        </pc:cxnChg>
        <pc:cxnChg chg="mod">
          <ac:chgData name="김 남혁" userId="492584a0ac289ca9" providerId="LiveId" clId="{9043E759-3652-4405-AE6D-739452E8DA23}" dt="2020-10-12T06:55:43.802" v="107"/>
          <ac:cxnSpMkLst>
            <pc:docMk/>
            <pc:sldMk cId="1442773572" sldId="641"/>
            <ac:cxnSpMk id="129" creationId="{B03ADFBE-6CC4-4965-BD01-4DFC11023B95}"/>
          </ac:cxnSpMkLst>
        </pc:cxnChg>
      </pc:sldChg>
      <pc:sldChg chg="addSp delSp modSp add mod">
        <pc:chgData name="김 남혁" userId="492584a0ac289ca9" providerId="LiveId" clId="{9043E759-3652-4405-AE6D-739452E8DA23}" dt="2020-10-12T10:30:32.016" v="230"/>
        <pc:sldMkLst>
          <pc:docMk/>
          <pc:sldMk cId="1322101952" sldId="643"/>
        </pc:sldMkLst>
        <pc:spChg chg="add mod">
          <ac:chgData name="김 남혁" userId="492584a0ac289ca9" providerId="LiveId" clId="{9043E759-3652-4405-AE6D-739452E8DA23}" dt="2020-10-12T08:04:10.194" v="223" actId="20577"/>
          <ac:spMkLst>
            <pc:docMk/>
            <pc:sldMk cId="1322101952" sldId="643"/>
            <ac:spMk id="2" creationId="{F4C4279D-8040-416A-A489-D8D99161E6FB}"/>
          </ac:spMkLst>
        </pc:spChg>
        <pc:spChg chg="mod">
          <ac:chgData name="김 남혁" userId="492584a0ac289ca9" providerId="LiveId" clId="{9043E759-3652-4405-AE6D-739452E8DA23}" dt="2020-10-12T06:59:52.707" v="186" actId="1037"/>
          <ac:spMkLst>
            <pc:docMk/>
            <pc:sldMk cId="1322101952" sldId="643"/>
            <ac:spMk id="16" creationId="{2FB72DD9-B98A-4DBF-BC26-7DE84718C974}"/>
          </ac:spMkLst>
        </pc:spChg>
        <pc:spChg chg="mod">
          <ac:chgData name="김 남혁" userId="492584a0ac289ca9" providerId="LiveId" clId="{9043E759-3652-4405-AE6D-739452E8DA23}" dt="2020-10-12T06:59:52.707" v="186" actId="1037"/>
          <ac:spMkLst>
            <pc:docMk/>
            <pc:sldMk cId="1322101952" sldId="643"/>
            <ac:spMk id="17" creationId="{0AB16E8A-19E3-4C74-A53A-9EFD76360A44}"/>
          </ac:spMkLst>
        </pc:spChg>
        <pc:spChg chg="del">
          <ac:chgData name="김 남혁" userId="492584a0ac289ca9" providerId="LiveId" clId="{9043E759-3652-4405-AE6D-739452E8DA23}" dt="2020-10-12T06:57:00.377" v="128" actId="478"/>
          <ac:spMkLst>
            <pc:docMk/>
            <pc:sldMk cId="1322101952" sldId="643"/>
            <ac:spMk id="18" creationId="{D6C16F39-ED17-45A4-A9A6-EEC2CAE377E9}"/>
          </ac:spMkLst>
        </pc:spChg>
        <pc:spChg chg="mod">
          <ac:chgData name="김 남혁" userId="492584a0ac289ca9" providerId="LiveId" clId="{9043E759-3652-4405-AE6D-739452E8DA23}" dt="2020-10-12T06:57:46.427" v="133" actId="14100"/>
          <ac:spMkLst>
            <pc:docMk/>
            <pc:sldMk cId="1322101952" sldId="643"/>
            <ac:spMk id="22" creationId="{0C0551AF-87B9-4411-9595-D1971A0A53A0}"/>
          </ac:spMkLst>
        </pc:spChg>
        <pc:grpChg chg="del">
          <ac:chgData name="김 남혁" userId="492584a0ac289ca9" providerId="LiveId" clId="{9043E759-3652-4405-AE6D-739452E8DA23}" dt="2020-10-12T06:56:58.715" v="127" actId="478"/>
          <ac:grpSpMkLst>
            <pc:docMk/>
            <pc:sldMk cId="1322101952" sldId="643"/>
            <ac:grpSpMk id="4" creationId="{C3B9B609-5391-4F67-ADC4-3C655874602C}"/>
          </ac:grpSpMkLst>
        </pc:grpChg>
        <pc:graphicFrameChg chg="add mod">
          <ac:chgData name="김 남혁" userId="492584a0ac289ca9" providerId="LiveId" clId="{9043E759-3652-4405-AE6D-739452E8DA23}" dt="2020-10-12T06:59:52.707" v="186" actId="1037"/>
          <ac:graphicFrameMkLst>
            <pc:docMk/>
            <pc:sldMk cId="1322101952" sldId="643"/>
            <ac:graphicFrameMk id="3" creationId="{82BB93F1-2FDB-4D71-B0C4-91C9876898B9}"/>
          </ac:graphicFrameMkLst>
        </pc:graphicFrameChg>
        <pc:graphicFrameChg chg="add mod">
          <ac:chgData name="김 남혁" userId="492584a0ac289ca9" providerId="LiveId" clId="{9043E759-3652-4405-AE6D-739452E8DA23}" dt="2020-10-12T10:30:32.016" v="230"/>
          <ac:graphicFrameMkLst>
            <pc:docMk/>
            <pc:sldMk cId="1322101952" sldId="643"/>
            <ac:graphicFrameMk id="5" creationId="{EF8C4590-4204-4E14-96E7-6D1831F7475F}"/>
          </ac:graphicFrameMkLst>
        </pc:graphicFrameChg>
        <pc:picChg chg="del">
          <ac:chgData name="김 남혁" userId="492584a0ac289ca9" providerId="LiveId" clId="{9043E759-3652-4405-AE6D-739452E8DA23}" dt="2020-10-12T06:56:58.715" v="127" actId="478"/>
          <ac:picMkLst>
            <pc:docMk/>
            <pc:sldMk cId="1322101952" sldId="643"/>
            <ac:picMk id="25" creationId="{8BD06C22-7C2A-48AD-911F-4C6B33C5DC4F}"/>
          </ac:picMkLst>
        </pc:picChg>
      </pc:sldChg>
      <pc:sldChg chg="addSp modSp new del mod">
        <pc:chgData name="김 남혁" userId="492584a0ac289ca9" providerId="LiveId" clId="{9043E759-3652-4405-AE6D-739452E8DA23}" dt="2020-10-12T06:56:30.526" v="125" actId="47"/>
        <pc:sldMkLst>
          <pc:docMk/>
          <pc:sldMk cId="1813771245" sldId="643"/>
        </pc:sldMkLst>
        <pc:spChg chg="add mod">
          <ac:chgData name="김 남혁" userId="492584a0ac289ca9" providerId="LiveId" clId="{9043E759-3652-4405-AE6D-739452E8DA23}" dt="2020-10-12T06:55:41.370" v="106" actId="164"/>
          <ac:spMkLst>
            <pc:docMk/>
            <pc:sldMk cId="1813771245" sldId="643"/>
            <ac:spMk id="3" creationId="{C9F6B6EC-1135-447E-81EB-96B14AC95A65}"/>
          </ac:spMkLst>
        </pc:spChg>
        <pc:spChg chg="add mod">
          <ac:chgData name="김 남혁" userId="492584a0ac289ca9" providerId="LiveId" clId="{9043E759-3652-4405-AE6D-739452E8DA23}" dt="2020-10-12T06:55:41.370" v="106" actId="164"/>
          <ac:spMkLst>
            <pc:docMk/>
            <pc:sldMk cId="1813771245" sldId="643"/>
            <ac:spMk id="4" creationId="{E0B6B0D9-F484-42D1-BB28-02D55F0A50F2}"/>
          </ac:spMkLst>
        </pc:spChg>
        <pc:spChg chg="add mod">
          <ac:chgData name="김 남혁" userId="492584a0ac289ca9" providerId="LiveId" clId="{9043E759-3652-4405-AE6D-739452E8DA23}" dt="2020-10-12T06:55:41.370" v="106" actId="164"/>
          <ac:spMkLst>
            <pc:docMk/>
            <pc:sldMk cId="1813771245" sldId="643"/>
            <ac:spMk id="5" creationId="{8E2434BC-B8B1-41CC-A0B7-E59FE008DFB8}"/>
          </ac:spMkLst>
        </pc:spChg>
        <pc:spChg chg="add mod">
          <ac:chgData name="김 남혁" userId="492584a0ac289ca9" providerId="LiveId" clId="{9043E759-3652-4405-AE6D-739452E8DA23}" dt="2020-10-12T06:55:41.370" v="106" actId="164"/>
          <ac:spMkLst>
            <pc:docMk/>
            <pc:sldMk cId="1813771245" sldId="643"/>
            <ac:spMk id="6" creationId="{F8C38703-E9D2-42F7-9815-7F6494387B47}"/>
          </ac:spMkLst>
        </pc:spChg>
        <pc:spChg chg="add mod">
          <ac:chgData name="김 남혁" userId="492584a0ac289ca9" providerId="LiveId" clId="{9043E759-3652-4405-AE6D-739452E8DA23}" dt="2020-10-12T06:55:41.370" v="106" actId="164"/>
          <ac:spMkLst>
            <pc:docMk/>
            <pc:sldMk cId="1813771245" sldId="643"/>
            <ac:spMk id="12" creationId="{6C95238A-3AA8-4B99-B5E7-686C217E609A}"/>
          </ac:spMkLst>
        </pc:spChg>
        <pc:spChg chg="add mod">
          <ac:chgData name="김 남혁" userId="492584a0ac289ca9" providerId="LiveId" clId="{9043E759-3652-4405-AE6D-739452E8DA23}" dt="2020-10-12T06:55:41.370" v="106" actId="164"/>
          <ac:spMkLst>
            <pc:docMk/>
            <pc:sldMk cId="1813771245" sldId="643"/>
            <ac:spMk id="14" creationId="{0FC5336B-4A9A-4C58-88CE-526FAFD046FF}"/>
          </ac:spMkLst>
        </pc:spChg>
        <pc:grpChg chg="add mod">
          <ac:chgData name="김 남혁" userId="492584a0ac289ca9" providerId="LiveId" clId="{9043E759-3652-4405-AE6D-739452E8DA23}" dt="2020-10-12T06:55:41.370" v="106" actId="164"/>
          <ac:grpSpMkLst>
            <pc:docMk/>
            <pc:sldMk cId="1813771245" sldId="643"/>
            <ac:grpSpMk id="16" creationId="{9C51393C-AA68-42AB-B477-33B7312CC1C9}"/>
          </ac:grpSpMkLst>
        </pc:grpChg>
        <pc:picChg chg="add mod">
          <ac:chgData name="김 남혁" userId="492584a0ac289ca9" providerId="LiveId" clId="{9043E759-3652-4405-AE6D-739452E8DA23}" dt="2020-10-12T06:55:41.370" v="106" actId="164"/>
          <ac:picMkLst>
            <pc:docMk/>
            <pc:sldMk cId="1813771245" sldId="643"/>
            <ac:picMk id="2" creationId="{D3DE1CF9-232F-4788-BACA-42A667921115}"/>
          </ac:picMkLst>
        </pc:picChg>
        <pc:picChg chg="add mod">
          <ac:chgData name="김 남혁" userId="492584a0ac289ca9" providerId="LiveId" clId="{9043E759-3652-4405-AE6D-739452E8DA23}" dt="2020-10-12T06:55:41.370" v="106" actId="164"/>
          <ac:picMkLst>
            <pc:docMk/>
            <pc:sldMk cId="1813771245" sldId="643"/>
            <ac:picMk id="13" creationId="{026CC4F9-39BE-4FF4-B631-01B6C7998EED}"/>
          </ac:picMkLst>
        </pc:picChg>
        <pc:cxnChg chg="add mod">
          <ac:chgData name="김 남혁" userId="492584a0ac289ca9" providerId="LiveId" clId="{9043E759-3652-4405-AE6D-739452E8DA23}" dt="2020-10-12T06:55:41.370" v="106" actId="164"/>
          <ac:cxnSpMkLst>
            <pc:docMk/>
            <pc:sldMk cId="1813771245" sldId="643"/>
            <ac:cxnSpMk id="7" creationId="{4BBBA639-A87F-479B-8787-0080508F94F2}"/>
          </ac:cxnSpMkLst>
        </pc:cxnChg>
        <pc:cxnChg chg="add mod">
          <ac:chgData name="김 남혁" userId="492584a0ac289ca9" providerId="LiveId" clId="{9043E759-3652-4405-AE6D-739452E8DA23}" dt="2020-10-12T06:55:41.370" v="106" actId="164"/>
          <ac:cxnSpMkLst>
            <pc:docMk/>
            <pc:sldMk cId="1813771245" sldId="643"/>
            <ac:cxnSpMk id="8" creationId="{AC82E5BE-0921-48A9-A20B-443C05FC8BD1}"/>
          </ac:cxnSpMkLst>
        </pc:cxnChg>
        <pc:cxnChg chg="add mod">
          <ac:chgData name="김 남혁" userId="492584a0ac289ca9" providerId="LiveId" clId="{9043E759-3652-4405-AE6D-739452E8DA23}" dt="2020-10-12T06:55:41.370" v="106" actId="164"/>
          <ac:cxnSpMkLst>
            <pc:docMk/>
            <pc:sldMk cId="1813771245" sldId="643"/>
            <ac:cxnSpMk id="9" creationId="{37E33A30-E655-43BC-BD9B-19F7ED4B42F7}"/>
          </ac:cxnSpMkLst>
        </pc:cxnChg>
        <pc:cxnChg chg="add mod">
          <ac:chgData name="김 남혁" userId="492584a0ac289ca9" providerId="LiveId" clId="{9043E759-3652-4405-AE6D-739452E8DA23}" dt="2020-10-12T06:55:41.370" v="106" actId="164"/>
          <ac:cxnSpMkLst>
            <pc:docMk/>
            <pc:sldMk cId="1813771245" sldId="643"/>
            <ac:cxnSpMk id="10" creationId="{0FD764A0-4CEB-4CDD-B1C2-9862A7DCA56A}"/>
          </ac:cxnSpMkLst>
        </pc:cxnChg>
        <pc:cxnChg chg="add mod">
          <ac:chgData name="김 남혁" userId="492584a0ac289ca9" providerId="LiveId" clId="{9043E759-3652-4405-AE6D-739452E8DA23}" dt="2020-10-12T06:55:41.370" v="106" actId="164"/>
          <ac:cxnSpMkLst>
            <pc:docMk/>
            <pc:sldMk cId="1813771245" sldId="643"/>
            <ac:cxnSpMk id="15" creationId="{EB38E89F-7E42-407A-A716-6817A3546F6A}"/>
          </ac:cxnSpMkLst>
        </pc:cxnChg>
      </pc:sldChg>
      <pc:sldChg chg="addSp delSp modSp new del mod">
        <pc:chgData name="김 남혁" userId="492584a0ac289ca9" providerId="LiveId" clId="{9043E759-3652-4405-AE6D-739452E8DA23}" dt="2020-10-12T06:53:58.062" v="86" actId="47"/>
        <pc:sldMkLst>
          <pc:docMk/>
          <pc:sldMk cId="3747537447" sldId="643"/>
        </pc:sldMkLst>
        <pc:spChg chg="add del mod">
          <ac:chgData name="김 남혁" userId="492584a0ac289ca9" providerId="LiveId" clId="{9043E759-3652-4405-AE6D-739452E8DA23}" dt="2020-10-12T06:53:56.373" v="85" actId="478"/>
          <ac:spMkLst>
            <pc:docMk/>
            <pc:sldMk cId="3747537447" sldId="643"/>
            <ac:spMk id="3" creationId="{EE99AA29-40F8-4F42-9C1A-F259F5114583}"/>
          </ac:spMkLst>
        </pc:spChg>
        <pc:spChg chg="add del mod">
          <ac:chgData name="김 남혁" userId="492584a0ac289ca9" providerId="LiveId" clId="{9043E759-3652-4405-AE6D-739452E8DA23}" dt="2020-10-12T06:53:56.373" v="85" actId="478"/>
          <ac:spMkLst>
            <pc:docMk/>
            <pc:sldMk cId="3747537447" sldId="643"/>
            <ac:spMk id="4" creationId="{D165E9EA-CEDA-40D1-8734-EEE92A3DE190}"/>
          </ac:spMkLst>
        </pc:spChg>
        <pc:spChg chg="add del mod">
          <ac:chgData name="김 남혁" userId="492584a0ac289ca9" providerId="LiveId" clId="{9043E759-3652-4405-AE6D-739452E8DA23}" dt="2020-10-12T06:53:56.373" v="85" actId="478"/>
          <ac:spMkLst>
            <pc:docMk/>
            <pc:sldMk cId="3747537447" sldId="643"/>
            <ac:spMk id="5" creationId="{3E7626BF-3499-44CE-94AC-81CA81AE6442}"/>
          </ac:spMkLst>
        </pc:spChg>
        <pc:spChg chg="add del mod">
          <ac:chgData name="김 남혁" userId="492584a0ac289ca9" providerId="LiveId" clId="{9043E759-3652-4405-AE6D-739452E8DA23}" dt="2020-10-12T06:53:56.373" v="85" actId="478"/>
          <ac:spMkLst>
            <pc:docMk/>
            <pc:sldMk cId="3747537447" sldId="643"/>
            <ac:spMk id="6" creationId="{0D8DCF53-1A54-43BA-957E-B5D6A0707586}"/>
          </ac:spMkLst>
        </pc:spChg>
        <pc:spChg chg="add del mod">
          <ac:chgData name="김 남혁" userId="492584a0ac289ca9" providerId="LiveId" clId="{9043E759-3652-4405-AE6D-739452E8DA23}" dt="2020-10-12T06:53:56.373" v="85" actId="478"/>
          <ac:spMkLst>
            <pc:docMk/>
            <pc:sldMk cId="3747537447" sldId="643"/>
            <ac:spMk id="11" creationId="{45E79365-28E6-4BB7-9CA8-BEAAF58CE676}"/>
          </ac:spMkLst>
        </pc:spChg>
        <pc:picChg chg="add del mod modCrop">
          <ac:chgData name="김 남혁" userId="492584a0ac289ca9" providerId="LiveId" clId="{9043E759-3652-4405-AE6D-739452E8DA23}" dt="2020-10-12T06:53:56.373" v="85" actId="478"/>
          <ac:picMkLst>
            <pc:docMk/>
            <pc:sldMk cId="3747537447" sldId="643"/>
            <ac:picMk id="2" creationId="{EF007A7A-0F10-4D64-AB4F-9C5217730D42}"/>
          </ac:picMkLst>
        </pc:picChg>
        <pc:cxnChg chg="add del mod">
          <ac:chgData name="김 남혁" userId="492584a0ac289ca9" providerId="LiveId" clId="{9043E759-3652-4405-AE6D-739452E8DA23}" dt="2020-10-12T06:53:56.373" v="85" actId="478"/>
          <ac:cxnSpMkLst>
            <pc:docMk/>
            <pc:sldMk cId="3747537447" sldId="643"/>
            <ac:cxnSpMk id="7" creationId="{867FF687-47C0-42DE-92B0-333D0D5E7648}"/>
          </ac:cxnSpMkLst>
        </pc:cxnChg>
        <pc:cxnChg chg="add del mod">
          <ac:chgData name="김 남혁" userId="492584a0ac289ca9" providerId="LiveId" clId="{9043E759-3652-4405-AE6D-739452E8DA23}" dt="2020-10-12T06:53:56.373" v="85" actId="478"/>
          <ac:cxnSpMkLst>
            <pc:docMk/>
            <pc:sldMk cId="3747537447" sldId="643"/>
            <ac:cxnSpMk id="8" creationId="{3E0E27F5-72C3-4648-A3A7-3ECA925827FF}"/>
          </ac:cxnSpMkLst>
        </pc:cxnChg>
        <pc:cxnChg chg="add del mod">
          <ac:chgData name="김 남혁" userId="492584a0ac289ca9" providerId="LiveId" clId="{9043E759-3652-4405-AE6D-739452E8DA23}" dt="2020-10-12T06:53:56.373" v="85" actId="478"/>
          <ac:cxnSpMkLst>
            <pc:docMk/>
            <pc:sldMk cId="3747537447" sldId="643"/>
            <ac:cxnSpMk id="9" creationId="{21D55F49-425B-4A07-B3CB-48E2D939CAF9}"/>
          </ac:cxnSpMkLst>
        </pc:cxnChg>
        <pc:cxnChg chg="add del mod">
          <ac:chgData name="김 남혁" userId="492584a0ac289ca9" providerId="LiveId" clId="{9043E759-3652-4405-AE6D-739452E8DA23}" dt="2020-10-12T06:53:56.373" v="85" actId="478"/>
          <ac:cxnSpMkLst>
            <pc:docMk/>
            <pc:sldMk cId="3747537447" sldId="643"/>
            <ac:cxnSpMk id="10" creationId="{4D128F45-E387-429E-868B-2D05C12F1C95}"/>
          </ac:cxnSpMkLst>
        </pc:cxnChg>
      </pc:sldChg>
    </pc:docChg>
  </pc:docChgLst>
  <pc:docChgLst>
    <pc:chgData name="김 남혁" userId="492584a0ac289ca9" providerId="LiveId" clId="{EA60056C-C998-F54E-BB87-D84A9AEABF13}"/>
    <pc:docChg chg="modSld">
      <pc:chgData name="김 남혁" userId="492584a0ac289ca9" providerId="LiveId" clId="{EA60056C-C998-F54E-BB87-D84A9AEABF13}" dt="2020-04-16T06:42:23.611" v="1" actId="114"/>
      <pc:docMkLst>
        <pc:docMk/>
      </pc:docMkLst>
      <pc:sldChg chg="modSp">
        <pc:chgData name="김 남혁" userId="492584a0ac289ca9" providerId="LiveId" clId="{EA60056C-C998-F54E-BB87-D84A9AEABF13}" dt="2020-04-16T06:42:23.611" v="1" actId="114"/>
        <pc:sldMkLst>
          <pc:docMk/>
          <pc:sldMk cId="1356419714" sldId="639"/>
        </pc:sldMkLst>
        <pc:spChg chg="mod">
          <ac:chgData name="김 남혁" userId="492584a0ac289ca9" providerId="LiveId" clId="{EA60056C-C998-F54E-BB87-D84A9AEABF13}" dt="2020-04-16T06:42:17.663" v="0" actId="114"/>
          <ac:spMkLst>
            <pc:docMk/>
            <pc:sldMk cId="1356419714" sldId="639"/>
            <ac:spMk id="101" creationId="{F85D52AB-8643-5648-9707-98D28C93FC76}"/>
          </ac:spMkLst>
        </pc:spChg>
        <pc:spChg chg="mod">
          <ac:chgData name="김 남혁" userId="492584a0ac289ca9" providerId="LiveId" clId="{EA60056C-C998-F54E-BB87-D84A9AEABF13}" dt="2020-04-16T06:42:23.611" v="1" actId="114"/>
          <ac:spMkLst>
            <pc:docMk/>
            <pc:sldMk cId="1356419714" sldId="639"/>
            <ac:spMk id="102" creationId="{E268B682-DA53-744A-87CA-CB945376624B}"/>
          </ac:spMkLst>
        </pc:spChg>
      </pc:sldChg>
    </pc:docChg>
  </pc:docChgLst>
  <pc:docChgLst>
    <pc:chgData name="김 남혁" userId="492584a0ac289ca9" providerId="LiveId" clId="{DED9E42A-D383-4645-9113-F421ADC786EF}"/>
    <pc:docChg chg="undo custSel addSld delSld modSld sldOrd">
      <pc:chgData name="김 남혁" userId="492584a0ac289ca9" providerId="LiveId" clId="{DED9E42A-D383-4645-9113-F421ADC786EF}" dt="2019-11-04T05:02:05.052" v="947"/>
      <pc:docMkLst>
        <pc:docMk/>
      </pc:docMkLst>
      <pc:sldChg chg="del">
        <pc:chgData name="김 남혁" userId="492584a0ac289ca9" providerId="LiveId" clId="{DED9E42A-D383-4645-9113-F421ADC786EF}" dt="2019-11-03T10:24:55.392" v="0" actId="2696"/>
        <pc:sldMkLst>
          <pc:docMk/>
          <pc:sldMk cId="1974304403" sldId="496"/>
        </pc:sldMkLst>
      </pc:sldChg>
      <pc:sldChg chg="del">
        <pc:chgData name="김 남혁" userId="492584a0ac289ca9" providerId="LiveId" clId="{DED9E42A-D383-4645-9113-F421ADC786EF}" dt="2019-11-03T10:25:01.961" v="3" actId="2696"/>
        <pc:sldMkLst>
          <pc:docMk/>
          <pc:sldMk cId="828195323" sldId="619"/>
        </pc:sldMkLst>
      </pc:sldChg>
      <pc:sldChg chg="del">
        <pc:chgData name="김 남혁" userId="492584a0ac289ca9" providerId="LiveId" clId="{DED9E42A-D383-4645-9113-F421ADC786EF}" dt="2019-11-03T10:25:05.084" v="5" actId="2696"/>
        <pc:sldMkLst>
          <pc:docMk/>
          <pc:sldMk cId="2025063474" sldId="625"/>
        </pc:sldMkLst>
      </pc:sldChg>
      <pc:sldChg chg="del">
        <pc:chgData name="김 남혁" userId="492584a0ac289ca9" providerId="LiveId" clId="{DED9E42A-D383-4645-9113-F421ADC786EF}" dt="2019-11-03T10:25:39.704" v="11" actId="2696"/>
        <pc:sldMkLst>
          <pc:docMk/>
          <pc:sldMk cId="3573674317" sldId="627"/>
        </pc:sldMkLst>
      </pc:sldChg>
      <pc:sldChg chg="addSp delSp modSp del">
        <pc:chgData name="김 남혁" userId="492584a0ac289ca9" providerId="LiveId" clId="{DED9E42A-D383-4645-9113-F421ADC786EF}" dt="2019-11-03T10:36:06.275" v="104"/>
        <pc:sldMkLst>
          <pc:docMk/>
          <pc:sldMk cId="3201097972" sldId="628"/>
        </pc:sldMkLst>
        <pc:spChg chg="mod">
          <ac:chgData name="김 남혁" userId="492584a0ac289ca9" providerId="LiveId" clId="{DED9E42A-D383-4645-9113-F421ADC786EF}" dt="2019-11-03T10:32:48.045" v="45" actId="1038"/>
          <ac:spMkLst>
            <pc:docMk/>
            <pc:sldMk cId="3201097972" sldId="628"/>
            <ac:spMk id="3" creationId="{05F694A2-5066-40D7-B682-54AA61A0DC5D}"/>
          </ac:spMkLst>
        </pc:spChg>
        <pc:spChg chg="add mod">
          <ac:chgData name="김 남혁" userId="492584a0ac289ca9" providerId="LiveId" clId="{DED9E42A-D383-4645-9113-F421ADC786EF}" dt="2019-11-03T10:35:30.590" v="96" actId="1038"/>
          <ac:spMkLst>
            <pc:docMk/>
            <pc:sldMk cId="3201097972" sldId="628"/>
            <ac:spMk id="4" creationId="{6708FA0F-8D01-42FF-A028-EC5278538B49}"/>
          </ac:spMkLst>
        </pc:spChg>
        <pc:spChg chg="del">
          <ac:chgData name="김 남혁" userId="492584a0ac289ca9" providerId="LiveId" clId="{DED9E42A-D383-4645-9113-F421ADC786EF}" dt="2019-11-03T10:25:52.629" v="17" actId="478"/>
          <ac:spMkLst>
            <pc:docMk/>
            <pc:sldMk cId="3201097972" sldId="628"/>
            <ac:spMk id="88" creationId="{4B848525-20C2-463B-A7C0-02749B657F83}"/>
          </ac:spMkLst>
        </pc:spChg>
        <pc:graphicFrameChg chg="add mod">
          <ac:chgData name="김 남혁" userId="492584a0ac289ca9" providerId="LiveId" clId="{DED9E42A-D383-4645-9113-F421ADC786EF}" dt="2019-11-03T10:36:06.275" v="104"/>
          <ac:graphicFrameMkLst>
            <pc:docMk/>
            <pc:sldMk cId="3201097972" sldId="628"/>
            <ac:graphicFrameMk id="2" creationId="{2ED3A42D-2284-40D7-BCB0-B3960A13B1F3}"/>
          </ac:graphicFrameMkLst>
        </pc:graphicFrameChg>
        <pc:graphicFrameChg chg="del mod">
          <ac:chgData name="김 남혁" userId="492584a0ac289ca9" providerId="LiveId" clId="{DED9E42A-D383-4645-9113-F421ADC786EF}" dt="2019-11-03T10:31:22.946" v="25" actId="478"/>
          <ac:graphicFrameMkLst>
            <pc:docMk/>
            <pc:sldMk cId="3201097972" sldId="628"/>
            <ac:graphicFrameMk id="24" creationId="{0B01BE30-FF2B-4637-96E2-58B6A67289D0}"/>
          </ac:graphicFrameMkLst>
        </pc:graphicFrameChg>
        <pc:graphicFrameChg chg="add del">
          <ac:chgData name="김 남혁" userId="492584a0ac289ca9" providerId="LiveId" clId="{DED9E42A-D383-4645-9113-F421ADC786EF}" dt="2019-11-03T10:25:51.336" v="16" actId="478"/>
          <ac:graphicFrameMkLst>
            <pc:docMk/>
            <pc:sldMk cId="3201097972" sldId="628"/>
            <ac:graphicFrameMk id="86" creationId="{FEC6B235-C50C-485D-B977-5BCA7B7DD67F}"/>
          </ac:graphicFrameMkLst>
        </pc:graphicFrameChg>
      </pc:sldChg>
      <pc:sldChg chg="addSp modSp del ord">
        <pc:chgData name="김 남혁" userId="492584a0ac289ca9" providerId="LiveId" clId="{DED9E42A-D383-4645-9113-F421ADC786EF}" dt="2019-11-03T10:57:14.941" v="204" actId="2696"/>
        <pc:sldMkLst>
          <pc:docMk/>
          <pc:sldMk cId="2188182994" sldId="630"/>
        </pc:sldMkLst>
        <pc:graphicFrameChg chg="mod">
          <ac:chgData name="김 남혁" userId="492584a0ac289ca9" providerId="LiveId" clId="{DED9E42A-D383-4645-9113-F421ADC786EF}" dt="2019-11-03T10:52:18.054" v="195" actId="14100"/>
          <ac:graphicFrameMkLst>
            <pc:docMk/>
            <pc:sldMk cId="2188182994" sldId="630"/>
            <ac:graphicFrameMk id="2" creationId="{C563A889-FBA7-4FC4-B6A2-82BF8492AC26}"/>
          </ac:graphicFrameMkLst>
        </pc:graphicFrameChg>
        <pc:graphicFrameChg chg="add mod">
          <ac:chgData name="김 남혁" userId="492584a0ac289ca9" providerId="LiveId" clId="{DED9E42A-D383-4645-9113-F421ADC786EF}" dt="2019-11-03T10:52:18.054" v="195" actId="14100"/>
          <ac:graphicFrameMkLst>
            <pc:docMk/>
            <pc:sldMk cId="2188182994" sldId="630"/>
            <ac:graphicFrameMk id="3" creationId="{7ED3B37D-D647-4E00-BC48-B28DFEFF23DF}"/>
          </ac:graphicFrameMkLst>
        </pc:graphicFrameChg>
        <pc:graphicFrameChg chg="mod">
          <ac:chgData name="김 남혁" userId="492584a0ac289ca9" providerId="LiveId" clId="{DED9E42A-D383-4645-9113-F421ADC786EF}" dt="2019-11-03T10:52:18.054" v="195" actId="14100"/>
          <ac:graphicFrameMkLst>
            <pc:docMk/>
            <pc:sldMk cId="2188182994" sldId="630"/>
            <ac:graphicFrameMk id="4" creationId="{2EBF9B46-80BC-470C-8F85-253AA7D3F5B9}"/>
          </ac:graphicFrameMkLst>
        </pc:graphicFrameChg>
      </pc:sldChg>
      <pc:sldChg chg="addSp delSp modSp del">
        <pc:chgData name="김 남혁" userId="492584a0ac289ca9" providerId="LiveId" clId="{DED9E42A-D383-4645-9113-F421ADC786EF}" dt="2019-11-03T10:45:31.927" v="155" actId="2696"/>
        <pc:sldMkLst>
          <pc:docMk/>
          <pc:sldMk cId="2451882138" sldId="631"/>
        </pc:sldMkLst>
        <pc:spChg chg="del mod topLvl">
          <ac:chgData name="김 남혁" userId="492584a0ac289ca9" providerId="LiveId" clId="{DED9E42A-D383-4645-9113-F421ADC786EF}" dt="2019-11-03T10:37:28.143" v="111" actId="478"/>
          <ac:spMkLst>
            <pc:docMk/>
            <pc:sldMk cId="2451882138" sldId="631"/>
            <ac:spMk id="2" creationId="{3C1D236D-2BF5-4CAA-A96B-C92358662EEA}"/>
          </ac:spMkLst>
        </pc:spChg>
        <pc:spChg chg="mod topLvl">
          <ac:chgData name="김 남혁" userId="492584a0ac289ca9" providerId="LiveId" clId="{DED9E42A-D383-4645-9113-F421ADC786EF}" dt="2019-11-03T10:43:04.602" v="122" actId="164"/>
          <ac:spMkLst>
            <pc:docMk/>
            <pc:sldMk cId="2451882138" sldId="631"/>
            <ac:spMk id="17" creationId="{55152C2B-DF40-4B2A-9F9C-64FA8A9F4549}"/>
          </ac:spMkLst>
        </pc:spChg>
        <pc:spChg chg="del mod topLvl">
          <ac:chgData name="김 남혁" userId="492584a0ac289ca9" providerId="LiveId" clId="{DED9E42A-D383-4645-9113-F421ADC786EF}" dt="2019-11-03T10:36:58.865" v="109" actId="478"/>
          <ac:spMkLst>
            <pc:docMk/>
            <pc:sldMk cId="2451882138" sldId="631"/>
            <ac:spMk id="18" creationId="{422ECCB9-1692-48A4-A44D-371A09DFD746}"/>
          </ac:spMkLst>
        </pc:spChg>
        <pc:spChg chg="mod topLvl">
          <ac:chgData name="김 남혁" userId="492584a0ac289ca9" providerId="LiveId" clId="{DED9E42A-D383-4645-9113-F421ADC786EF}" dt="2019-11-03T10:43:04.602" v="122" actId="164"/>
          <ac:spMkLst>
            <pc:docMk/>
            <pc:sldMk cId="2451882138" sldId="631"/>
            <ac:spMk id="33" creationId="{CB7F36D7-A94E-40BB-BCD8-85EBE3C5846D}"/>
          </ac:spMkLst>
        </pc:spChg>
        <pc:spChg chg="mod topLvl">
          <ac:chgData name="김 남혁" userId="492584a0ac289ca9" providerId="LiveId" clId="{DED9E42A-D383-4645-9113-F421ADC786EF}" dt="2019-11-03T10:43:04.602" v="122" actId="164"/>
          <ac:spMkLst>
            <pc:docMk/>
            <pc:sldMk cId="2451882138" sldId="631"/>
            <ac:spMk id="34" creationId="{327FAF90-5572-490A-964B-0BE25213836D}"/>
          </ac:spMkLst>
        </pc:spChg>
        <pc:spChg chg="mod topLvl">
          <ac:chgData name="김 남혁" userId="492584a0ac289ca9" providerId="LiveId" clId="{DED9E42A-D383-4645-9113-F421ADC786EF}" dt="2019-11-03T10:43:04.602" v="122" actId="164"/>
          <ac:spMkLst>
            <pc:docMk/>
            <pc:sldMk cId="2451882138" sldId="631"/>
            <ac:spMk id="35" creationId="{D5F87788-00E0-4254-A077-E575E7D02E1F}"/>
          </ac:spMkLst>
        </pc:spChg>
        <pc:spChg chg="mod topLvl">
          <ac:chgData name="김 남혁" userId="492584a0ac289ca9" providerId="LiveId" clId="{DED9E42A-D383-4645-9113-F421ADC786EF}" dt="2019-11-03T10:43:04.602" v="122" actId="164"/>
          <ac:spMkLst>
            <pc:docMk/>
            <pc:sldMk cId="2451882138" sldId="631"/>
            <ac:spMk id="36" creationId="{BDA1A7C1-5AE2-4377-8C73-E2D904639128}"/>
          </ac:spMkLst>
        </pc:spChg>
        <pc:grpChg chg="add mod">
          <ac:chgData name="김 남혁" userId="492584a0ac289ca9" providerId="LiveId" clId="{DED9E42A-D383-4645-9113-F421ADC786EF}" dt="2019-11-03T10:43:06.855" v="123" actId="1076"/>
          <ac:grpSpMkLst>
            <pc:docMk/>
            <pc:sldMk cId="2451882138" sldId="631"/>
            <ac:grpSpMk id="3" creationId="{46E0D379-B394-4D87-9855-7BA1D6670B73}"/>
          </ac:grpSpMkLst>
        </pc:grpChg>
        <pc:grpChg chg="del">
          <ac:chgData name="김 남혁" userId="492584a0ac289ca9" providerId="LiveId" clId="{DED9E42A-D383-4645-9113-F421ADC786EF}" dt="2019-11-03T10:36:56.048" v="108" actId="165"/>
          <ac:grpSpMkLst>
            <pc:docMk/>
            <pc:sldMk cId="2451882138" sldId="631"/>
            <ac:grpSpMk id="4" creationId="{33EA9957-2CAB-4C59-8178-5745E3994566}"/>
          </ac:grpSpMkLst>
        </pc:grpChg>
        <pc:grpChg chg="del mod topLvl">
          <ac:chgData name="김 남혁" userId="492584a0ac289ca9" providerId="LiveId" clId="{DED9E42A-D383-4645-9113-F421ADC786EF}" dt="2019-11-03T10:37:26.238" v="110" actId="478"/>
          <ac:grpSpMkLst>
            <pc:docMk/>
            <pc:sldMk cId="2451882138" sldId="631"/>
            <ac:grpSpMk id="19" creationId="{2AE30C2C-EB85-4394-B811-14938CAD06D2}"/>
          </ac:grpSpMkLst>
        </pc:grpChg>
        <pc:graphicFrameChg chg="mod">
          <ac:chgData name="김 남혁" userId="492584a0ac289ca9" providerId="LiveId" clId="{DED9E42A-D383-4645-9113-F421ADC786EF}" dt="2019-11-03T10:43:55.815" v="139" actId="1076"/>
          <ac:graphicFrameMkLst>
            <pc:docMk/>
            <pc:sldMk cId="2451882138" sldId="631"/>
            <ac:graphicFrameMk id="42" creationId="{5C4759A4-9213-4D0A-9A5D-3227C7E0F10F}"/>
          </ac:graphicFrameMkLst>
        </pc:graphicFrameChg>
        <pc:graphicFrameChg chg="mod">
          <ac:chgData name="김 남혁" userId="492584a0ac289ca9" providerId="LiveId" clId="{DED9E42A-D383-4645-9113-F421ADC786EF}" dt="2019-11-03T10:44:11.808" v="141"/>
          <ac:graphicFrameMkLst>
            <pc:docMk/>
            <pc:sldMk cId="2451882138" sldId="631"/>
            <ac:graphicFrameMk id="43" creationId="{A393BC5C-BF48-4092-B6DF-F51E6DD0DC65}"/>
          </ac:graphicFrameMkLst>
        </pc:graphicFrameChg>
        <pc:picChg chg="mod topLvl">
          <ac:chgData name="김 남혁" userId="492584a0ac289ca9" providerId="LiveId" clId="{DED9E42A-D383-4645-9113-F421ADC786EF}" dt="2019-11-03T10:43:04.602" v="122" actId="164"/>
          <ac:picMkLst>
            <pc:docMk/>
            <pc:sldMk cId="2451882138" sldId="631"/>
            <ac:picMk id="10" creationId="{E832DCED-D9FD-48B4-A3CB-DA36F89597E9}"/>
          </ac:picMkLst>
        </pc:picChg>
        <pc:cxnChg chg="mod topLvl">
          <ac:chgData name="김 남혁" userId="492584a0ac289ca9" providerId="LiveId" clId="{DED9E42A-D383-4645-9113-F421ADC786EF}" dt="2019-11-03T10:43:04.602" v="122" actId="164"/>
          <ac:cxnSpMkLst>
            <pc:docMk/>
            <pc:sldMk cId="2451882138" sldId="631"/>
            <ac:cxnSpMk id="37" creationId="{2249FB80-6490-4797-8EE5-D14DC813F8D9}"/>
          </ac:cxnSpMkLst>
        </pc:cxnChg>
        <pc:cxnChg chg="mod topLvl">
          <ac:chgData name="김 남혁" userId="492584a0ac289ca9" providerId="LiveId" clId="{DED9E42A-D383-4645-9113-F421ADC786EF}" dt="2019-11-03T10:43:04.602" v="122" actId="164"/>
          <ac:cxnSpMkLst>
            <pc:docMk/>
            <pc:sldMk cId="2451882138" sldId="631"/>
            <ac:cxnSpMk id="38" creationId="{18C64048-EFB2-4F81-BD2F-560C5ECABEC5}"/>
          </ac:cxnSpMkLst>
        </pc:cxnChg>
        <pc:cxnChg chg="mod topLvl">
          <ac:chgData name="김 남혁" userId="492584a0ac289ca9" providerId="LiveId" clId="{DED9E42A-D383-4645-9113-F421ADC786EF}" dt="2019-11-03T10:43:04.602" v="122" actId="164"/>
          <ac:cxnSpMkLst>
            <pc:docMk/>
            <pc:sldMk cId="2451882138" sldId="631"/>
            <ac:cxnSpMk id="39" creationId="{A6921266-A4F5-49F7-9EBE-9BE54F10D3A2}"/>
          </ac:cxnSpMkLst>
        </pc:cxnChg>
        <pc:cxnChg chg="mod topLvl">
          <ac:chgData name="김 남혁" userId="492584a0ac289ca9" providerId="LiveId" clId="{DED9E42A-D383-4645-9113-F421ADC786EF}" dt="2019-11-03T10:43:04.602" v="122" actId="164"/>
          <ac:cxnSpMkLst>
            <pc:docMk/>
            <pc:sldMk cId="2451882138" sldId="631"/>
            <ac:cxnSpMk id="40" creationId="{9B645D23-DAD2-4FBF-AB60-A8DEA024C514}"/>
          </ac:cxnSpMkLst>
        </pc:cxnChg>
      </pc:sldChg>
      <pc:sldChg chg="addSp delSp modSp add ord">
        <pc:chgData name="김 남혁" userId="492584a0ac289ca9" providerId="LiveId" clId="{DED9E42A-D383-4645-9113-F421ADC786EF}" dt="2019-11-04T04:44:19.003" v="922" actId="20577"/>
        <pc:sldMkLst>
          <pc:docMk/>
          <pc:sldMk cId="3598135459" sldId="632"/>
        </pc:sldMkLst>
        <pc:spChg chg="del">
          <ac:chgData name="김 남혁" userId="492584a0ac289ca9" providerId="LiveId" clId="{DED9E42A-D383-4645-9113-F421ADC786EF}" dt="2019-11-03T10:24:59.562" v="2" actId="478"/>
          <ac:spMkLst>
            <pc:docMk/>
            <pc:sldMk cId="3598135459" sldId="632"/>
            <ac:spMk id="2" creationId="{82B260F4-74E2-47C7-A5E1-E57708391284}"/>
          </ac:spMkLst>
        </pc:spChg>
        <pc:spChg chg="del">
          <ac:chgData name="김 남혁" userId="492584a0ac289ca9" providerId="LiveId" clId="{DED9E42A-D383-4645-9113-F421ADC786EF}" dt="2019-11-03T10:24:59.562" v="2" actId="478"/>
          <ac:spMkLst>
            <pc:docMk/>
            <pc:sldMk cId="3598135459" sldId="632"/>
            <ac:spMk id="3" creationId="{24530705-4A20-4792-802C-4A04616AB734}"/>
          </ac:spMkLst>
        </pc:spChg>
        <pc:spChg chg="add del mod">
          <ac:chgData name="김 남혁" userId="492584a0ac289ca9" providerId="LiveId" clId="{DED9E42A-D383-4645-9113-F421ADC786EF}" dt="2019-11-04T01:58:52.716" v="904" actId="11529"/>
          <ac:spMkLst>
            <pc:docMk/>
            <pc:sldMk cId="3598135459" sldId="632"/>
            <ac:spMk id="3" creationId="{457D2A76-9C2B-4E62-A259-AA4879AD63D8}"/>
          </ac:spMkLst>
        </pc:spChg>
        <pc:spChg chg="add mod">
          <ac:chgData name="김 남혁" userId="492584a0ac289ca9" providerId="LiveId" clId="{DED9E42A-D383-4645-9113-F421ADC786EF}" dt="2019-11-04T01:42:37.854" v="812" actId="1076"/>
          <ac:spMkLst>
            <pc:docMk/>
            <pc:sldMk cId="3598135459" sldId="632"/>
            <ac:spMk id="6" creationId="{92C202BB-F027-48AE-A9C3-139ADC809563}"/>
          </ac:spMkLst>
        </pc:spChg>
        <pc:spChg chg="add del mod topLvl">
          <ac:chgData name="김 남혁" userId="492584a0ac289ca9" providerId="LiveId" clId="{DED9E42A-D383-4645-9113-F421ADC786EF}" dt="2019-11-03T11:45:21.490" v="401" actId="478"/>
          <ac:spMkLst>
            <pc:docMk/>
            <pc:sldMk cId="3598135459" sldId="632"/>
            <ac:spMk id="6" creationId="{B4EA65B6-8434-4791-AC2B-FEBD797671AA}"/>
          </ac:spMkLst>
        </pc:spChg>
        <pc:spChg chg="add mod">
          <ac:chgData name="김 남혁" userId="492584a0ac289ca9" providerId="LiveId" clId="{DED9E42A-D383-4645-9113-F421ADC786EF}" dt="2019-11-04T01:59:41.599" v="917" actId="1076"/>
          <ac:spMkLst>
            <pc:docMk/>
            <pc:sldMk cId="3598135459" sldId="632"/>
            <ac:spMk id="7" creationId="{4B728A01-1F1A-4163-AB86-E4E46E1E1476}"/>
          </ac:spMkLst>
        </pc:spChg>
        <pc:spChg chg="add del mod topLvl">
          <ac:chgData name="김 남혁" userId="492584a0ac289ca9" providerId="LiveId" clId="{DED9E42A-D383-4645-9113-F421ADC786EF}" dt="2019-11-03T11:45:21.490" v="401" actId="478"/>
          <ac:spMkLst>
            <pc:docMk/>
            <pc:sldMk cId="3598135459" sldId="632"/>
            <ac:spMk id="7" creationId="{EDB9C41F-19FE-404D-8CB5-DBD928E2F9E5}"/>
          </ac:spMkLst>
        </pc:spChg>
        <pc:spChg chg="add del mod topLvl">
          <ac:chgData name="김 남혁" userId="492584a0ac289ca9" providerId="LiveId" clId="{DED9E42A-D383-4645-9113-F421ADC786EF}" dt="2019-11-03T11:45:21.490" v="401" actId="478"/>
          <ac:spMkLst>
            <pc:docMk/>
            <pc:sldMk cId="3598135459" sldId="632"/>
            <ac:spMk id="8" creationId="{B8E720BC-5E4A-4939-A35D-64245C195C86}"/>
          </ac:spMkLst>
        </pc:spChg>
        <pc:spChg chg="add mod topLvl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9" creationId="{3272BB27-81D5-49DA-AC02-D2E8C518C7FD}"/>
          </ac:spMkLst>
        </pc:spChg>
        <pc:spChg chg="add mod topLvl">
          <ac:chgData name="김 남혁" userId="492584a0ac289ca9" providerId="LiveId" clId="{DED9E42A-D383-4645-9113-F421ADC786EF}" dt="2019-11-04T01:33:51.433" v="696" actId="20577"/>
          <ac:spMkLst>
            <pc:docMk/>
            <pc:sldMk cId="3598135459" sldId="632"/>
            <ac:spMk id="26" creationId="{6B428FB0-7849-4671-B2CD-D64051DD78D9}"/>
          </ac:spMkLst>
        </pc:spChg>
        <pc:spChg chg="add mod topLvl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27" creationId="{7E3DEEA7-903B-4008-948C-E427B0371F41}"/>
          </ac:spMkLst>
        </pc:spChg>
        <pc:spChg chg="add mod topLvl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28" creationId="{F74EE607-3725-49A2-BB0A-711473E71F02}"/>
          </ac:spMkLst>
        </pc:spChg>
        <pc:spChg chg="add mod topLvl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29" creationId="{E889EB6A-6C6D-4787-999E-CA8BE7C89379}"/>
          </ac:spMkLst>
        </pc:spChg>
        <pc:spChg chg="add mod topLvl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30" creationId="{B4F3ED55-8866-4AFD-A293-E09D78253966}"/>
          </ac:spMkLst>
        </pc:spChg>
        <pc:spChg chg="add mod topLvl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33" creationId="{2E10BA94-5A33-4686-A943-92537E72B093}"/>
          </ac:spMkLst>
        </pc:spChg>
        <pc:spChg chg="add mod topLvl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35" creationId="{9415D4DC-0168-4505-B997-96598B93B1F5}"/>
          </ac:spMkLst>
        </pc:spChg>
        <pc:spChg chg="add mod">
          <ac:chgData name="김 남혁" userId="492584a0ac289ca9" providerId="LiveId" clId="{DED9E42A-D383-4645-9113-F421ADC786EF}" dt="2019-11-03T11:49:36.018" v="517" actId="1036"/>
          <ac:spMkLst>
            <pc:docMk/>
            <pc:sldMk cId="3598135459" sldId="632"/>
            <ac:spMk id="40" creationId="{DEB50ED1-F03E-4F3D-A199-1734F1969BC2}"/>
          </ac:spMkLst>
        </pc:spChg>
        <pc:spChg chg="add mod">
          <ac:chgData name="김 남혁" userId="492584a0ac289ca9" providerId="LiveId" clId="{DED9E42A-D383-4645-9113-F421ADC786EF}" dt="2019-11-03T11:49:36.018" v="517" actId="1036"/>
          <ac:spMkLst>
            <pc:docMk/>
            <pc:sldMk cId="3598135459" sldId="632"/>
            <ac:spMk id="41" creationId="{E9855229-E513-4908-AA7A-8A987C599C59}"/>
          </ac:spMkLst>
        </pc:spChg>
        <pc:spChg chg="add mod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42" creationId="{6BCE8209-76D5-48F2-AD9B-33F3FDF9DCA8}"/>
          </ac:spMkLst>
        </pc:spChg>
        <pc:spChg chg="add mod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43" creationId="{8F3AF298-A116-4122-9A55-9FC2DB60BC9D}"/>
          </ac:spMkLst>
        </pc:spChg>
        <pc:spChg chg="add mod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44" creationId="{D1EAD08B-619E-479C-9EEF-EDFB0658EA9C}"/>
          </ac:spMkLst>
        </pc:spChg>
        <pc:spChg chg="add mod">
          <ac:chgData name="김 남혁" userId="492584a0ac289ca9" providerId="LiveId" clId="{DED9E42A-D383-4645-9113-F421ADC786EF}" dt="2019-11-03T11:48:52.961" v="495" actId="164"/>
          <ac:spMkLst>
            <pc:docMk/>
            <pc:sldMk cId="3598135459" sldId="632"/>
            <ac:spMk id="45" creationId="{A22016CF-7CF1-419E-BA00-5951D1E148FC}"/>
          </ac:spMkLst>
        </pc:spChg>
        <pc:spChg chg="mod topLvl">
          <ac:chgData name="김 남혁" userId="492584a0ac289ca9" providerId="LiveId" clId="{DED9E42A-D383-4645-9113-F421ADC786EF}" dt="2019-11-04T01:38:50.120" v="781" actId="165"/>
          <ac:spMkLst>
            <pc:docMk/>
            <pc:sldMk cId="3598135459" sldId="632"/>
            <ac:spMk id="52" creationId="{30FDB558-2EDA-4F6E-868C-196FC5B9A59D}"/>
          </ac:spMkLst>
        </pc:spChg>
        <pc:spChg chg="mod topLvl">
          <ac:chgData name="김 남혁" userId="492584a0ac289ca9" providerId="LiveId" clId="{DED9E42A-D383-4645-9113-F421ADC786EF}" dt="2019-11-04T01:38:50.120" v="781" actId="165"/>
          <ac:spMkLst>
            <pc:docMk/>
            <pc:sldMk cId="3598135459" sldId="632"/>
            <ac:spMk id="53" creationId="{9AA2CCAA-4857-4631-90C0-DE0614D015BB}"/>
          </ac:spMkLst>
        </pc:spChg>
        <pc:spChg chg="mod topLvl">
          <ac:chgData name="김 남혁" userId="492584a0ac289ca9" providerId="LiveId" clId="{DED9E42A-D383-4645-9113-F421ADC786EF}" dt="2019-11-04T01:38:50.120" v="781" actId="165"/>
          <ac:spMkLst>
            <pc:docMk/>
            <pc:sldMk cId="3598135459" sldId="632"/>
            <ac:spMk id="54" creationId="{40FCCFF0-2815-4B25-85E7-858C46D7C4AC}"/>
          </ac:spMkLst>
        </pc:spChg>
        <pc:spChg chg="mod topLvl">
          <ac:chgData name="김 남혁" userId="492584a0ac289ca9" providerId="LiveId" clId="{DED9E42A-D383-4645-9113-F421ADC786EF}" dt="2019-11-04T01:38:50.120" v="781" actId="165"/>
          <ac:spMkLst>
            <pc:docMk/>
            <pc:sldMk cId="3598135459" sldId="632"/>
            <ac:spMk id="55" creationId="{8095BC85-93BB-4E7E-AA25-11DF9455613B}"/>
          </ac:spMkLst>
        </pc:spChg>
        <pc:spChg chg="del mod topLvl">
          <ac:chgData name="김 남혁" userId="492584a0ac289ca9" providerId="LiveId" clId="{DED9E42A-D383-4645-9113-F421ADC786EF}" dt="2019-11-04T01:41:38.638" v="802" actId="478"/>
          <ac:spMkLst>
            <pc:docMk/>
            <pc:sldMk cId="3598135459" sldId="632"/>
            <ac:spMk id="56" creationId="{CB89AB3E-4BE9-43E4-9F16-2CB2ABDBD523}"/>
          </ac:spMkLst>
        </pc:spChg>
        <pc:spChg chg="mod topLvl">
          <ac:chgData name="김 남혁" userId="492584a0ac289ca9" providerId="LiveId" clId="{DED9E42A-D383-4645-9113-F421ADC786EF}" dt="2019-11-04T04:44:16.427" v="921" actId="20577"/>
          <ac:spMkLst>
            <pc:docMk/>
            <pc:sldMk cId="3598135459" sldId="632"/>
            <ac:spMk id="62" creationId="{A89CAF13-4433-43C9-B3B6-6E6837E4FC4A}"/>
          </ac:spMkLst>
        </pc:spChg>
        <pc:spChg chg="mod topLvl">
          <ac:chgData name="김 남혁" userId="492584a0ac289ca9" providerId="LiveId" clId="{DED9E42A-D383-4645-9113-F421ADC786EF}" dt="2019-11-04T01:38:50.120" v="781" actId="165"/>
          <ac:spMkLst>
            <pc:docMk/>
            <pc:sldMk cId="3598135459" sldId="632"/>
            <ac:spMk id="65" creationId="{DE78B96C-8710-4A99-B695-7B4D705BBD31}"/>
          </ac:spMkLst>
        </pc:spChg>
        <pc:spChg chg="mod topLvl">
          <ac:chgData name="김 남혁" userId="492584a0ac289ca9" providerId="LiveId" clId="{DED9E42A-D383-4645-9113-F421ADC786EF}" dt="2019-11-04T01:38:50.120" v="781" actId="165"/>
          <ac:spMkLst>
            <pc:docMk/>
            <pc:sldMk cId="3598135459" sldId="632"/>
            <ac:spMk id="66" creationId="{9530CD86-7E0E-4EB2-9D20-B98154BCBC05}"/>
          </ac:spMkLst>
        </pc:spChg>
        <pc:spChg chg="mod topLvl">
          <ac:chgData name="김 남혁" userId="492584a0ac289ca9" providerId="LiveId" clId="{DED9E42A-D383-4645-9113-F421ADC786EF}" dt="2019-11-04T01:38:50.120" v="781" actId="165"/>
          <ac:spMkLst>
            <pc:docMk/>
            <pc:sldMk cId="3598135459" sldId="632"/>
            <ac:spMk id="67" creationId="{25A34C66-528D-4F60-BA21-71D21711E6B9}"/>
          </ac:spMkLst>
        </pc:spChg>
        <pc:spChg chg="mod topLvl">
          <ac:chgData name="김 남혁" userId="492584a0ac289ca9" providerId="LiveId" clId="{DED9E42A-D383-4645-9113-F421ADC786EF}" dt="2019-11-04T01:38:50.120" v="781" actId="165"/>
          <ac:spMkLst>
            <pc:docMk/>
            <pc:sldMk cId="3598135459" sldId="632"/>
            <ac:spMk id="68" creationId="{ECA122AD-F52D-4DE9-9FBA-77D6F864720B}"/>
          </ac:spMkLst>
        </pc:spChg>
        <pc:spChg chg="mod topLvl">
          <ac:chgData name="김 남혁" userId="492584a0ac289ca9" providerId="LiveId" clId="{DED9E42A-D383-4645-9113-F421ADC786EF}" dt="2019-11-04T04:44:19.003" v="922" actId="20577"/>
          <ac:spMkLst>
            <pc:docMk/>
            <pc:sldMk cId="3598135459" sldId="632"/>
            <ac:spMk id="73" creationId="{AE665CFA-445F-4D2D-AFF7-5B6B53A53885}"/>
          </ac:spMkLst>
        </pc:spChg>
        <pc:spChg chg="del mod topLvl">
          <ac:chgData name="김 남혁" userId="492584a0ac289ca9" providerId="LiveId" clId="{DED9E42A-D383-4645-9113-F421ADC786EF}" dt="2019-11-04T01:41:54.972" v="803" actId="478"/>
          <ac:spMkLst>
            <pc:docMk/>
            <pc:sldMk cId="3598135459" sldId="632"/>
            <ac:spMk id="75" creationId="{67932C9B-3FA6-414B-8F48-433826326059}"/>
          </ac:spMkLst>
        </pc:spChg>
        <pc:spChg chg="add mod topLvl">
          <ac:chgData name="김 남혁" userId="492584a0ac289ca9" providerId="LiveId" clId="{DED9E42A-D383-4645-9113-F421ADC786EF}" dt="2019-11-04T01:38:37.692" v="780" actId="165"/>
          <ac:spMkLst>
            <pc:docMk/>
            <pc:sldMk cId="3598135459" sldId="632"/>
            <ac:spMk id="76" creationId="{504947F9-C87E-403A-9412-53924F76D20F}"/>
          </ac:spMkLst>
        </pc:spChg>
        <pc:spChg chg="add mod topLvl">
          <ac:chgData name="김 남혁" userId="492584a0ac289ca9" providerId="LiveId" clId="{DED9E42A-D383-4645-9113-F421ADC786EF}" dt="2019-11-04T01:38:37.692" v="780" actId="165"/>
          <ac:spMkLst>
            <pc:docMk/>
            <pc:sldMk cId="3598135459" sldId="632"/>
            <ac:spMk id="77" creationId="{57F7901F-D820-42B7-8E15-9020DCE645EE}"/>
          </ac:spMkLst>
        </pc:spChg>
        <pc:spChg chg="add mod topLvl">
          <ac:chgData name="김 남혁" userId="492584a0ac289ca9" providerId="LiveId" clId="{DED9E42A-D383-4645-9113-F421ADC786EF}" dt="2019-11-04T01:38:37.692" v="780" actId="165"/>
          <ac:spMkLst>
            <pc:docMk/>
            <pc:sldMk cId="3598135459" sldId="632"/>
            <ac:spMk id="78" creationId="{C1A2D8E3-A1B3-4A4E-AEC1-1EE34655BF54}"/>
          </ac:spMkLst>
        </pc:spChg>
        <pc:spChg chg="add mod">
          <ac:chgData name="김 남혁" userId="492584a0ac289ca9" providerId="LiveId" clId="{DED9E42A-D383-4645-9113-F421ADC786EF}" dt="2019-11-04T01:35:27.847" v="723" actId="1036"/>
          <ac:spMkLst>
            <pc:docMk/>
            <pc:sldMk cId="3598135459" sldId="632"/>
            <ac:spMk id="79" creationId="{408F63AF-0A40-4264-B002-A25020FA5697}"/>
          </ac:spMkLst>
        </pc:spChg>
        <pc:spChg chg="add mod">
          <ac:chgData name="김 남혁" userId="492584a0ac289ca9" providerId="LiveId" clId="{DED9E42A-D383-4645-9113-F421ADC786EF}" dt="2019-11-04T01:42:44.813" v="813" actId="1076"/>
          <ac:spMkLst>
            <pc:docMk/>
            <pc:sldMk cId="3598135459" sldId="632"/>
            <ac:spMk id="80" creationId="{952C1C04-DB7A-4D76-ADD4-87BAB324E957}"/>
          </ac:spMkLst>
        </pc:spChg>
        <pc:spChg chg="add mod">
          <ac:chgData name="김 남혁" userId="492584a0ac289ca9" providerId="LiveId" clId="{DED9E42A-D383-4645-9113-F421ADC786EF}" dt="2019-11-04T01:44:15.533" v="843" actId="1076"/>
          <ac:spMkLst>
            <pc:docMk/>
            <pc:sldMk cId="3598135459" sldId="632"/>
            <ac:spMk id="81" creationId="{F1723A48-5B88-4A6C-88C2-0EF7FA2E3EB7}"/>
          </ac:spMkLst>
        </pc:spChg>
        <pc:grpChg chg="add mod">
          <ac:chgData name="김 남혁" userId="492584a0ac289ca9" providerId="LiveId" clId="{DED9E42A-D383-4645-9113-F421ADC786EF}" dt="2019-11-03T11:49:40.114" v="518" actId="1076"/>
          <ac:grpSpMkLst>
            <pc:docMk/>
            <pc:sldMk cId="3598135459" sldId="632"/>
            <ac:grpSpMk id="2" creationId="{267269D4-157C-4BB7-AF5B-1E513430E48A}"/>
          </ac:grpSpMkLst>
        </pc:grpChg>
        <pc:grpChg chg="add del mod">
          <ac:chgData name="김 남혁" userId="492584a0ac289ca9" providerId="LiveId" clId="{DED9E42A-D383-4645-9113-F421ADC786EF}" dt="2019-11-04T01:38:37.692" v="780" actId="165"/>
          <ac:grpSpMkLst>
            <pc:docMk/>
            <pc:sldMk cId="3598135459" sldId="632"/>
            <ac:grpSpMk id="3" creationId="{DCB46CC7-6634-409E-885A-279C6526159A}"/>
          </ac:grpSpMkLst>
        </pc:grpChg>
        <pc:grpChg chg="add mod topLvl">
          <ac:chgData name="김 남혁" userId="492584a0ac289ca9" providerId="LiveId" clId="{DED9E42A-D383-4645-9113-F421ADC786EF}" dt="2019-11-03T11:48:52.961" v="495" actId="164"/>
          <ac:grpSpMkLst>
            <pc:docMk/>
            <pc:sldMk cId="3598135459" sldId="632"/>
            <ac:grpSpMk id="10" creationId="{CD9981C9-B3FC-4DDF-B456-0B9FF86FA4F0}"/>
          </ac:grpSpMkLst>
        </pc:grpChg>
        <pc:grpChg chg="add mod topLvl">
          <ac:chgData name="김 남혁" userId="492584a0ac289ca9" providerId="LiveId" clId="{DED9E42A-D383-4645-9113-F421ADC786EF}" dt="2019-11-03T11:48:52.961" v="495" actId="164"/>
          <ac:grpSpMkLst>
            <pc:docMk/>
            <pc:sldMk cId="3598135459" sldId="632"/>
            <ac:grpSpMk id="14" creationId="{691D2D72-6215-4BC0-84D6-55AE98F63ADE}"/>
          </ac:grpSpMkLst>
        </pc:grpChg>
        <pc:grpChg chg="add mod topLvl">
          <ac:chgData name="김 남혁" userId="492584a0ac289ca9" providerId="LiveId" clId="{DED9E42A-D383-4645-9113-F421ADC786EF}" dt="2019-11-03T11:48:52.961" v="495" actId="164"/>
          <ac:grpSpMkLst>
            <pc:docMk/>
            <pc:sldMk cId="3598135459" sldId="632"/>
            <ac:grpSpMk id="18" creationId="{0FC0D2D4-2FC3-4291-B27D-3A3A3A927E88}"/>
          </ac:grpSpMkLst>
        </pc:grpChg>
        <pc:grpChg chg="add mod topLvl">
          <ac:chgData name="김 남혁" userId="492584a0ac289ca9" providerId="LiveId" clId="{DED9E42A-D383-4645-9113-F421ADC786EF}" dt="2019-11-03T11:48:52.961" v="495" actId="164"/>
          <ac:grpSpMkLst>
            <pc:docMk/>
            <pc:sldMk cId="3598135459" sldId="632"/>
            <ac:grpSpMk id="22" creationId="{2855D960-7DFD-4BDF-8EC3-9A88A135F6B7}"/>
          </ac:grpSpMkLst>
        </pc:grpChg>
        <pc:grpChg chg="add del mod">
          <ac:chgData name="김 남혁" userId="492584a0ac289ca9" providerId="LiveId" clId="{DED9E42A-D383-4645-9113-F421ADC786EF}" dt="2019-11-03T11:44:28.429" v="393" actId="165"/>
          <ac:grpSpMkLst>
            <pc:docMk/>
            <pc:sldMk cId="3598135459" sldId="632"/>
            <ac:grpSpMk id="39" creationId="{63F30AFF-C404-48C3-A17B-34754CCA705C}"/>
          </ac:grpSpMkLst>
        </pc:grpChg>
        <pc:grpChg chg="add del mod topLvl">
          <ac:chgData name="김 남혁" userId="492584a0ac289ca9" providerId="LiveId" clId="{DED9E42A-D383-4645-9113-F421ADC786EF}" dt="2019-11-04T01:38:50.120" v="781" actId="165"/>
          <ac:grpSpMkLst>
            <pc:docMk/>
            <pc:sldMk cId="3598135459" sldId="632"/>
            <ac:grpSpMk id="50" creationId="{7009B7DD-6A78-4DF7-BD3E-A07C8B01CAA5}"/>
          </ac:grpSpMkLst>
        </pc:grpChg>
        <pc:graphicFrameChg chg="add mod topLvl">
          <ac:chgData name="김 남혁" userId="492584a0ac289ca9" providerId="LiveId" clId="{DED9E42A-D383-4645-9113-F421ADC786EF}" dt="2019-11-03T11:48:52.961" v="495" actId="164"/>
          <ac:graphicFrameMkLst>
            <pc:docMk/>
            <pc:sldMk cId="3598135459" sldId="632"/>
            <ac:graphicFrameMk id="32" creationId="{B4903C0E-E766-4B5C-9873-35404887C265}"/>
          </ac:graphicFrameMkLst>
        </pc:graphicFrameChg>
        <pc:graphicFrameChg chg="mod topLvl">
          <ac:chgData name="김 남혁" userId="492584a0ac289ca9" providerId="LiveId" clId="{DED9E42A-D383-4645-9113-F421ADC786EF}" dt="2019-11-04T01:38:50.120" v="781" actId="165"/>
          <ac:graphicFrameMkLst>
            <pc:docMk/>
            <pc:sldMk cId="3598135459" sldId="632"/>
            <ac:graphicFrameMk id="74" creationId="{61171AA9-60C7-42F2-8C0A-0A6E94FC1460}"/>
          </ac:graphicFrameMkLst>
        </pc:graphicFrameChg>
        <pc:picChg chg="add mod topLvl">
          <ac:chgData name="김 남혁" userId="492584a0ac289ca9" providerId="LiveId" clId="{DED9E42A-D383-4645-9113-F421ADC786EF}" dt="2019-11-03T11:48:52.961" v="495" actId="164"/>
          <ac:picMkLst>
            <pc:docMk/>
            <pc:sldMk cId="3598135459" sldId="632"/>
            <ac:picMk id="4" creationId="{7A68EC50-457D-450A-874D-70689F9B989C}"/>
          </ac:picMkLst>
        </pc:picChg>
        <pc:picChg chg="add mod topLvl">
          <ac:chgData name="김 남혁" userId="492584a0ac289ca9" providerId="LiveId" clId="{DED9E42A-D383-4645-9113-F421ADC786EF}" dt="2019-11-03T11:48:52.961" v="495" actId="164"/>
          <ac:picMkLst>
            <pc:docMk/>
            <pc:sldMk cId="3598135459" sldId="632"/>
            <ac:picMk id="5" creationId="{CEE0FF5C-DF00-429E-AF1E-7C883DFDF3C2}"/>
          </ac:picMkLst>
        </pc:picChg>
        <pc:picChg chg="add mod topLvl">
          <ac:chgData name="김 남혁" userId="492584a0ac289ca9" providerId="LiveId" clId="{DED9E42A-D383-4645-9113-F421ADC786EF}" dt="2019-11-03T11:48:52.961" v="495" actId="164"/>
          <ac:picMkLst>
            <pc:docMk/>
            <pc:sldMk cId="3598135459" sldId="632"/>
            <ac:picMk id="34" creationId="{3F9642FF-C9D1-4F7F-8498-DFE3A09D9B3C}"/>
          </ac:picMkLst>
        </pc:picChg>
        <pc:picChg chg="mod topLvl">
          <ac:chgData name="김 남혁" userId="492584a0ac289ca9" providerId="LiveId" clId="{DED9E42A-D383-4645-9113-F421ADC786EF}" dt="2019-11-04T01:38:50.120" v="781" actId="165"/>
          <ac:picMkLst>
            <pc:docMk/>
            <pc:sldMk cId="3598135459" sldId="632"/>
            <ac:picMk id="51" creationId="{5BC1CEB2-4FBF-47D3-BD72-BAF361885FA3}"/>
          </ac:picMkLst>
        </pc:picChg>
        <pc:picChg chg="mod topLvl">
          <ac:chgData name="김 남혁" userId="492584a0ac289ca9" providerId="LiveId" clId="{DED9E42A-D383-4645-9113-F421ADC786EF}" dt="2019-11-04T01:38:50.120" v="781" actId="165"/>
          <ac:picMkLst>
            <pc:docMk/>
            <pc:sldMk cId="3598135459" sldId="632"/>
            <ac:picMk id="61" creationId="{A486F532-7FF8-470A-9D33-E9D81D655EE4}"/>
          </ac:picMkLst>
        </pc:picChg>
        <pc:picChg chg="mod topLvl">
          <ac:chgData name="김 남혁" userId="492584a0ac289ca9" providerId="LiveId" clId="{DED9E42A-D383-4645-9113-F421ADC786EF}" dt="2019-11-04T01:38:50.120" v="781" actId="165"/>
          <ac:picMkLst>
            <pc:docMk/>
            <pc:sldMk cId="3598135459" sldId="632"/>
            <ac:picMk id="63" creationId="{BBA60586-AAE4-45F7-AB4F-354005AD3939}"/>
          </ac:picMkLst>
        </pc:picChg>
        <pc:picChg chg="mod topLvl">
          <ac:chgData name="김 남혁" userId="492584a0ac289ca9" providerId="LiveId" clId="{DED9E42A-D383-4645-9113-F421ADC786EF}" dt="2019-11-04T01:38:50.120" v="781" actId="165"/>
          <ac:picMkLst>
            <pc:docMk/>
            <pc:sldMk cId="3598135459" sldId="632"/>
            <ac:picMk id="64" creationId="{E6DBA898-4506-4E82-A7F5-F1C7B362AFA5}"/>
          </ac:picMkLst>
        </pc:picChg>
        <pc:cxnChg chg="add mod topLvl">
          <ac:chgData name="김 남혁" userId="492584a0ac289ca9" providerId="LiveId" clId="{DED9E42A-D383-4645-9113-F421ADC786EF}" dt="2019-11-03T11:48:52.961" v="495" actId="164"/>
          <ac:cxnSpMkLst>
            <pc:docMk/>
            <pc:sldMk cId="3598135459" sldId="632"/>
            <ac:cxnSpMk id="31" creationId="{91F69F0D-4361-46E8-A9F0-F740B10428AE}"/>
          </ac:cxnSpMkLst>
        </pc:cxnChg>
        <pc:cxnChg chg="add del mod topLvl">
          <ac:chgData name="김 남혁" userId="492584a0ac289ca9" providerId="LiveId" clId="{DED9E42A-D383-4645-9113-F421ADC786EF}" dt="2019-11-03T11:45:21.490" v="401" actId="478"/>
          <ac:cxnSpMkLst>
            <pc:docMk/>
            <pc:sldMk cId="3598135459" sldId="632"/>
            <ac:cxnSpMk id="36" creationId="{A90BE266-7B11-40CB-B156-C4D03540BB0A}"/>
          </ac:cxnSpMkLst>
        </pc:cxnChg>
        <pc:cxnChg chg="add del mod topLvl">
          <ac:chgData name="김 남혁" userId="492584a0ac289ca9" providerId="LiveId" clId="{DED9E42A-D383-4645-9113-F421ADC786EF}" dt="2019-11-03T11:45:21.490" v="401" actId="478"/>
          <ac:cxnSpMkLst>
            <pc:docMk/>
            <pc:sldMk cId="3598135459" sldId="632"/>
            <ac:cxnSpMk id="37" creationId="{4A0B5719-F88A-4ECF-A117-A40887019F99}"/>
          </ac:cxnSpMkLst>
        </pc:cxnChg>
        <pc:cxnChg chg="add del mod topLvl">
          <ac:chgData name="김 남혁" userId="492584a0ac289ca9" providerId="LiveId" clId="{DED9E42A-D383-4645-9113-F421ADC786EF}" dt="2019-11-03T11:45:21.490" v="401" actId="478"/>
          <ac:cxnSpMkLst>
            <pc:docMk/>
            <pc:sldMk cId="3598135459" sldId="632"/>
            <ac:cxnSpMk id="38" creationId="{6FA691B8-0BA9-41BF-AD6A-0E8192EE2138}"/>
          </ac:cxnSpMkLst>
        </pc:cxnChg>
        <pc:cxnChg chg="add mod">
          <ac:chgData name="김 남혁" userId="492584a0ac289ca9" providerId="LiveId" clId="{DED9E42A-D383-4645-9113-F421ADC786EF}" dt="2019-11-03T11:48:52.961" v="495" actId="164"/>
          <ac:cxnSpMkLst>
            <pc:docMk/>
            <pc:sldMk cId="3598135459" sldId="632"/>
            <ac:cxnSpMk id="46" creationId="{7E6171A7-8E5A-43C3-8142-F9DB3064D7B9}"/>
          </ac:cxnSpMkLst>
        </pc:cxnChg>
        <pc:cxnChg chg="add mod">
          <ac:chgData name="김 남혁" userId="492584a0ac289ca9" providerId="LiveId" clId="{DED9E42A-D383-4645-9113-F421ADC786EF}" dt="2019-11-03T11:48:52.961" v="495" actId="164"/>
          <ac:cxnSpMkLst>
            <pc:docMk/>
            <pc:sldMk cId="3598135459" sldId="632"/>
            <ac:cxnSpMk id="47" creationId="{5C6D4E48-9919-442C-B4FC-02B888C4667D}"/>
          </ac:cxnSpMkLst>
        </pc:cxnChg>
        <pc:cxnChg chg="add mod">
          <ac:chgData name="김 남혁" userId="492584a0ac289ca9" providerId="LiveId" clId="{DED9E42A-D383-4645-9113-F421ADC786EF}" dt="2019-11-03T11:48:52.961" v="495" actId="164"/>
          <ac:cxnSpMkLst>
            <pc:docMk/>
            <pc:sldMk cId="3598135459" sldId="632"/>
            <ac:cxnSpMk id="48" creationId="{9A97DF8E-BF39-4C2F-88A0-25EE6E6B4344}"/>
          </ac:cxnSpMkLst>
        </pc:cxnChg>
        <pc:cxnChg chg="add mod">
          <ac:chgData name="김 남혁" userId="492584a0ac289ca9" providerId="LiveId" clId="{DED9E42A-D383-4645-9113-F421ADC786EF}" dt="2019-11-03T11:48:52.961" v="495" actId="164"/>
          <ac:cxnSpMkLst>
            <pc:docMk/>
            <pc:sldMk cId="3598135459" sldId="632"/>
            <ac:cxnSpMk id="49" creationId="{AC1DC84D-023F-46CC-9687-C08D07FB63B1}"/>
          </ac:cxnSpMkLst>
        </pc:cxnChg>
        <pc:cxnChg chg="mod topLvl">
          <ac:chgData name="김 남혁" userId="492584a0ac289ca9" providerId="LiveId" clId="{DED9E42A-D383-4645-9113-F421ADC786EF}" dt="2019-11-04T01:38:50.120" v="781" actId="165"/>
          <ac:cxnSpMkLst>
            <pc:docMk/>
            <pc:sldMk cId="3598135459" sldId="632"/>
            <ac:cxnSpMk id="57" creationId="{5F09FB74-4A73-42C9-B284-364D9F3781A6}"/>
          </ac:cxnSpMkLst>
        </pc:cxnChg>
        <pc:cxnChg chg="mod topLvl">
          <ac:chgData name="김 남혁" userId="492584a0ac289ca9" providerId="LiveId" clId="{DED9E42A-D383-4645-9113-F421ADC786EF}" dt="2019-11-04T01:38:50.120" v="781" actId="165"/>
          <ac:cxnSpMkLst>
            <pc:docMk/>
            <pc:sldMk cId="3598135459" sldId="632"/>
            <ac:cxnSpMk id="58" creationId="{B1A3E002-87AB-41C3-BC4B-46C7DA3FDFD7}"/>
          </ac:cxnSpMkLst>
        </pc:cxnChg>
        <pc:cxnChg chg="mod topLvl">
          <ac:chgData name="김 남혁" userId="492584a0ac289ca9" providerId="LiveId" clId="{DED9E42A-D383-4645-9113-F421ADC786EF}" dt="2019-11-04T01:38:50.120" v="781" actId="165"/>
          <ac:cxnSpMkLst>
            <pc:docMk/>
            <pc:sldMk cId="3598135459" sldId="632"/>
            <ac:cxnSpMk id="59" creationId="{3D6563E2-05DF-44A1-9BAB-7125BE7194C7}"/>
          </ac:cxnSpMkLst>
        </pc:cxnChg>
        <pc:cxnChg chg="mod topLvl">
          <ac:chgData name="김 남혁" userId="492584a0ac289ca9" providerId="LiveId" clId="{DED9E42A-D383-4645-9113-F421ADC786EF}" dt="2019-11-04T01:38:50.120" v="781" actId="165"/>
          <ac:cxnSpMkLst>
            <pc:docMk/>
            <pc:sldMk cId="3598135459" sldId="632"/>
            <ac:cxnSpMk id="60" creationId="{E76BC347-9B8F-4AA0-8EFE-F29B884A3976}"/>
          </ac:cxnSpMkLst>
        </pc:cxnChg>
        <pc:cxnChg chg="mod topLvl">
          <ac:chgData name="김 남혁" userId="492584a0ac289ca9" providerId="LiveId" clId="{DED9E42A-D383-4645-9113-F421ADC786EF}" dt="2019-11-04T01:38:50.120" v="781" actId="165"/>
          <ac:cxnSpMkLst>
            <pc:docMk/>
            <pc:sldMk cId="3598135459" sldId="632"/>
            <ac:cxnSpMk id="69" creationId="{38D084A2-2979-4CEF-A915-311B1B01EC8F}"/>
          </ac:cxnSpMkLst>
        </pc:cxnChg>
        <pc:cxnChg chg="mod topLvl">
          <ac:chgData name="김 남혁" userId="492584a0ac289ca9" providerId="LiveId" clId="{DED9E42A-D383-4645-9113-F421ADC786EF}" dt="2019-11-04T01:38:50.120" v="781" actId="165"/>
          <ac:cxnSpMkLst>
            <pc:docMk/>
            <pc:sldMk cId="3598135459" sldId="632"/>
            <ac:cxnSpMk id="70" creationId="{AFBC33CE-240E-477B-BB1B-CE133F6ECC9E}"/>
          </ac:cxnSpMkLst>
        </pc:cxnChg>
        <pc:cxnChg chg="mod topLvl">
          <ac:chgData name="김 남혁" userId="492584a0ac289ca9" providerId="LiveId" clId="{DED9E42A-D383-4645-9113-F421ADC786EF}" dt="2019-11-04T01:38:50.120" v="781" actId="165"/>
          <ac:cxnSpMkLst>
            <pc:docMk/>
            <pc:sldMk cId="3598135459" sldId="632"/>
            <ac:cxnSpMk id="71" creationId="{948375E7-3790-4AF5-B35E-AB689A7105FB}"/>
          </ac:cxnSpMkLst>
        </pc:cxnChg>
        <pc:cxnChg chg="mod topLvl">
          <ac:chgData name="김 남혁" userId="492584a0ac289ca9" providerId="LiveId" clId="{DED9E42A-D383-4645-9113-F421ADC786EF}" dt="2019-11-04T01:38:50.120" v="781" actId="165"/>
          <ac:cxnSpMkLst>
            <pc:docMk/>
            <pc:sldMk cId="3598135459" sldId="632"/>
            <ac:cxnSpMk id="72" creationId="{D93FF0E8-644A-4B8D-A84C-121E62D30003}"/>
          </ac:cxnSpMkLst>
        </pc:cxnChg>
      </pc:sldChg>
      <pc:sldChg chg="addSp delSp modSp add del">
        <pc:chgData name="김 남혁" userId="492584a0ac289ca9" providerId="LiveId" clId="{DED9E42A-D383-4645-9113-F421ADC786EF}" dt="2019-11-03T11:50:11.209" v="540" actId="2696"/>
        <pc:sldMkLst>
          <pc:docMk/>
          <pc:sldMk cId="65058991" sldId="633"/>
        </pc:sldMkLst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3" creationId="{20505359-4386-43A9-9169-83D4846CE868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4" creationId="{41B0805A-7753-4A77-8C90-8C3DF5982731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5" creationId="{0C7F2580-14FA-4A52-9BE6-78105CC9F9EA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6" creationId="{7BC94074-42C4-40A4-AB4D-1CA3BBF13689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7" creationId="{2E1B8166-D576-4E73-BAA1-E08BA6AA0EB2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13" creationId="{0669AADB-0A1A-4DA5-B255-9C88FE57B4D5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16" creationId="{0174B2AF-4DEF-4BB9-8D1A-CBA81F831F0C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17" creationId="{83FCA4AA-C4D2-4375-BBBB-F51543BF6DD6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18" creationId="{6F9BB465-888F-4A7C-8607-62E46E41B3C9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19" creationId="{ECBE3D2E-6C6C-4539-873B-4A2E116A974D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24" creationId="{148613F4-F0E4-4079-AE43-EB3625AC07D3}"/>
          </ac:spMkLst>
        </pc:spChg>
        <pc:spChg chg="add mod topLvl">
          <ac:chgData name="김 남혁" userId="492584a0ac289ca9" providerId="LiveId" clId="{DED9E42A-D383-4645-9113-F421ADC786EF}" dt="2019-11-03T10:45:15.824" v="153" actId="164"/>
          <ac:spMkLst>
            <pc:docMk/>
            <pc:sldMk cId="65058991" sldId="633"/>
            <ac:spMk id="26" creationId="{6ADF4CCC-F13E-479E-AE47-74ECA9CBEE73}"/>
          </ac:spMkLst>
        </pc:spChg>
        <pc:spChg chg="add mod">
          <ac:chgData name="김 남혁" userId="492584a0ac289ca9" providerId="LiveId" clId="{DED9E42A-D383-4645-9113-F421ADC786EF}" dt="2019-11-03T11:15:07.604" v="334" actId="1035"/>
          <ac:spMkLst>
            <pc:docMk/>
            <pc:sldMk cId="65058991" sldId="633"/>
            <ac:spMk id="29" creationId="{0D2F7541-C4B1-41B3-BC10-C97986CFB419}"/>
          </ac:spMkLst>
        </pc:spChg>
        <pc:spChg chg="add mod">
          <ac:chgData name="김 남혁" userId="492584a0ac289ca9" providerId="LiveId" clId="{DED9E42A-D383-4645-9113-F421ADC786EF}" dt="2019-11-03T11:15:07.604" v="334" actId="1035"/>
          <ac:spMkLst>
            <pc:docMk/>
            <pc:sldMk cId="65058991" sldId="633"/>
            <ac:spMk id="30" creationId="{164201CC-C75A-495F-9144-17881D82447A}"/>
          </ac:spMkLst>
        </pc:spChg>
        <pc:spChg chg="add mod">
          <ac:chgData name="김 남혁" userId="492584a0ac289ca9" providerId="LiveId" clId="{DED9E42A-D383-4645-9113-F421ADC786EF}" dt="2019-11-03T11:15:07.604" v="334" actId="1035"/>
          <ac:spMkLst>
            <pc:docMk/>
            <pc:sldMk cId="65058991" sldId="633"/>
            <ac:spMk id="31" creationId="{D27895F5-FCBC-417F-B28E-EC5B6B0A9C82}"/>
          </ac:spMkLst>
        </pc:spChg>
        <pc:grpChg chg="add del mod">
          <ac:chgData name="김 남혁" userId="492584a0ac289ca9" providerId="LiveId" clId="{DED9E42A-D383-4645-9113-F421ADC786EF}" dt="2019-11-03T10:44:59.885" v="150" actId="165"/>
          <ac:grpSpMkLst>
            <pc:docMk/>
            <pc:sldMk cId="65058991" sldId="633"/>
            <ac:grpSpMk id="27" creationId="{27F58896-B6B7-4D28-BEA5-330D561A5ECA}"/>
          </ac:grpSpMkLst>
        </pc:grpChg>
        <pc:grpChg chg="add mod">
          <ac:chgData name="김 남혁" userId="492584a0ac289ca9" providerId="LiveId" clId="{DED9E42A-D383-4645-9113-F421ADC786EF}" dt="2019-11-03T10:45:18.376" v="154" actId="1076"/>
          <ac:grpSpMkLst>
            <pc:docMk/>
            <pc:sldMk cId="65058991" sldId="633"/>
            <ac:grpSpMk id="28" creationId="{ECB04F28-240F-44E4-A2F1-A5E217E89ECE}"/>
          </ac:grpSpMkLst>
        </pc:grpChg>
        <pc:graphicFrameChg chg="add mod topLvl">
          <ac:chgData name="김 남혁" userId="492584a0ac289ca9" providerId="LiveId" clId="{DED9E42A-D383-4645-9113-F421ADC786EF}" dt="2019-11-03T10:45:15.824" v="153" actId="164"/>
          <ac:graphicFrameMkLst>
            <pc:docMk/>
            <pc:sldMk cId="65058991" sldId="633"/>
            <ac:graphicFrameMk id="25" creationId="{668ED90C-A852-4E7F-ABAE-FB61AEECE00B}"/>
          </ac:graphicFrameMkLst>
        </pc:graphicFrameChg>
        <pc:picChg chg="add mod topLvl">
          <ac:chgData name="김 남혁" userId="492584a0ac289ca9" providerId="LiveId" clId="{DED9E42A-D383-4645-9113-F421ADC786EF}" dt="2019-11-03T10:45:15.824" v="153" actId="164"/>
          <ac:picMkLst>
            <pc:docMk/>
            <pc:sldMk cId="65058991" sldId="633"/>
            <ac:picMk id="2" creationId="{CC3219FF-5F5D-4478-9E36-290DF67D3E15}"/>
          </ac:picMkLst>
        </pc:picChg>
        <pc:picChg chg="add mod topLvl">
          <ac:chgData name="김 남혁" userId="492584a0ac289ca9" providerId="LiveId" clId="{DED9E42A-D383-4645-9113-F421ADC786EF}" dt="2019-11-03T10:45:15.824" v="153" actId="164"/>
          <ac:picMkLst>
            <pc:docMk/>
            <pc:sldMk cId="65058991" sldId="633"/>
            <ac:picMk id="12" creationId="{56D2A74F-4AF7-4C48-9876-1F001C816E63}"/>
          </ac:picMkLst>
        </pc:picChg>
        <pc:picChg chg="add mod topLvl">
          <ac:chgData name="김 남혁" userId="492584a0ac289ca9" providerId="LiveId" clId="{DED9E42A-D383-4645-9113-F421ADC786EF}" dt="2019-11-03T10:45:15.824" v="153" actId="164"/>
          <ac:picMkLst>
            <pc:docMk/>
            <pc:sldMk cId="65058991" sldId="633"/>
            <ac:picMk id="14" creationId="{F4F0C5FC-E313-4A70-B80D-36C1B9A832CB}"/>
          </ac:picMkLst>
        </pc:picChg>
        <pc:picChg chg="add mod topLvl">
          <ac:chgData name="김 남혁" userId="492584a0ac289ca9" providerId="LiveId" clId="{DED9E42A-D383-4645-9113-F421ADC786EF}" dt="2019-11-03T10:45:15.824" v="153" actId="164"/>
          <ac:picMkLst>
            <pc:docMk/>
            <pc:sldMk cId="65058991" sldId="633"/>
            <ac:picMk id="15" creationId="{67E49537-7DDA-436F-B96C-A1684F7221D9}"/>
          </ac:picMkLst>
        </pc:picChg>
        <pc:cxnChg chg="add mod topLvl">
          <ac:chgData name="김 남혁" userId="492584a0ac289ca9" providerId="LiveId" clId="{DED9E42A-D383-4645-9113-F421ADC786EF}" dt="2019-11-03T10:45:15.824" v="153" actId="164"/>
          <ac:cxnSpMkLst>
            <pc:docMk/>
            <pc:sldMk cId="65058991" sldId="633"/>
            <ac:cxnSpMk id="8" creationId="{8B1E2ABE-94F1-405E-B620-9A9758A125BB}"/>
          </ac:cxnSpMkLst>
        </pc:cxnChg>
        <pc:cxnChg chg="add mod topLvl">
          <ac:chgData name="김 남혁" userId="492584a0ac289ca9" providerId="LiveId" clId="{DED9E42A-D383-4645-9113-F421ADC786EF}" dt="2019-11-03T10:45:15.824" v="153" actId="164"/>
          <ac:cxnSpMkLst>
            <pc:docMk/>
            <pc:sldMk cId="65058991" sldId="633"/>
            <ac:cxnSpMk id="9" creationId="{D41D338C-3343-442B-A5DC-44F3E3208713}"/>
          </ac:cxnSpMkLst>
        </pc:cxnChg>
        <pc:cxnChg chg="add mod topLvl">
          <ac:chgData name="김 남혁" userId="492584a0ac289ca9" providerId="LiveId" clId="{DED9E42A-D383-4645-9113-F421ADC786EF}" dt="2019-11-03T10:45:15.824" v="153" actId="164"/>
          <ac:cxnSpMkLst>
            <pc:docMk/>
            <pc:sldMk cId="65058991" sldId="633"/>
            <ac:cxnSpMk id="10" creationId="{DCB28527-A1C9-4134-9B15-B46A69CA1A02}"/>
          </ac:cxnSpMkLst>
        </pc:cxnChg>
        <pc:cxnChg chg="add mod topLvl">
          <ac:chgData name="김 남혁" userId="492584a0ac289ca9" providerId="LiveId" clId="{DED9E42A-D383-4645-9113-F421ADC786EF}" dt="2019-11-03T10:45:15.824" v="153" actId="164"/>
          <ac:cxnSpMkLst>
            <pc:docMk/>
            <pc:sldMk cId="65058991" sldId="633"/>
            <ac:cxnSpMk id="11" creationId="{71026E55-BE7D-44B5-91C7-8DF870332FDC}"/>
          </ac:cxnSpMkLst>
        </pc:cxnChg>
        <pc:cxnChg chg="add mod topLvl">
          <ac:chgData name="김 남혁" userId="492584a0ac289ca9" providerId="LiveId" clId="{DED9E42A-D383-4645-9113-F421ADC786EF}" dt="2019-11-03T10:45:15.824" v="153" actId="164"/>
          <ac:cxnSpMkLst>
            <pc:docMk/>
            <pc:sldMk cId="65058991" sldId="633"/>
            <ac:cxnSpMk id="20" creationId="{103B6F0C-9F2B-4B0A-944A-25C4EAE863CE}"/>
          </ac:cxnSpMkLst>
        </pc:cxnChg>
        <pc:cxnChg chg="add mod topLvl">
          <ac:chgData name="김 남혁" userId="492584a0ac289ca9" providerId="LiveId" clId="{DED9E42A-D383-4645-9113-F421ADC786EF}" dt="2019-11-03T10:45:15.824" v="153" actId="164"/>
          <ac:cxnSpMkLst>
            <pc:docMk/>
            <pc:sldMk cId="65058991" sldId="633"/>
            <ac:cxnSpMk id="21" creationId="{29BB4DF3-762C-434D-BB32-29F8E5B3C076}"/>
          </ac:cxnSpMkLst>
        </pc:cxnChg>
        <pc:cxnChg chg="add mod topLvl">
          <ac:chgData name="김 남혁" userId="492584a0ac289ca9" providerId="LiveId" clId="{DED9E42A-D383-4645-9113-F421ADC786EF}" dt="2019-11-03T10:45:15.824" v="153" actId="164"/>
          <ac:cxnSpMkLst>
            <pc:docMk/>
            <pc:sldMk cId="65058991" sldId="633"/>
            <ac:cxnSpMk id="22" creationId="{768D951A-790A-4400-A25D-9A55D9711A2F}"/>
          </ac:cxnSpMkLst>
        </pc:cxnChg>
        <pc:cxnChg chg="add mod topLvl">
          <ac:chgData name="김 남혁" userId="492584a0ac289ca9" providerId="LiveId" clId="{DED9E42A-D383-4645-9113-F421ADC786EF}" dt="2019-11-03T10:45:15.824" v="153" actId="164"/>
          <ac:cxnSpMkLst>
            <pc:docMk/>
            <pc:sldMk cId="65058991" sldId="633"/>
            <ac:cxnSpMk id="23" creationId="{EE92472C-EA73-4E7B-B3B2-FA239FA51560}"/>
          </ac:cxnSpMkLst>
        </pc:cxnChg>
      </pc:sldChg>
      <pc:sldChg chg="addSp delSp modSp add">
        <pc:chgData name="김 남혁" userId="492584a0ac289ca9" providerId="LiveId" clId="{DED9E42A-D383-4645-9113-F421ADC786EF}" dt="2019-11-04T04:55:47.958" v="938"/>
        <pc:sldMkLst>
          <pc:docMk/>
          <pc:sldMk cId="17353670" sldId="634"/>
        </pc:sldMkLst>
        <pc:spChg chg="add mod">
          <ac:chgData name="김 남혁" userId="492584a0ac289ca9" providerId="LiveId" clId="{DED9E42A-D383-4645-9113-F421ADC786EF}" dt="2019-11-03T11:14:48.780" v="312" actId="1036"/>
          <ac:spMkLst>
            <pc:docMk/>
            <pc:sldMk cId="17353670" sldId="634"/>
            <ac:spMk id="42" creationId="{77B25049-B463-4326-BD46-917DC05465CF}"/>
          </ac:spMkLst>
        </pc:spChg>
        <pc:spChg chg="add mod">
          <ac:chgData name="김 남혁" userId="492584a0ac289ca9" providerId="LiveId" clId="{DED9E42A-D383-4645-9113-F421ADC786EF}" dt="2019-11-03T11:14:48.780" v="312" actId="1036"/>
          <ac:spMkLst>
            <pc:docMk/>
            <pc:sldMk cId="17353670" sldId="634"/>
            <ac:spMk id="43" creationId="{A1E12E79-71E7-4FF6-AA3B-5F320FF501BB}"/>
          </ac:spMkLst>
        </pc:spChg>
        <pc:spChg chg="add mod">
          <ac:chgData name="김 남혁" userId="492584a0ac289ca9" providerId="LiveId" clId="{DED9E42A-D383-4645-9113-F421ADC786EF}" dt="2019-11-03T11:14:48.780" v="312" actId="1036"/>
          <ac:spMkLst>
            <pc:docMk/>
            <pc:sldMk cId="17353670" sldId="634"/>
            <ac:spMk id="44" creationId="{CD8277A5-36C1-4F2E-AACF-4EA665EAD829}"/>
          </ac:spMkLst>
        </pc:spChg>
        <pc:grpChg chg="del">
          <ac:chgData name="김 남혁" userId="492584a0ac289ca9" providerId="LiveId" clId="{DED9E42A-D383-4645-9113-F421ADC786EF}" dt="2019-11-03T10:36:10.489" v="106" actId="478"/>
          <ac:grpSpMkLst>
            <pc:docMk/>
            <pc:sldMk cId="17353670" sldId="634"/>
            <ac:grpSpMk id="27" creationId="{27F58896-B6B7-4D28-BEA5-330D561A5ECA}"/>
          </ac:grpSpMkLst>
        </pc:grpChg>
        <pc:grpChg chg="add mod">
          <ac:chgData name="김 남혁" userId="492584a0ac289ca9" providerId="LiveId" clId="{DED9E42A-D383-4645-9113-F421ADC786EF}" dt="2019-11-03T10:44:28.906" v="143" actId="164"/>
          <ac:grpSpMkLst>
            <pc:docMk/>
            <pc:sldMk cId="17353670" sldId="634"/>
            <ac:grpSpMk id="28" creationId="{DFB058E4-33D6-4E38-BE6F-DE5A9EFC8526}"/>
          </ac:grpSpMkLst>
        </pc:grpChg>
        <pc:grpChg chg="add mod">
          <ac:chgData name="김 남혁" userId="492584a0ac289ca9" providerId="LiveId" clId="{DED9E42A-D383-4645-9113-F421ADC786EF}" dt="2019-11-04T01:32:14.150" v="650"/>
          <ac:grpSpMkLst>
            <pc:docMk/>
            <pc:sldMk cId="17353670" sldId="634"/>
            <ac:grpSpMk id="41" creationId="{73A7F7E1-598E-4C7A-AACE-B3B1CB97DF18}"/>
          </ac:grpSpMkLst>
        </pc:grpChg>
        <pc:graphicFrameChg chg="add mod">
          <ac:chgData name="김 남혁" userId="492584a0ac289ca9" providerId="LiveId" clId="{DED9E42A-D383-4645-9113-F421ADC786EF}" dt="2019-11-04T04:55:47.958" v="938"/>
          <ac:graphicFrameMkLst>
            <pc:docMk/>
            <pc:sldMk cId="17353670" sldId="634"/>
            <ac:graphicFrameMk id="39" creationId="{CED6118C-39A7-47E2-B18C-3C3012EC7B1A}"/>
          </ac:graphicFrameMkLst>
        </pc:graphicFrameChg>
        <pc:graphicFrameChg chg="add mod">
          <ac:chgData name="김 남혁" userId="492584a0ac289ca9" providerId="LiveId" clId="{DED9E42A-D383-4645-9113-F421ADC786EF}" dt="2019-11-04T01:32:14.150" v="650"/>
          <ac:graphicFrameMkLst>
            <pc:docMk/>
            <pc:sldMk cId="17353670" sldId="634"/>
            <ac:graphicFrameMk id="40" creationId="{B9303DDE-6752-4455-9EBD-04B48715EA2A}"/>
          </ac:graphicFrameMkLst>
        </pc:graphicFrameChg>
      </pc:sldChg>
      <pc:sldChg chg="add del">
        <pc:chgData name="김 남혁" userId="492584a0ac289ca9" providerId="LiveId" clId="{DED9E42A-D383-4645-9113-F421ADC786EF}" dt="2019-11-03T10:36:01.433" v="101" actId="2696"/>
        <pc:sldMkLst>
          <pc:docMk/>
          <pc:sldMk cId="751135793" sldId="634"/>
        </pc:sldMkLst>
      </pc:sldChg>
      <pc:sldChg chg="addSp modSp add">
        <pc:chgData name="김 남혁" userId="492584a0ac289ca9" providerId="LiveId" clId="{DED9E42A-D383-4645-9113-F421ADC786EF}" dt="2019-11-04T01:27:49.538" v="636"/>
        <pc:sldMkLst>
          <pc:docMk/>
          <pc:sldMk cId="26628413" sldId="635"/>
        </pc:sldMkLst>
        <pc:spChg chg="add mod">
          <ac:chgData name="김 남혁" userId="492584a0ac289ca9" providerId="LiveId" clId="{DED9E42A-D383-4645-9113-F421ADC786EF}" dt="2019-11-04T01:27:06.420" v="620" actId="1037"/>
          <ac:spMkLst>
            <pc:docMk/>
            <pc:sldMk cId="26628413" sldId="635"/>
            <ac:spMk id="6" creationId="{13995579-165E-4BD1-A136-C6B3587880C9}"/>
          </ac:spMkLst>
        </pc:spChg>
        <pc:spChg chg="add mod">
          <ac:chgData name="김 남혁" userId="492584a0ac289ca9" providerId="LiveId" clId="{DED9E42A-D383-4645-9113-F421ADC786EF}" dt="2019-11-04T01:27:40.558" v="633" actId="1076"/>
          <ac:spMkLst>
            <pc:docMk/>
            <pc:sldMk cId="26628413" sldId="635"/>
            <ac:spMk id="7" creationId="{FC3A25BF-466E-43F0-8687-D04C36E916E2}"/>
          </ac:spMkLst>
        </pc:spChg>
        <pc:spChg chg="add mod">
          <ac:chgData name="김 남혁" userId="492584a0ac289ca9" providerId="LiveId" clId="{DED9E42A-D383-4645-9113-F421ADC786EF}" dt="2019-11-04T01:27:47.028" v="634" actId="1076"/>
          <ac:spMkLst>
            <pc:docMk/>
            <pc:sldMk cId="26628413" sldId="635"/>
            <ac:spMk id="8" creationId="{35227387-C626-43AF-910C-1A3EA296B5CB}"/>
          </ac:spMkLst>
        </pc:spChg>
        <pc:grpChg chg="add mod">
          <ac:chgData name="김 남혁" userId="492584a0ac289ca9" providerId="LiveId" clId="{DED9E42A-D383-4645-9113-F421ADC786EF}" dt="2019-11-04T01:27:06.420" v="620" actId="1037"/>
          <ac:grpSpMkLst>
            <pc:docMk/>
            <pc:sldMk cId="26628413" sldId="635"/>
            <ac:grpSpMk id="5" creationId="{1B7BDBE5-CD30-4BAF-ABC6-340F95A4CED5}"/>
          </ac:grpSpMkLst>
        </pc:grpChg>
        <pc:graphicFrameChg chg="add mod">
          <ac:chgData name="김 남혁" userId="492584a0ac289ca9" providerId="LiveId" clId="{DED9E42A-D383-4645-9113-F421ADC786EF}" dt="2019-11-04T01:27:32.825" v="632" actId="1037"/>
          <ac:graphicFrameMkLst>
            <pc:docMk/>
            <pc:sldMk cId="26628413" sldId="635"/>
            <ac:graphicFrameMk id="2" creationId="{21A7C6FD-9141-4F2D-9321-6FC0E39403C5}"/>
          </ac:graphicFrameMkLst>
        </pc:graphicFrameChg>
        <pc:graphicFrameChg chg="add mod">
          <ac:chgData name="김 남혁" userId="492584a0ac289ca9" providerId="LiveId" clId="{DED9E42A-D383-4645-9113-F421ADC786EF}" dt="2019-11-04T01:24:39.351" v="597"/>
          <ac:graphicFrameMkLst>
            <pc:docMk/>
            <pc:sldMk cId="26628413" sldId="635"/>
            <ac:graphicFrameMk id="3" creationId="{90B80EF5-57E1-49EE-9BC6-27450068D9FA}"/>
          </ac:graphicFrameMkLst>
        </pc:graphicFrameChg>
        <pc:graphicFrameChg chg="add mod">
          <ac:chgData name="김 남혁" userId="492584a0ac289ca9" providerId="LiveId" clId="{DED9E42A-D383-4645-9113-F421ADC786EF}" dt="2019-11-04T01:27:49.538" v="636"/>
          <ac:graphicFrameMkLst>
            <pc:docMk/>
            <pc:sldMk cId="26628413" sldId="635"/>
            <ac:graphicFrameMk id="4" creationId="{B8502BAC-F7A1-4458-B4E7-7969B38C2F1C}"/>
          </ac:graphicFrameMkLst>
        </pc:graphicFrameChg>
      </pc:sldChg>
      <pc:sldChg chg="add del">
        <pc:chgData name="김 남혁" userId="492584a0ac289ca9" providerId="LiveId" clId="{DED9E42A-D383-4645-9113-F421ADC786EF}" dt="2019-11-03T10:36:02.132" v="102" actId="2696"/>
        <pc:sldMkLst>
          <pc:docMk/>
          <pc:sldMk cId="3359490992" sldId="635"/>
        </pc:sldMkLst>
      </pc:sldChg>
      <pc:sldChg chg="addSp delSp modSp add">
        <pc:chgData name="김 남혁" userId="492584a0ac289ca9" providerId="LiveId" clId="{DED9E42A-D383-4645-9113-F421ADC786EF}" dt="2019-11-04T05:02:05.052" v="947"/>
        <pc:sldMkLst>
          <pc:docMk/>
          <pc:sldMk cId="4038532872" sldId="636"/>
        </pc:sldMkLst>
        <pc:spChg chg="del">
          <ac:chgData name="김 남혁" userId="492584a0ac289ca9" providerId="LiveId" clId="{DED9E42A-D383-4645-9113-F421ADC786EF}" dt="2019-11-03T11:15:15.823" v="336" actId="478"/>
          <ac:spMkLst>
            <pc:docMk/>
            <pc:sldMk cId="4038532872" sldId="636"/>
            <ac:spMk id="6" creationId="{13995579-165E-4BD1-A136-C6B3587880C9}"/>
          </ac:spMkLst>
        </pc:spChg>
        <pc:spChg chg="del">
          <ac:chgData name="김 남혁" userId="492584a0ac289ca9" providerId="LiveId" clId="{DED9E42A-D383-4645-9113-F421ADC786EF}" dt="2019-11-03T11:15:15.823" v="336" actId="478"/>
          <ac:spMkLst>
            <pc:docMk/>
            <pc:sldMk cId="4038532872" sldId="636"/>
            <ac:spMk id="7" creationId="{FC3A25BF-466E-43F0-8687-D04C36E916E2}"/>
          </ac:spMkLst>
        </pc:spChg>
        <pc:spChg chg="del">
          <ac:chgData name="김 남혁" userId="492584a0ac289ca9" providerId="LiveId" clId="{DED9E42A-D383-4645-9113-F421ADC786EF}" dt="2019-11-03T11:15:15.823" v="336" actId="478"/>
          <ac:spMkLst>
            <pc:docMk/>
            <pc:sldMk cId="4038532872" sldId="636"/>
            <ac:spMk id="8" creationId="{35227387-C626-43AF-910C-1A3EA296B5CB}"/>
          </ac:spMkLst>
        </pc:spChg>
        <pc:spChg chg="add mod">
          <ac:chgData name="김 남혁" userId="492584a0ac289ca9" providerId="LiveId" clId="{DED9E42A-D383-4645-9113-F421ADC786EF}" dt="2019-11-03T11:31:17.612" v="388" actId="1076"/>
          <ac:spMkLst>
            <pc:docMk/>
            <pc:sldMk cId="4038532872" sldId="636"/>
            <ac:spMk id="16" creationId="{2FB72DD9-B98A-4DBF-BC26-7DE84718C974}"/>
          </ac:spMkLst>
        </pc:spChg>
        <pc:spChg chg="add mod">
          <ac:chgData name="김 남혁" userId="492584a0ac289ca9" providerId="LiveId" clId="{DED9E42A-D383-4645-9113-F421ADC786EF}" dt="2019-11-03T11:31:28.302" v="390" actId="1076"/>
          <ac:spMkLst>
            <pc:docMk/>
            <pc:sldMk cId="4038532872" sldId="636"/>
            <ac:spMk id="17" creationId="{0AB16E8A-19E3-4C74-A53A-9EFD76360A44}"/>
          </ac:spMkLst>
        </pc:spChg>
        <pc:spChg chg="add mod">
          <ac:chgData name="김 남혁" userId="492584a0ac289ca9" providerId="LiveId" clId="{DED9E42A-D383-4645-9113-F421ADC786EF}" dt="2019-11-03T11:31:33.014" v="391" actId="1076"/>
          <ac:spMkLst>
            <pc:docMk/>
            <pc:sldMk cId="4038532872" sldId="636"/>
            <ac:spMk id="18" creationId="{60B80CB3-BF37-40D1-9C22-F2B7B7C30F34}"/>
          </ac:spMkLst>
        </pc:spChg>
        <pc:spChg chg="add mod">
          <ac:chgData name="김 남혁" userId="492584a0ac289ca9" providerId="LiveId" clId="{DED9E42A-D383-4645-9113-F421ADC786EF}" dt="2019-11-04T04:49:38.637" v="937" actId="20577"/>
          <ac:spMkLst>
            <pc:docMk/>
            <pc:sldMk cId="4038532872" sldId="636"/>
            <ac:spMk id="19" creationId="{191034DB-BC39-45EB-A241-2E65F750042E}"/>
          </ac:spMkLst>
        </pc:spChg>
        <pc:spChg chg="add mod">
          <ac:chgData name="김 남혁" userId="492584a0ac289ca9" providerId="LiveId" clId="{DED9E42A-D383-4645-9113-F421ADC786EF}" dt="2019-11-04T01:46:30.352" v="890" actId="1076"/>
          <ac:spMkLst>
            <pc:docMk/>
            <pc:sldMk cId="4038532872" sldId="636"/>
            <ac:spMk id="20" creationId="{F799559E-92ED-43D7-8AFE-83A631E417F5}"/>
          </ac:spMkLst>
        </pc:spChg>
        <pc:spChg chg="add mod">
          <ac:chgData name="김 남혁" userId="492584a0ac289ca9" providerId="LiveId" clId="{DED9E42A-D383-4645-9113-F421ADC786EF}" dt="2019-11-04T01:46:56.998" v="902" actId="20577"/>
          <ac:spMkLst>
            <pc:docMk/>
            <pc:sldMk cId="4038532872" sldId="636"/>
            <ac:spMk id="21" creationId="{2EF4A8FB-D1FC-4AE4-A171-451C243AC159}"/>
          </ac:spMkLst>
        </pc:spChg>
        <pc:grpChg chg="del">
          <ac:chgData name="김 남혁" userId="492584a0ac289ca9" providerId="LiveId" clId="{DED9E42A-D383-4645-9113-F421ADC786EF}" dt="2019-11-03T11:15:15.823" v="336" actId="478"/>
          <ac:grpSpMkLst>
            <pc:docMk/>
            <pc:sldMk cId="4038532872" sldId="636"/>
            <ac:grpSpMk id="5" creationId="{1B7BDBE5-CD30-4BAF-ABC6-340F95A4CED5}"/>
          </ac:grpSpMkLst>
        </pc:grpChg>
        <pc:grpChg chg="add mod">
          <ac:chgData name="김 남혁" userId="492584a0ac289ca9" providerId="LiveId" clId="{DED9E42A-D383-4645-9113-F421ADC786EF}" dt="2019-11-03T11:30:42.702" v="385" actId="1076"/>
          <ac:grpSpMkLst>
            <pc:docMk/>
            <pc:sldMk cId="4038532872" sldId="636"/>
            <ac:grpSpMk id="15" creationId="{6C2BE2A2-E467-4B58-A3CA-93A771A248CE}"/>
          </ac:grpSpMkLst>
        </pc:grpChg>
        <pc:graphicFrameChg chg="add del mod">
          <ac:chgData name="김 남혁" userId="492584a0ac289ca9" providerId="LiveId" clId="{DED9E42A-D383-4645-9113-F421ADC786EF}" dt="2019-11-03T11:23:49.871" v="355" actId="478"/>
          <ac:graphicFrameMkLst>
            <pc:docMk/>
            <pc:sldMk cId="4038532872" sldId="636"/>
            <ac:graphicFrameMk id="9" creationId="{084E45EC-20B7-4BA5-A3D9-2759A1022ED4}"/>
          </ac:graphicFrameMkLst>
        </pc:graphicFrameChg>
        <pc:graphicFrameChg chg="add del mod">
          <ac:chgData name="김 남혁" userId="492584a0ac289ca9" providerId="LiveId" clId="{DED9E42A-D383-4645-9113-F421ADC786EF}" dt="2019-11-03T11:23:49.871" v="355" actId="478"/>
          <ac:graphicFrameMkLst>
            <pc:docMk/>
            <pc:sldMk cId="4038532872" sldId="636"/>
            <ac:graphicFrameMk id="10" creationId="{EF13DCDC-69E4-4742-B865-34069505E81A}"/>
          </ac:graphicFrameMkLst>
        </pc:graphicFrameChg>
        <pc:graphicFrameChg chg="add del mod">
          <ac:chgData name="김 남혁" userId="492584a0ac289ca9" providerId="LiveId" clId="{DED9E42A-D383-4645-9113-F421ADC786EF}" dt="2019-11-03T11:23:49.871" v="355" actId="478"/>
          <ac:graphicFrameMkLst>
            <pc:docMk/>
            <pc:sldMk cId="4038532872" sldId="636"/>
            <ac:graphicFrameMk id="11" creationId="{78615A71-6DE8-43A1-9A7A-3B8624D99C55}"/>
          </ac:graphicFrameMkLst>
        </pc:graphicFrameChg>
        <pc:graphicFrameChg chg="add mod">
          <ac:chgData name="김 남혁" userId="492584a0ac289ca9" providerId="LiveId" clId="{DED9E42A-D383-4645-9113-F421ADC786EF}" dt="2019-11-04T05:01:54.633" v="945"/>
          <ac:graphicFrameMkLst>
            <pc:docMk/>
            <pc:sldMk cId="4038532872" sldId="636"/>
            <ac:graphicFrameMk id="12" creationId="{A7AF75B3-8F40-455D-A919-C1E4A4325169}"/>
          </ac:graphicFrameMkLst>
        </pc:graphicFrameChg>
        <pc:graphicFrameChg chg="add mod">
          <ac:chgData name="김 남혁" userId="492584a0ac289ca9" providerId="LiveId" clId="{DED9E42A-D383-4645-9113-F421ADC786EF}" dt="2019-11-04T05:01:46.967" v="942"/>
          <ac:graphicFrameMkLst>
            <pc:docMk/>
            <pc:sldMk cId="4038532872" sldId="636"/>
            <ac:graphicFrameMk id="13" creationId="{F003A92B-7DCB-4565-A11E-833C1DD9A4CD}"/>
          </ac:graphicFrameMkLst>
        </pc:graphicFrameChg>
        <pc:graphicFrameChg chg="add mod">
          <ac:chgData name="김 남혁" userId="492584a0ac289ca9" providerId="LiveId" clId="{DED9E42A-D383-4645-9113-F421ADC786EF}" dt="2019-11-04T05:02:05.052" v="947"/>
          <ac:graphicFrameMkLst>
            <pc:docMk/>
            <pc:sldMk cId="4038532872" sldId="636"/>
            <ac:graphicFrameMk id="14" creationId="{6E0CA994-9329-4561-8DE1-1FA7CFA4C71A}"/>
          </ac:graphicFrameMkLst>
        </pc:graphicFrameChg>
        <pc:picChg chg="add mod">
          <ac:chgData name="김 남혁" userId="492584a0ac289ca9" providerId="LiveId" clId="{DED9E42A-D383-4645-9113-F421ADC786EF}" dt="2019-11-04T01:21:33.508" v="573" actId="1038"/>
          <ac:picMkLst>
            <pc:docMk/>
            <pc:sldMk cId="4038532872" sldId="636"/>
            <ac:picMk id="4102" creationId="{BB30A97E-82F4-4DCB-894C-CA29885EC07B}"/>
          </ac:picMkLst>
        </pc:picChg>
        <pc:picChg chg="add mod">
          <ac:chgData name="김 남혁" userId="492584a0ac289ca9" providerId="LiveId" clId="{DED9E42A-D383-4645-9113-F421ADC786EF}" dt="2019-11-04T01:21:40.149" v="576" actId="1036"/>
          <ac:picMkLst>
            <pc:docMk/>
            <pc:sldMk cId="4038532872" sldId="636"/>
            <ac:picMk id="4104" creationId="{842B5AC7-D594-415B-A36A-B37A851456A5}"/>
          </ac:picMkLst>
        </pc:picChg>
        <pc:picChg chg="add mod">
          <ac:chgData name="김 남혁" userId="492584a0ac289ca9" providerId="LiveId" clId="{DED9E42A-D383-4645-9113-F421ADC786EF}" dt="2019-11-04T01:22:37.888" v="590" actId="1038"/>
          <ac:picMkLst>
            <pc:docMk/>
            <pc:sldMk cId="4038532872" sldId="636"/>
            <ac:picMk id="4106" creationId="{47F54093-B268-418E-AB43-47B658F7BA5E}"/>
          </ac:picMkLst>
        </pc:picChg>
      </pc:sldChg>
    </pc:docChg>
  </pc:docChgLst>
  <pc:docChgLst>
    <pc:chgData name="김 남혁" userId="492584a0ac289ca9" providerId="LiveId" clId="{0CC3DB0C-F52B-4DB3-AC80-C5111D847178}"/>
    <pc:docChg chg="undo custSel addSld modSld">
      <pc:chgData name="김 남혁" userId="492584a0ac289ca9" providerId="LiveId" clId="{0CC3DB0C-F52B-4DB3-AC80-C5111D847178}" dt="2020-05-28T05:41:56.471" v="627" actId="1076"/>
      <pc:docMkLst>
        <pc:docMk/>
      </pc:docMkLst>
      <pc:sldChg chg="modSp">
        <pc:chgData name="김 남혁" userId="492584a0ac289ca9" providerId="LiveId" clId="{0CC3DB0C-F52B-4DB3-AC80-C5111D847178}" dt="2020-05-28T05:10:32.542" v="147"/>
        <pc:sldMkLst>
          <pc:docMk/>
          <pc:sldMk cId="26628413" sldId="635"/>
        </pc:sldMkLst>
        <pc:graphicFrameChg chg="mod">
          <ac:chgData name="김 남혁" userId="492584a0ac289ca9" providerId="LiveId" clId="{0CC3DB0C-F52B-4DB3-AC80-C5111D847178}" dt="2020-05-28T05:10:32.542" v="147"/>
          <ac:graphicFrameMkLst>
            <pc:docMk/>
            <pc:sldMk cId="26628413" sldId="635"/>
            <ac:graphicFrameMk id="4" creationId="{B8502BAC-F7A1-4458-B4E7-7969B38C2F1C}"/>
          </ac:graphicFrameMkLst>
        </pc:graphicFrameChg>
      </pc:sldChg>
      <pc:sldChg chg="addSp delSp modSp add mod">
        <pc:chgData name="김 남혁" userId="492584a0ac289ca9" providerId="LiveId" clId="{0CC3DB0C-F52B-4DB3-AC80-C5111D847178}" dt="2020-05-28T05:02:06.087" v="146" actId="1035"/>
        <pc:sldMkLst>
          <pc:docMk/>
          <pc:sldMk cId="1442773572" sldId="641"/>
        </pc:sldMkLst>
        <pc:spChg chg="add mod">
          <ac:chgData name="김 남혁" userId="492584a0ac289ca9" providerId="LiveId" clId="{0CC3DB0C-F52B-4DB3-AC80-C5111D847178}" dt="2020-05-28T04:59:35.005" v="74" actId="1036"/>
          <ac:spMkLst>
            <pc:docMk/>
            <pc:sldMk cId="1442773572" sldId="641"/>
            <ac:spMk id="38" creationId="{1F0BB601-EAC8-435B-98BE-614895FCDD3D}"/>
          </ac:spMkLst>
        </pc:spChg>
        <pc:spChg chg="mod">
          <ac:chgData name="김 남혁" userId="492584a0ac289ca9" providerId="LiveId" clId="{0CC3DB0C-F52B-4DB3-AC80-C5111D847178}" dt="2020-05-28T05:01:54.130" v="135" actId="1038"/>
          <ac:spMkLst>
            <pc:docMk/>
            <pc:sldMk cId="1442773572" sldId="641"/>
            <ac:spMk id="52" creationId="{30FDB558-2EDA-4F6E-868C-196FC5B9A59D}"/>
          </ac:spMkLst>
        </pc:spChg>
        <pc:spChg chg="mod">
          <ac:chgData name="김 남혁" userId="492584a0ac289ca9" providerId="LiveId" clId="{0CC3DB0C-F52B-4DB3-AC80-C5111D847178}" dt="2020-05-28T05:01:58.595" v="139" actId="1035"/>
          <ac:spMkLst>
            <pc:docMk/>
            <pc:sldMk cId="1442773572" sldId="641"/>
            <ac:spMk id="53" creationId="{9AA2CCAA-4857-4631-90C0-DE0614D015BB}"/>
          </ac:spMkLst>
        </pc:spChg>
        <pc:spChg chg="mod">
          <ac:chgData name="김 남혁" userId="492584a0ac289ca9" providerId="LiveId" clId="{0CC3DB0C-F52B-4DB3-AC80-C5111D847178}" dt="2020-05-28T05:02:02.369" v="144" actId="1035"/>
          <ac:spMkLst>
            <pc:docMk/>
            <pc:sldMk cId="1442773572" sldId="641"/>
            <ac:spMk id="54" creationId="{40FCCFF0-2815-4B25-85E7-858C46D7C4AC}"/>
          </ac:spMkLst>
        </pc:spChg>
        <pc:spChg chg="mod">
          <ac:chgData name="김 남혁" userId="492584a0ac289ca9" providerId="LiveId" clId="{0CC3DB0C-F52B-4DB3-AC80-C5111D847178}" dt="2020-05-28T05:02:06.087" v="146" actId="1035"/>
          <ac:spMkLst>
            <pc:docMk/>
            <pc:sldMk cId="1442773572" sldId="641"/>
            <ac:spMk id="55" creationId="{8095BC85-93BB-4E7E-AA25-11DF9455613B}"/>
          </ac:spMkLst>
        </pc:spChg>
        <pc:spChg chg="mod">
          <ac:chgData name="김 남혁" userId="492584a0ac289ca9" providerId="LiveId" clId="{0CC3DB0C-F52B-4DB3-AC80-C5111D847178}" dt="2020-05-28T05:01:18.631" v="94" actId="20577"/>
          <ac:spMkLst>
            <pc:docMk/>
            <pc:sldMk cId="1442773572" sldId="641"/>
            <ac:spMk id="62" creationId="{A89CAF13-4433-43C9-B3B6-6E6837E4FC4A}"/>
          </ac:spMkLst>
        </pc:spChg>
        <pc:spChg chg="mod">
          <ac:chgData name="김 남혁" userId="492584a0ac289ca9" providerId="LiveId" clId="{0CC3DB0C-F52B-4DB3-AC80-C5111D847178}" dt="2020-05-28T05:01:36.294" v="119" actId="1035"/>
          <ac:spMkLst>
            <pc:docMk/>
            <pc:sldMk cId="1442773572" sldId="641"/>
            <ac:spMk id="76" creationId="{504947F9-C87E-403A-9412-53924F76D20F}"/>
          </ac:spMkLst>
        </pc:spChg>
        <pc:spChg chg="mod">
          <ac:chgData name="김 남혁" userId="492584a0ac289ca9" providerId="LiveId" clId="{0CC3DB0C-F52B-4DB3-AC80-C5111D847178}" dt="2020-05-28T04:59:55.425" v="75" actId="1076"/>
          <ac:spMkLst>
            <pc:docMk/>
            <pc:sldMk cId="1442773572" sldId="641"/>
            <ac:spMk id="82" creationId="{7ABC30EC-C54F-5444-93AC-44B7568055DC}"/>
          </ac:spMkLst>
        </pc:spChg>
        <pc:grpChg chg="add mod">
          <ac:chgData name="김 남혁" userId="492584a0ac289ca9" providerId="LiveId" clId="{0CC3DB0C-F52B-4DB3-AC80-C5111D847178}" dt="2020-05-28T04:57:52.993" v="62" actId="14100"/>
          <ac:grpSpMkLst>
            <pc:docMk/>
            <pc:sldMk cId="1442773572" sldId="641"/>
            <ac:grpSpMk id="37" creationId="{5FFDD4D2-060E-406A-AD9C-4E0004EEF4F1}"/>
          </ac:grpSpMkLst>
        </pc:grpChg>
        <pc:picChg chg="add mod modCrop">
          <ac:chgData name="김 남혁" userId="492584a0ac289ca9" providerId="LiveId" clId="{0CC3DB0C-F52B-4DB3-AC80-C5111D847178}" dt="2020-05-28T04:55:28.427" v="25" actId="164"/>
          <ac:picMkLst>
            <pc:docMk/>
            <pc:sldMk cId="1442773572" sldId="641"/>
            <ac:picMk id="36" creationId="{5B2A4EE1-8193-46FE-9190-EBE9F7977988}"/>
          </ac:picMkLst>
        </pc:picChg>
        <pc:picChg chg="del">
          <ac:chgData name="김 남혁" userId="492584a0ac289ca9" providerId="LiveId" clId="{0CC3DB0C-F52B-4DB3-AC80-C5111D847178}" dt="2020-05-28T04:55:49.134" v="29" actId="478"/>
          <ac:picMkLst>
            <pc:docMk/>
            <pc:sldMk cId="1442773572" sldId="641"/>
            <ac:picMk id="51" creationId="{5BC1CEB2-4FBF-47D3-BD72-BAF361885FA3}"/>
          </ac:picMkLst>
        </pc:picChg>
        <pc:picChg chg="mod">
          <ac:chgData name="김 남혁" userId="492584a0ac289ca9" providerId="LiveId" clId="{0CC3DB0C-F52B-4DB3-AC80-C5111D847178}" dt="2020-05-28T05:00:12.976" v="77" actId="14100"/>
          <ac:picMkLst>
            <pc:docMk/>
            <pc:sldMk cId="1442773572" sldId="641"/>
            <ac:picMk id="61" creationId="{A486F532-7FF8-470A-9D33-E9D81D655EE4}"/>
          </ac:picMkLst>
        </pc:picChg>
        <pc:picChg chg="mod modCrop">
          <ac:chgData name="김 남혁" userId="492584a0ac289ca9" providerId="LiveId" clId="{0CC3DB0C-F52B-4DB3-AC80-C5111D847178}" dt="2020-05-28T05:00:46.705" v="79" actId="14100"/>
          <ac:picMkLst>
            <pc:docMk/>
            <pc:sldMk cId="1442773572" sldId="641"/>
            <ac:picMk id="63" creationId="{BBA60586-AAE4-45F7-AB4F-354005AD3939}"/>
          </ac:picMkLst>
        </pc:picChg>
        <pc:picChg chg="add mod modCrop">
          <ac:chgData name="김 남혁" userId="492584a0ac289ca9" providerId="LiveId" clId="{0CC3DB0C-F52B-4DB3-AC80-C5111D847178}" dt="2020-05-28T04:55:28.427" v="25" actId="164"/>
          <ac:picMkLst>
            <pc:docMk/>
            <pc:sldMk cId="1442773572" sldId="641"/>
            <ac:picMk id="115" creationId="{9BAE7116-0373-47E5-8ABE-4E24E5417281}"/>
          </ac:picMkLst>
        </pc:picChg>
        <pc:cxnChg chg="mod">
          <ac:chgData name="김 남혁" userId="492584a0ac289ca9" providerId="LiveId" clId="{0CC3DB0C-F52B-4DB3-AC80-C5111D847178}" dt="2020-05-28T04:59:55.425" v="75" actId="1076"/>
          <ac:cxnSpMkLst>
            <pc:docMk/>
            <pc:sldMk cId="1442773572" sldId="641"/>
            <ac:cxnSpMk id="39" creationId="{569A6CFE-450F-FD40-AAB6-1EB3478F95E0}"/>
          </ac:cxnSpMkLst>
        </pc:cxnChg>
        <pc:cxnChg chg="mod">
          <ac:chgData name="김 남혁" userId="492584a0ac289ca9" providerId="LiveId" clId="{0CC3DB0C-F52B-4DB3-AC80-C5111D847178}" dt="2020-05-28T05:02:02.369" v="144" actId="1035"/>
          <ac:cxnSpMkLst>
            <pc:docMk/>
            <pc:sldMk cId="1442773572" sldId="641"/>
            <ac:cxnSpMk id="57" creationId="{5F09FB74-4A73-42C9-B284-364D9F3781A6}"/>
          </ac:cxnSpMkLst>
        </pc:cxnChg>
        <pc:cxnChg chg="mod">
          <ac:chgData name="김 남혁" userId="492584a0ac289ca9" providerId="LiveId" clId="{0CC3DB0C-F52B-4DB3-AC80-C5111D847178}" dt="2020-05-28T05:01:54.130" v="135" actId="1038"/>
          <ac:cxnSpMkLst>
            <pc:docMk/>
            <pc:sldMk cId="1442773572" sldId="641"/>
            <ac:cxnSpMk id="58" creationId="{B1A3E002-87AB-41C3-BC4B-46C7DA3FDFD7}"/>
          </ac:cxnSpMkLst>
        </pc:cxnChg>
        <pc:cxnChg chg="mod">
          <ac:chgData name="김 남혁" userId="492584a0ac289ca9" providerId="LiveId" clId="{0CC3DB0C-F52B-4DB3-AC80-C5111D847178}" dt="2020-05-28T05:01:58.595" v="139" actId="1035"/>
          <ac:cxnSpMkLst>
            <pc:docMk/>
            <pc:sldMk cId="1442773572" sldId="641"/>
            <ac:cxnSpMk id="59" creationId="{3D6563E2-05DF-44A1-9BAB-7125BE7194C7}"/>
          </ac:cxnSpMkLst>
        </pc:cxnChg>
        <pc:cxnChg chg="mod">
          <ac:chgData name="김 남혁" userId="492584a0ac289ca9" providerId="LiveId" clId="{0CC3DB0C-F52B-4DB3-AC80-C5111D847178}" dt="2020-05-28T05:02:06.087" v="146" actId="1035"/>
          <ac:cxnSpMkLst>
            <pc:docMk/>
            <pc:sldMk cId="1442773572" sldId="641"/>
            <ac:cxnSpMk id="60" creationId="{E76BC347-9B8F-4AA0-8EFE-F29B884A3976}"/>
          </ac:cxnSpMkLst>
        </pc:cxnChg>
      </pc:sldChg>
      <pc:sldChg chg="addSp delSp modSp add mod">
        <pc:chgData name="김 남혁" userId="492584a0ac289ca9" providerId="LiveId" clId="{0CC3DB0C-F52B-4DB3-AC80-C5111D847178}" dt="2020-05-28T05:41:56.471" v="627" actId="1076"/>
        <pc:sldMkLst>
          <pc:docMk/>
          <pc:sldMk cId="4044590329" sldId="642"/>
        </pc:sldMkLst>
        <pc:spChg chg="mod">
          <ac:chgData name="김 남혁" userId="492584a0ac289ca9" providerId="LiveId" clId="{0CC3DB0C-F52B-4DB3-AC80-C5111D847178}" dt="2020-05-28T05:41:56.471" v="627" actId="1076"/>
          <ac:spMkLst>
            <pc:docMk/>
            <pc:sldMk cId="4044590329" sldId="642"/>
            <ac:spMk id="16" creationId="{2FB72DD9-B98A-4DBF-BC26-7DE84718C974}"/>
          </ac:spMkLst>
        </pc:spChg>
        <pc:spChg chg="mod">
          <ac:chgData name="김 남혁" userId="492584a0ac289ca9" providerId="LiveId" clId="{0CC3DB0C-F52B-4DB3-AC80-C5111D847178}" dt="2020-05-28T05:41:56.471" v="627" actId="1076"/>
          <ac:spMkLst>
            <pc:docMk/>
            <pc:sldMk cId="4044590329" sldId="642"/>
            <ac:spMk id="17" creationId="{0AB16E8A-19E3-4C74-A53A-9EFD76360A44}"/>
          </ac:spMkLst>
        </pc:spChg>
        <pc:spChg chg="del">
          <ac:chgData name="김 남혁" userId="492584a0ac289ca9" providerId="LiveId" clId="{0CC3DB0C-F52B-4DB3-AC80-C5111D847178}" dt="2020-05-28T05:33:52.668" v="253" actId="478"/>
          <ac:spMkLst>
            <pc:docMk/>
            <pc:sldMk cId="4044590329" sldId="642"/>
            <ac:spMk id="18" creationId="{60B80CB3-BF37-40D1-9C22-F2B7B7C30F34}"/>
          </ac:spMkLst>
        </pc:spChg>
        <pc:spChg chg="mod topLvl">
          <ac:chgData name="김 남혁" userId="492584a0ac289ca9" providerId="LiveId" clId="{0CC3DB0C-F52B-4DB3-AC80-C5111D847178}" dt="2020-05-28T05:41:56.471" v="627" actId="1076"/>
          <ac:spMkLst>
            <pc:docMk/>
            <pc:sldMk cId="4044590329" sldId="642"/>
            <ac:spMk id="19" creationId="{191034DB-BC39-45EB-A241-2E65F750042E}"/>
          </ac:spMkLst>
        </pc:spChg>
        <pc:spChg chg="mod">
          <ac:chgData name="김 남혁" userId="492584a0ac289ca9" providerId="LiveId" clId="{0CC3DB0C-F52B-4DB3-AC80-C5111D847178}" dt="2020-05-28T05:41:56.471" v="627" actId="1076"/>
          <ac:spMkLst>
            <pc:docMk/>
            <pc:sldMk cId="4044590329" sldId="642"/>
            <ac:spMk id="20" creationId="{F799559E-92ED-43D7-8AFE-83A631E417F5}"/>
          </ac:spMkLst>
        </pc:spChg>
        <pc:spChg chg="mod">
          <ac:chgData name="김 남혁" userId="492584a0ac289ca9" providerId="LiveId" clId="{0CC3DB0C-F52B-4DB3-AC80-C5111D847178}" dt="2020-05-28T05:41:56.471" v="627" actId="1076"/>
          <ac:spMkLst>
            <pc:docMk/>
            <pc:sldMk cId="4044590329" sldId="642"/>
            <ac:spMk id="21" creationId="{2EF4A8FB-D1FC-4AE4-A171-451C243AC159}"/>
          </ac:spMkLst>
        </pc:spChg>
        <pc:grpChg chg="add del mod">
          <ac:chgData name="김 남혁" userId="492584a0ac289ca9" providerId="LiveId" clId="{0CC3DB0C-F52B-4DB3-AC80-C5111D847178}" dt="2020-05-28T05:41:18.481" v="619" actId="165"/>
          <ac:grpSpMkLst>
            <pc:docMk/>
            <pc:sldMk cId="4044590329" sldId="642"/>
            <ac:grpSpMk id="2" creationId="{A4D4E63B-D516-4A80-BF35-D3CF68433E3E}"/>
          </ac:grpSpMkLst>
        </pc:grpChg>
        <pc:grpChg chg="add mod">
          <ac:chgData name="김 남혁" userId="492584a0ac289ca9" providerId="LiveId" clId="{0CC3DB0C-F52B-4DB3-AC80-C5111D847178}" dt="2020-05-28T05:41:56.471" v="627" actId="1076"/>
          <ac:grpSpMkLst>
            <pc:docMk/>
            <pc:sldMk cId="4044590329" sldId="642"/>
            <ac:grpSpMk id="3" creationId="{3835D442-3B77-4BC4-AC31-05FBE106F1FA}"/>
          </ac:grpSpMkLst>
        </pc:grpChg>
        <pc:grpChg chg="del">
          <ac:chgData name="김 남혁" userId="492584a0ac289ca9" providerId="LiveId" clId="{0CC3DB0C-F52B-4DB3-AC80-C5111D847178}" dt="2020-05-28T05:11:48.192" v="149" actId="165"/>
          <ac:grpSpMkLst>
            <pc:docMk/>
            <pc:sldMk cId="4044590329" sldId="642"/>
            <ac:grpSpMk id="15" creationId="{6C2BE2A2-E467-4B58-A3CA-93A771A248CE}"/>
          </ac:grpSpMkLst>
        </pc:grpChg>
        <pc:graphicFrameChg chg="mod topLvl">
          <ac:chgData name="김 남혁" userId="492584a0ac289ca9" providerId="LiveId" clId="{0CC3DB0C-F52B-4DB3-AC80-C5111D847178}" dt="2020-05-28T05:41:56.471" v="627" actId="1076"/>
          <ac:graphicFrameMkLst>
            <pc:docMk/>
            <pc:sldMk cId="4044590329" sldId="642"/>
            <ac:graphicFrameMk id="12" creationId="{A7AF75B3-8F40-455D-A919-C1E4A4325169}"/>
          </ac:graphicFrameMkLst>
        </pc:graphicFrameChg>
        <pc:graphicFrameChg chg="mod topLvl">
          <ac:chgData name="김 남혁" userId="492584a0ac289ca9" providerId="LiveId" clId="{0CC3DB0C-F52B-4DB3-AC80-C5111D847178}" dt="2020-05-28T05:41:56.471" v="627" actId="1076"/>
          <ac:graphicFrameMkLst>
            <pc:docMk/>
            <pc:sldMk cId="4044590329" sldId="642"/>
            <ac:graphicFrameMk id="13" creationId="{F003A92B-7DCB-4565-A11E-833C1DD9A4CD}"/>
          </ac:graphicFrameMkLst>
        </pc:graphicFrameChg>
        <pc:graphicFrameChg chg="mod topLvl">
          <ac:chgData name="김 남혁" userId="492584a0ac289ca9" providerId="LiveId" clId="{0CC3DB0C-F52B-4DB3-AC80-C5111D847178}" dt="2020-05-28T05:41:56.471" v="627" actId="1076"/>
          <ac:graphicFrameMkLst>
            <pc:docMk/>
            <pc:sldMk cId="4044590329" sldId="642"/>
            <ac:graphicFrameMk id="14" creationId="{6E0CA994-9329-4561-8DE1-1FA7CFA4C71A}"/>
          </ac:graphicFrameMkLst>
        </pc:graphicFrameChg>
        <pc:picChg chg="add del mod">
          <ac:chgData name="김 남혁" userId="492584a0ac289ca9" providerId="LiveId" clId="{0CC3DB0C-F52B-4DB3-AC80-C5111D847178}" dt="2020-05-28T05:17:52.111" v="154" actId="478"/>
          <ac:picMkLst>
            <pc:docMk/>
            <pc:sldMk cId="4044590329" sldId="642"/>
            <ac:picMk id="23" creationId="{228A6DFE-3FB1-4737-983A-4B3D73D0B9A7}"/>
          </ac:picMkLst>
        </pc:picChg>
        <pc:picChg chg="add del mod ord">
          <ac:chgData name="김 남혁" userId="492584a0ac289ca9" providerId="LiveId" clId="{0CC3DB0C-F52B-4DB3-AC80-C5111D847178}" dt="2020-05-28T05:40:36.227" v="615" actId="478"/>
          <ac:picMkLst>
            <pc:docMk/>
            <pc:sldMk cId="4044590329" sldId="642"/>
            <ac:picMk id="24" creationId="{12D7D3FD-3F80-4142-9252-0BFAB8929E62}"/>
          </ac:picMkLst>
        </pc:picChg>
        <pc:picChg chg="add mod ord">
          <ac:chgData name="김 남혁" userId="492584a0ac289ca9" providerId="LiveId" clId="{0CC3DB0C-F52B-4DB3-AC80-C5111D847178}" dt="2020-05-28T05:41:56.471" v="627" actId="1076"/>
          <ac:picMkLst>
            <pc:docMk/>
            <pc:sldMk cId="4044590329" sldId="642"/>
            <ac:picMk id="25" creationId="{8BD06C22-7C2A-48AD-911F-4C6B33C5DC4F}"/>
          </ac:picMkLst>
        </pc:picChg>
        <pc:picChg chg="mod">
          <ac:chgData name="김 남혁" userId="492584a0ac289ca9" providerId="LiveId" clId="{0CC3DB0C-F52B-4DB3-AC80-C5111D847178}" dt="2020-05-28T05:41:56.471" v="627" actId="1076"/>
          <ac:picMkLst>
            <pc:docMk/>
            <pc:sldMk cId="4044590329" sldId="642"/>
            <ac:picMk id="4102" creationId="{BB30A97E-82F4-4DCB-894C-CA29885EC07B}"/>
          </ac:picMkLst>
        </pc:picChg>
        <pc:picChg chg="mod">
          <ac:chgData name="김 남혁" userId="492584a0ac289ca9" providerId="LiveId" clId="{0CC3DB0C-F52B-4DB3-AC80-C5111D847178}" dt="2020-05-28T05:41:56.471" v="627" actId="1076"/>
          <ac:picMkLst>
            <pc:docMk/>
            <pc:sldMk cId="4044590329" sldId="642"/>
            <ac:picMk id="4104" creationId="{842B5AC7-D594-415B-A36A-B37A851456A5}"/>
          </ac:picMkLst>
        </pc:picChg>
        <pc:picChg chg="mod topLvl">
          <ac:chgData name="김 남혁" userId="492584a0ac289ca9" providerId="LiveId" clId="{0CC3DB0C-F52B-4DB3-AC80-C5111D847178}" dt="2020-05-28T05:41:56.471" v="627" actId="1076"/>
          <ac:picMkLst>
            <pc:docMk/>
            <pc:sldMk cId="4044590329" sldId="642"/>
            <ac:picMk id="4106" creationId="{47F54093-B268-418E-AB43-47B658F7BA5E}"/>
          </ac:picMkLst>
        </pc:picChg>
      </pc:sldChg>
    </pc:docChg>
  </pc:docChgLst>
  <pc:docChgLst>
    <pc:chgData name="김 남혁" userId="492584a0ac289ca9" providerId="LiveId" clId="{563A090A-3F8C-4831-894E-5340C3821F04}"/>
    <pc:docChg chg="undo custSel delSld modSld">
      <pc:chgData name="김 남혁" userId="492584a0ac289ca9" providerId="LiveId" clId="{563A090A-3F8C-4831-894E-5340C3821F04}" dt="2020-05-29T14:04:48.026" v="119"/>
      <pc:docMkLst>
        <pc:docMk/>
      </pc:docMkLst>
      <pc:sldChg chg="addSp delSp modSp mod">
        <pc:chgData name="김 남혁" userId="492584a0ac289ca9" providerId="LiveId" clId="{563A090A-3F8C-4831-894E-5340C3821F04}" dt="2020-05-29T14:04:48.026" v="119"/>
        <pc:sldMkLst>
          <pc:docMk/>
          <pc:sldMk cId="17353670" sldId="634"/>
        </pc:sldMkLst>
        <pc:spChg chg="mod">
          <ac:chgData name="김 남혁" userId="492584a0ac289ca9" providerId="LiveId" clId="{563A090A-3F8C-4831-894E-5340C3821F04}" dt="2020-05-29T14:04:13.631" v="115" actId="20577"/>
          <ac:spMkLst>
            <pc:docMk/>
            <pc:sldMk cId="17353670" sldId="634"/>
            <ac:spMk id="30" creationId="{95237DB5-AA25-4516-B770-68A4DD118220}"/>
          </ac:spMkLst>
        </pc:spChg>
        <pc:spChg chg="mod">
          <ac:chgData name="김 남혁" userId="492584a0ac289ca9" providerId="LiveId" clId="{563A090A-3F8C-4831-894E-5340C3821F04}" dt="2020-05-29T14:01:57.178" v="98" actId="165"/>
          <ac:spMkLst>
            <pc:docMk/>
            <pc:sldMk cId="17353670" sldId="634"/>
            <ac:spMk id="31" creationId="{2E6C593B-926F-4E5D-B10E-126FF6EE86EA}"/>
          </ac:spMkLst>
        </pc:spChg>
        <pc:spChg chg="mod">
          <ac:chgData name="김 남혁" userId="492584a0ac289ca9" providerId="LiveId" clId="{563A090A-3F8C-4831-894E-5340C3821F04}" dt="2020-05-29T14:01:57.178" v="98" actId="165"/>
          <ac:spMkLst>
            <pc:docMk/>
            <pc:sldMk cId="17353670" sldId="634"/>
            <ac:spMk id="32" creationId="{02828C17-F71C-45D9-A8C9-52263EDBBAB2}"/>
          </ac:spMkLst>
        </pc:spChg>
        <pc:spChg chg="mod">
          <ac:chgData name="김 남혁" userId="492584a0ac289ca9" providerId="LiveId" clId="{563A090A-3F8C-4831-894E-5340C3821F04}" dt="2020-05-29T14:01:57.178" v="98" actId="165"/>
          <ac:spMkLst>
            <pc:docMk/>
            <pc:sldMk cId="17353670" sldId="634"/>
            <ac:spMk id="33" creationId="{8C27022E-E7AD-44CD-B71A-3B8EADF647FD}"/>
          </ac:spMkLst>
        </pc:spChg>
        <pc:spChg chg="mod">
          <ac:chgData name="김 남혁" userId="492584a0ac289ca9" providerId="LiveId" clId="{563A090A-3F8C-4831-894E-5340C3821F04}" dt="2020-05-29T14:01:57.178" v="98" actId="165"/>
          <ac:spMkLst>
            <pc:docMk/>
            <pc:sldMk cId="17353670" sldId="634"/>
            <ac:spMk id="34" creationId="{B715C10F-CF2D-4580-A80F-F75CEE1EA134}"/>
          </ac:spMkLst>
        </pc:spChg>
        <pc:grpChg chg="mod topLvl">
          <ac:chgData name="김 남혁" userId="492584a0ac289ca9" providerId="LiveId" clId="{563A090A-3F8C-4831-894E-5340C3821F04}" dt="2020-05-29T14:01:57.178" v="98" actId="165"/>
          <ac:grpSpMkLst>
            <pc:docMk/>
            <pc:sldMk cId="17353670" sldId="634"/>
            <ac:grpSpMk id="28" creationId="{DFB058E4-33D6-4E38-BE6F-DE5A9EFC8526}"/>
          </ac:grpSpMkLst>
        </pc:grpChg>
        <pc:grpChg chg="del mod">
          <ac:chgData name="김 남혁" userId="492584a0ac289ca9" providerId="LiveId" clId="{563A090A-3F8C-4831-894E-5340C3821F04}" dt="2020-05-29T14:01:57.178" v="98" actId="165"/>
          <ac:grpSpMkLst>
            <pc:docMk/>
            <pc:sldMk cId="17353670" sldId="634"/>
            <ac:grpSpMk id="41" creationId="{73A7F7E1-598E-4C7A-AACE-B3B1CB97DF18}"/>
          </ac:grpSpMkLst>
        </pc:grpChg>
        <pc:graphicFrameChg chg="add mod ord">
          <ac:chgData name="김 남혁" userId="492584a0ac289ca9" providerId="LiveId" clId="{563A090A-3F8C-4831-894E-5340C3821F04}" dt="2020-05-29T14:04:34.487" v="117"/>
          <ac:graphicFrameMkLst>
            <pc:docMk/>
            <pc:sldMk cId="17353670" sldId="634"/>
            <ac:graphicFrameMk id="2" creationId="{4B99D47B-F71F-44F7-8B89-351F4C8B8C3F}"/>
          </ac:graphicFrameMkLst>
        </pc:graphicFrameChg>
        <pc:graphicFrameChg chg="del mod">
          <ac:chgData name="김 남혁" userId="492584a0ac289ca9" providerId="LiveId" clId="{563A090A-3F8C-4831-894E-5340C3821F04}" dt="2020-05-29T13:27:22.066" v="97" actId="478"/>
          <ac:graphicFrameMkLst>
            <pc:docMk/>
            <pc:sldMk cId="17353670" sldId="634"/>
            <ac:graphicFrameMk id="39" creationId="{CED6118C-39A7-47E2-B18C-3C3012EC7B1A}"/>
          </ac:graphicFrameMkLst>
        </pc:graphicFrameChg>
        <pc:graphicFrameChg chg="mod topLvl">
          <ac:chgData name="김 남혁" userId="492584a0ac289ca9" providerId="LiveId" clId="{563A090A-3F8C-4831-894E-5340C3821F04}" dt="2020-05-29T14:04:48.026" v="119"/>
          <ac:graphicFrameMkLst>
            <pc:docMk/>
            <pc:sldMk cId="17353670" sldId="634"/>
            <ac:graphicFrameMk id="40" creationId="{B9303DDE-6752-4455-9EBD-04B48715EA2A}"/>
          </ac:graphicFrameMkLst>
        </pc:graphicFrameChg>
        <pc:picChg chg="add mod modCrop">
          <ac:chgData name="김 남혁" userId="492584a0ac289ca9" providerId="LiveId" clId="{563A090A-3F8C-4831-894E-5340C3821F04}" dt="2020-05-29T14:02:26.135" v="102" actId="1076"/>
          <ac:picMkLst>
            <pc:docMk/>
            <pc:sldMk cId="17353670" sldId="634"/>
            <ac:picMk id="20" creationId="{8079E4E3-5F8E-45D8-952A-5E972186F948}"/>
          </ac:picMkLst>
        </pc:picChg>
        <pc:picChg chg="mod modCrop">
          <ac:chgData name="김 남혁" userId="492584a0ac289ca9" providerId="LiveId" clId="{563A090A-3F8C-4831-894E-5340C3821F04}" dt="2020-05-29T14:02:15.583" v="99" actId="732"/>
          <ac:picMkLst>
            <pc:docMk/>
            <pc:sldMk cId="17353670" sldId="634"/>
            <ac:picMk id="29" creationId="{C8FF5E9C-E677-4799-9A7F-8CAB4DF3450C}"/>
          </ac:picMkLst>
        </pc:picChg>
        <pc:cxnChg chg="mod">
          <ac:chgData name="김 남혁" userId="492584a0ac289ca9" providerId="LiveId" clId="{563A090A-3F8C-4831-894E-5340C3821F04}" dt="2020-05-29T14:01:57.178" v="98" actId="165"/>
          <ac:cxnSpMkLst>
            <pc:docMk/>
            <pc:sldMk cId="17353670" sldId="634"/>
            <ac:cxnSpMk id="35" creationId="{FEFF0C67-B5EC-4E2E-A98E-976962C3F857}"/>
          </ac:cxnSpMkLst>
        </pc:cxnChg>
        <pc:cxnChg chg="mod">
          <ac:chgData name="김 남혁" userId="492584a0ac289ca9" providerId="LiveId" clId="{563A090A-3F8C-4831-894E-5340C3821F04}" dt="2020-05-29T14:01:57.178" v="98" actId="165"/>
          <ac:cxnSpMkLst>
            <pc:docMk/>
            <pc:sldMk cId="17353670" sldId="634"/>
            <ac:cxnSpMk id="36" creationId="{7B94DC72-5B2B-470C-AF70-4E3E88D43ECD}"/>
          </ac:cxnSpMkLst>
        </pc:cxnChg>
        <pc:cxnChg chg="mod">
          <ac:chgData name="김 남혁" userId="492584a0ac289ca9" providerId="LiveId" clId="{563A090A-3F8C-4831-894E-5340C3821F04}" dt="2020-05-29T14:01:57.178" v="98" actId="165"/>
          <ac:cxnSpMkLst>
            <pc:docMk/>
            <pc:sldMk cId="17353670" sldId="634"/>
            <ac:cxnSpMk id="37" creationId="{C68DCBF1-6195-482C-A274-04C594C7DFF1}"/>
          </ac:cxnSpMkLst>
        </pc:cxnChg>
        <pc:cxnChg chg="mod">
          <ac:chgData name="김 남혁" userId="492584a0ac289ca9" providerId="LiveId" clId="{563A090A-3F8C-4831-894E-5340C3821F04}" dt="2020-05-29T14:01:57.178" v="98" actId="165"/>
          <ac:cxnSpMkLst>
            <pc:docMk/>
            <pc:sldMk cId="17353670" sldId="634"/>
            <ac:cxnSpMk id="38" creationId="{02837C3F-6BD7-4947-BD5B-F48BA7C5F8B5}"/>
          </ac:cxnSpMkLst>
        </pc:cxnChg>
      </pc:sldChg>
      <pc:sldChg chg="del">
        <pc:chgData name="김 남혁" userId="492584a0ac289ca9" providerId="LiveId" clId="{563A090A-3F8C-4831-894E-5340C3821F04}" dt="2020-05-28T05:44:05.266" v="4" actId="47"/>
        <pc:sldMkLst>
          <pc:docMk/>
          <pc:sldMk cId="4038532872" sldId="636"/>
        </pc:sldMkLst>
      </pc:sldChg>
      <pc:sldChg chg="del">
        <pc:chgData name="김 남혁" userId="492584a0ac289ca9" providerId="LiveId" clId="{563A090A-3F8C-4831-894E-5340C3821F04}" dt="2020-05-28T05:44:11.811" v="6" actId="47"/>
        <pc:sldMkLst>
          <pc:docMk/>
          <pc:sldMk cId="1356419714" sldId="639"/>
        </pc:sldMkLst>
      </pc:sldChg>
      <pc:sldChg chg="del">
        <pc:chgData name="김 남혁" userId="492584a0ac289ca9" providerId="LiveId" clId="{563A090A-3F8C-4831-894E-5340C3821F04}" dt="2020-05-28T05:44:08.960" v="5" actId="47"/>
        <pc:sldMkLst>
          <pc:docMk/>
          <pc:sldMk cId="3490269967" sldId="640"/>
        </pc:sldMkLst>
      </pc:sldChg>
      <pc:sldChg chg="addSp delSp modSp mod">
        <pc:chgData name="김 남혁" userId="492584a0ac289ca9" providerId="LiveId" clId="{563A090A-3F8C-4831-894E-5340C3821F04}" dt="2020-05-28T05:52:33.435" v="71" actId="164"/>
        <pc:sldMkLst>
          <pc:docMk/>
          <pc:sldMk cId="4044590329" sldId="642"/>
        </pc:sldMkLst>
        <pc:spChg chg="add mod">
          <ac:chgData name="김 남혁" userId="492584a0ac289ca9" providerId="LiveId" clId="{563A090A-3F8C-4831-894E-5340C3821F04}" dt="2020-05-28T05:52:33.435" v="71" actId="164"/>
          <ac:spMkLst>
            <pc:docMk/>
            <pc:sldMk cId="4044590329" sldId="642"/>
            <ac:spMk id="2" creationId="{A8DBBF39-EA7E-49F3-A9B5-D80487188674}"/>
          </ac:spMkLst>
        </pc:spChg>
        <pc:spChg chg="add mod">
          <ac:chgData name="김 남혁" userId="492584a0ac289ca9" providerId="LiveId" clId="{563A090A-3F8C-4831-894E-5340C3821F04}" dt="2020-05-28T05:46:32.111" v="26" actId="1038"/>
          <ac:spMkLst>
            <pc:docMk/>
            <pc:sldMk cId="4044590329" sldId="642"/>
            <ac:spMk id="18" creationId="{D6C16F39-ED17-45A4-A9A6-EEC2CAE377E9}"/>
          </ac:spMkLst>
        </pc:spChg>
        <pc:spChg chg="mod topLvl">
          <ac:chgData name="김 남혁" userId="492584a0ac289ca9" providerId="LiveId" clId="{563A090A-3F8C-4831-894E-5340C3821F04}" dt="2020-05-28T05:52:33.435" v="71" actId="164"/>
          <ac:spMkLst>
            <pc:docMk/>
            <pc:sldMk cId="4044590329" sldId="642"/>
            <ac:spMk id="19" creationId="{191034DB-BC39-45EB-A241-2E65F750042E}"/>
          </ac:spMkLst>
        </pc:spChg>
        <pc:spChg chg="mod topLvl">
          <ac:chgData name="김 남혁" userId="492584a0ac289ca9" providerId="LiveId" clId="{563A090A-3F8C-4831-894E-5340C3821F04}" dt="2020-05-28T05:52:33.435" v="71" actId="164"/>
          <ac:spMkLst>
            <pc:docMk/>
            <pc:sldMk cId="4044590329" sldId="642"/>
            <ac:spMk id="20" creationId="{F799559E-92ED-43D7-8AFE-83A631E417F5}"/>
          </ac:spMkLst>
        </pc:spChg>
        <pc:spChg chg="mod topLvl">
          <ac:chgData name="김 남혁" userId="492584a0ac289ca9" providerId="LiveId" clId="{563A090A-3F8C-4831-894E-5340C3821F04}" dt="2020-05-28T05:52:33.435" v="71" actId="164"/>
          <ac:spMkLst>
            <pc:docMk/>
            <pc:sldMk cId="4044590329" sldId="642"/>
            <ac:spMk id="21" creationId="{2EF4A8FB-D1FC-4AE4-A171-451C243AC159}"/>
          </ac:spMkLst>
        </pc:spChg>
        <pc:grpChg chg="del mod">
          <ac:chgData name="김 남혁" userId="492584a0ac289ca9" providerId="LiveId" clId="{563A090A-3F8C-4831-894E-5340C3821F04}" dt="2020-05-28T05:52:25.925" v="70" actId="165"/>
          <ac:grpSpMkLst>
            <pc:docMk/>
            <pc:sldMk cId="4044590329" sldId="642"/>
            <ac:grpSpMk id="3" creationId="{3835D442-3B77-4BC4-AC31-05FBE106F1FA}"/>
          </ac:grpSpMkLst>
        </pc:grpChg>
        <pc:grpChg chg="add mod">
          <ac:chgData name="김 남혁" userId="492584a0ac289ca9" providerId="LiveId" clId="{563A090A-3F8C-4831-894E-5340C3821F04}" dt="2020-05-28T05:52:33.435" v="71" actId="164"/>
          <ac:grpSpMkLst>
            <pc:docMk/>
            <pc:sldMk cId="4044590329" sldId="642"/>
            <ac:grpSpMk id="4" creationId="{C3B9B609-5391-4F67-ADC4-3C655874602C}"/>
          </ac:grpSpMkLst>
        </pc:grpChg>
        <pc:graphicFrameChg chg="mod topLvl">
          <ac:chgData name="김 남혁" userId="492584a0ac289ca9" providerId="LiveId" clId="{563A090A-3F8C-4831-894E-5340C3821F04}" dt="2020-05-28T05:52:33.435" v="71" actId="164"/>
          <ac:graphicFrameMkLst>
            <pc:docMk/>
            <pc:sldMk cId="4044590329" sldId="642"/>
            <ac:graphicFrameMk id="12" creationId="{A7AF75B3-8F40-455D-A919-C1E4A4325169}"/>
          </ac:graphicFrameMkLst>
        </pc:graphicFrameChg>
        <pc:graphicFrameChg chg="mod topLvl">
          <ac:chgData name="김 남혁" userId="492584a0ac289ca9" providerId="LiveId" clId="{563A090A-3F8C-4831-894E-5340C3821F04}" dt="2020-05-28T05:52:33.435" v="71" actId="164"/>
          <ac:graphicFrameMkLst>
            <pc:docMk/>
            <pc:sldMk cId="4044590329" sldId="642"/>
            <ac:graphicFrameMk id="13" creationId="{F003A92B-7DCB-4565-A11E-833C1DD9A4CD}"/>
          </ac:graphicFrameMkLst>
        </pc:graphicFrameChg>
        <pc:graphicFrameChg chg="mod topLvl">
          <ac:chgData name="김 남혁" userId="492584a0ac289ca9" providerId="LiveId" clId="{563A090A-3F8C-4831-894E-5340C3821F04}" dt="2020-05-28T05:52:33.435" v="71" actId="164"/>
          <ac:graphicFrameMkLst>
            <pc:docMk/>
            <pc:sldMk cId="4044590329" sldId="642"/>
            <ac:graphicFrameMk id="14" creationId="{6E0CA994-9329-4561-8DE1-1FA7CFA4C71A}"/>
          </ac:graphicFrameMkLst>
        </pc:graphicFrameChg>
        <pc:picChg chg="mod topLvl">
          <ac:chgData name="김 남혁" userId="492584a0ac289ca9" providerId="LiveId" clId="{563A090A-3F8C-4831-894E-5340C3821F04}" dt="2020-05-28T05:52:33.435" v="71" actId="164"/>
          <ac:picMkLst>
            <pc:docMk/>
            <pc:sldMk cId="4044590329" sldId="642"/>
            <ac:picMk id="4102" creationId="{BB30A97E-82F4-4DCB-894C-CA29885EC07B}"/>
          </ac:picMkLst>
        </pc:picChg>
        <pc:picChg chg="mod topLvl">
          <ac:chgData name="김 남혁" userId="492584a0ac289ca9" providerId="LiveId" clId="{563A090A-3F8C-4831-894E-5340C3821F04}" dt="2020-05-28T05:52:33.435" v="71" actId="164"/>
          <ac:picMkLst>
            <pc:docMk/>
            <pc:sldMk cId="4044590329" sldId="642"/>
            <ac:picMk id="4104" creationId="{842B5AC7-D594-415B-A36A-B37A851456A5}"/>
          </ac:picMkLst>
        </pc:picChg>
        <pc:picChg chg="mod topLvl">
          <ac:chgData name="김 남혁" userId="492584a0ac289ca9" providerId="LiveId" clId="{563A090A-3F8C-4831-894E-5340C3821F04}" dt="2020-05-28T05:52:33.435" v="71" actId="164"/>
          <ac:picMkLst>
            <pc:docMk/>
            <pc:sldMk cId="4044590329" sldId="642"/>
            <ac:picMk id="4106" creationId="{47F54093-B268-418E-AB43-47B658F7BA5E}"/>
          </ac:picMkLst>
        </pc:picChg>
      </pc:sldChg>
    </pc:docChg>
  </pc:docChgLst>
  <pc:docChgLst>
    <pc:chgData name="김 남혁" userId="492584a0ac289ca9" providerId="LiveId" clId="{6927F272-C1B0-4430-AFB4-D0427AD930C2}"/>
    <pc:docChg chg="custSel modSld">
      <pc:chgData name="김 남혁" userId="492584a0ac289ca9" providerId="LiveId" clId="{6927F272-C1B0-4430-AFB4-D0427AD930C2}" dt="2019-11-24T05:35:16.415" v="101" actId="1076"/>
      <pc:docMkLst>
        <pc:docMk/>
      </pc:docMkLst>
      <pc:sldChg chg="addSp delSp modSp">
        <pc:chgData name="김 남혁" userId="492584a0ac289ca9" providerId="LiveId" clId="{6927F272-C1B0-4430-AFB4-D0427AD930C2}" dt="2019-11-24T05:35:16.415" v="101" actId="1076"/>
        <pc:sldMkLst>
          <pc:docMk/>
          <pc:sldMk cId="3598135459" sldId="632"/>
        </pc:sldMkLst>
        <pc:spChg chg="add mod">
          <ac:chgData name="김 남혁" userId="492584a0ac289ca9" providerId="LiveId" clId="{6927F272-C1B0-4430-AFB4-D0427AD930C2}" dt="2019-11-24T05:35:16.415" v="101" actId="1076"/>
          <ac:spMkLst>
            <pc:docMk/>
            <pc:sldMk cId="3598135459" sldId="632"/>
            <ac:spMk id="75" creationId="{0C81FDFE-FAAE-454F-B575-4604757C74CA}"/>
          </ac:spMkLst>
        </pc:spChg>
        <pc:spChg chg="del mod">
          <ac:chgData name="김 남혁" userId="492584a0ac289ca9" providerId="LiveId" clId="{6927F272-C1B0-4430-AFB4-D0427AD930C2}" dt="2019-11-24T05:34:13.775" v="42" actId="478"/>
          <ac:spMkLst>
            <pc:docMk/>
            <pc:sldMk cId="3598135459" sldId="632"/>
            <ac:spMk id="81" creationId="{F1723A48-5B88-4A6C-88C2-0EF7FA2E3EB7}"/>
          </ac:spMkLst>
        </pc:spChg>
        <pc:spChg chg="add del mod">
          <ac:chgData name="김 남혁" userId="492584a0ac289ca9" providerId="LiveId" clId="{6927F272-C1B0-4430-AFB4-D0427AD930C2}" dt="2019-11-24T05:34:42.787" v="66" actId="478"/>
          <ac:spMkLst>
            <pc:docMk/>
            <pc:sldMk cId="3598135459" sldId="632"/>
            <ac:spMk id="82" creationId="{A24F8AFE-24FE-4B0B-8C03-576F37702C2D}"/>
          </ac:spMkLst>
        </pc:spChg>
        <pc:graphicFrameChg chg="add del mod">
          <ac:chgData name="김 남혁" userId="492584a0ac289ca9" providerId="LiveId" clId="{6927F272-C1B0-4430-AFB4-D0427AD930C2}" dt="2019-11-24T05:32:38.927" v="22" actId="478"/>
          <ac:graphicFrameMkLst>
            <pc:docMk/>
            <pc:sldMk cId="3598135459" sldId="632"/>
            <ac:graphicFrameMk id="3" creationId="{26CD722D-D47F-41E3-A7CF-F469650C5EA4}"/>
          </ac:graphicFrameMkLst>
        </pc:graphicFrameChg>
        <pc:graphicFrameChg chg="add mod">
          <ac:chgData name="김 남혁" userId="492584a0ac289ca9" providerId="LiveId" clId="{6927F272-C1B0-4430-AFB4-D0427AD930C2}" dt="2019-11-24T05:35:11.816" v="100" actId="1076"/>
          <ac:graphicFrameMkLst>
            <pc:docMk/>
            <pc:sldMk cId="3598135459" sldId="632"/>
            <ac:graphicFrameMk id="8" creationId="{FE907455-0C66-4709-9718-561D73F4009C}"/>
          </ac:graphicFrameMkLst>
        </pc:graphicFrameChg>
      </pc:sldChg>
      <pc:sldChg chg="modSp">
        <pc:chgData name="김 남혁" userId="492584a0ac289ca9" providerId="LiveId" clId="{6927F272-C1B0-4430-AFB4-D0427AD930C2}" dt="2019-11-24T04:25:17.388" v="0" actId="947"/>
        <pc:sldMkLst>
          <pc:docMk/>
          <pc:sldMk cId="17353670" sldId="634"/>
        </pc:sldMkLst>
        <pc:spChg chg="mod">
          <ac:chgData name="김 남혁" userId="492584a0ac289ca9" providerId="LiveId" clId="{6927F272-C1B0-4430-AFB4-D0427AD930C2}" dt="2019-11-24T04:25:17.388" v="0" actId="947"/>
          <ac:spMkLst>
            <pc:docMk/>
            <pc:sldMk cId="17353670" sldId="634"/>
            <ac:spMk id="30" creationId="{95237DB5-AA25-4516-B770-68A4DD118220}"/>
          </ac:spMkLst>
        </pc:spChg>
      </pc:sldChg>
    </pc:docChg>
  </pc:docChgLst>
  <pc:docChgLst>
    <pc:chgData name="김 남혁" userId="492584a0ac289ca9" providerId="LiveId" clId="{CE86E322-83AC-4557-A56E-E2A066842647}"/>
    <pc:docChg chg="undo redo custSel addSld modSld">
      <pc:chgData name="김 남혁" userId="492584a0ac289ca9" providerId="LiveId" clId="{CE86E322-83AC-4557-A56E-E2A066842647}" dt="2020-05-11T12:06:49.334" v="301" actId="1035"/>
      <pc:docMkLst>
        <pc:docMk/>
      </pc:docMkLst>
      <pc:sldChg chg="modSp mod">
        <pc:chgData name="김 남혁" userId="492584a0ac289ca9" providerId="LiveId" clId="{CE86E322-83AC-4557-A56E-E2A066842647}" dt="2020-05-01T08:14:17.652" v="2"/>
        <pc:sldMkLst>
          <pc:docMk/>
          <pc:sldMk cId="4038532872" sldId="636"/>
        </pc:sldMkLst>
        <pc:grpChg chg="mod">
          <ac:chgData name="김 남혁" userId="492584a0ac289ca9" providerId="LiveId" clId="{CE86E322-83AC-4557-A56E-E2A066842647}" dt="2020-05-01T08:14:11.985" v="1" actId="1076"/>
          <ac:grpSpMkLst>
            <pc:docMk/>
            <pc:sldMk cId="4038532872" sldId="636"/>
            <ac:grpSpMk id="15" creationId="{6C2BE2A2-E467-4B58-A3CA-93A771A248CE}"/>
          </ac:grpSpMkLst>
        </pc:grpChg>
        <pc:graphicFrameChg chg="mod">
          <ac:chgData name="김 남혁" userId="492584a0ac289ca9" providerId="LiveId" clId="{CE86E322-83AC-4557-A56E-E2A066842647}" dt="2020-05-01T08:14:17.652" v="2"/>
          <ac:graphicFrameMkLst>
            <pc:docMk/>
            <pc:sldMk cId="4038532872" sldId="636"/>
            <ac:graphicFrameMk id="12" creationId="{A7AF75B3-8F40-455D-A919-C1E4A4325169}"/>
          </ac:graphicFrameMkLst>
        </pc:graphicFrameChg>
      </pc:sldChg>
      <pc:sldChg chg="addSp delSp modSp mod">
        <pc:chgData name="김 남혁" userId="492584a0ac289ca9" providerId="LiveId" clId="{CE86E322-83AC-4557-A56E-E2A066842647}" dt="2020-05-11T11:36:35.586" v="159" actId="478"/>
        <pc:sldMkLst>
          <pc:docMk/>
          <pc:sldMk cId="1356419714" sldId="639"/>
        </pc:sldMkLst>
        <pc:picChg chg="add del mod">
          <ac:chgData name="김 남혁" userId="492584a0ac289ca9" providerId="LiveId" clId="{CE86E322-83AC-4557-A56E-E2A066842647}" dt="2020-05-11T11:36:35.586" v="159" actId="478"/>
          <ac:picMkLst>
            <pc:docMk/>
            <pc:sldMk cId="1356419714" sldId="639"/>
            <ac:picMk id="36" creationId="{A45ADFFA-9E94-4C92-B989-BBDAABDFE10F}"/>
          </ac:picMkLst>
        </pc:picChg>
      </pc:sldChg>
      <pc:sldChg chg="addSp delSp modSp add mod">
        <pc:chgData name="김 남혁" userId="492584a0ac289ca9" providerId="LiveId" clId="{CE86E322-83AC-4557-A56E-E2A066842647}" dt="2020-05-11T12:06:49.334" v="301" actId="1035"/>
        <pc:sldMkLst>
          <pc:docMk/>
          <pc:sldMk cId="3490269967" sldId="640"/>
        </pc:sldMkLst>
        <pc:spChg chg="add mod">
          <ac:chgData name="김 남혁" userId="492584a0ac289ca9" providerId="LiveId" clId="{CE86E322-83AC-4557-A56E-E2A066842647}" dt="2020-05-11T11:42:39.193" v="235" actId="164"/>
          <ac:spMkLst>
            <pc:docMk/>
            <pc:sldMk cId="3490269967" sldId="640"/>
            <ac:spMk id="37" creationId="{F9338B97-6B3F-4FC4-8E22-01E1CB9229CA}"/>
          </ac:spMkLst>
        </pc:spChg>
        <pc:spChg chg="mod">
          <ac:chgData name="김 남혁" userId="492584a0ac289ca9" providerId="LiveId" clId="{CE86E322-83AC-4557-A56E-E2A066842647}" dt="2020-05-11T12:06:19.192" v="266" actId="1036"/>
          <ac:spMkLst>
            <pc:docMk/>
            <pc:sldMk cId="3490269967" sldId="640"/>
            <ac:spMk id="52" creationId="{30FDB558-2EDA-4F6E-868C-196FC5B9A59D}"/>
          </ac:spMkLst>
        </pc:spChg>
        <pc:spChg chg="mod">
          <ac:chgData name="김 남혁" userId="492584a0ac289ca9" providerId="LiveId" clId="{CE86E322-83AC-4557-A56E-E2A066842647}" dt="2020-05-11T12:06:38.503" v="274" actId="1035"/>
          <ac:spMkLst>
            <pc:docMk/>
            <pc:sldMk cId="3490269967" sldId="640"/>
            <ac:spMk id="53" creationId="{9AA2CCAA-4857-4631-90C0-DE0614D015BB}"/>
          </ac:spMkLst>
        </pc:spChg>
        <pc:spChg chg="mod">
          <ac:chgData name="김 남혁" userId="492584a0ac289ca9" providerId="LiveId" clId="{CE86E322-83AC-4557-A56E-E2A066842647}" dt="2020-05-11T12:06:44.590" v="285" actId="1036"/>
          <ac:spMkLst>
            <pc:docMk/>
            <pc:sldMk cId="3490269967" sldId="640"/>
            <ac:spMk id="54" creationId="{40FCCFF0-2815-4B25-85E7-858C46D7C4AC}"/>
          </ac:spMkLst>
        </pc:spChg>
        <pc:spChg chg="mod">
          <ac:chgData name="김 남혁" userId="492584a0ac289ca9" providerId="LiveId" clId="{CE86E322-83AC-4557-A56E-E2A066842647}" dt="2020-05-11T12:06:49.334" v="301" actId="1035"/>
          <ac:spMkLst>
            <pc:docMk/>
            <pc:sldMk cId="3490269967" sldId="640"/>
            <ac:spMk id="55" creationId="{8095BC85-93BB-4E7E-AA25-11DF9455613B}"/>
          </ac:spMkLst>
        </pc:spChg>
        <pc:grpChg chg="add del mod">
          <ac:chgData name="김 남혁" userId="492584a0ac289ca9" providerId="LiveId" clId="{CE86E322-83AC-4557-A56E-E2A066842647}" dt="2020-05-11T11:39:37.516" v="202" actId="478"/>
          <ac:grpSpMkLst>
            <pc:docMk/>
            <pc:sldMk cId="3490269967" sldId="640"/>
            <ac:grpSpMk id="2" creationId="{3FE99689-F531-4F35-9C8C-B8613B21B9AB}"/>
          </ac:grpSpMkLst>
        </pc:grpChg>
        <pc:grpChg chg="add mod">
          <ac:chgData name="김 남혁" userId="492584a0ac289ca9" providerId="LiveId" clId="{CE86E322-83AC-4557-A56E-E2A066842647}" dt="2020-05-11T11:42:49.161" v="240" actId="1038"/>
          <ac:grpSpMkLst>
            <pc:docMk/>
            <pc:sldMk cId="3490269967" sldId="640"/>
            <ac:grpSpMk id="38" creationId="{6150AEA8-B0DE-4433-8A9C-19053218A118}"/>
          </ac:grpSpMkLst>
        </pc:grpChg>
        <pc:grpChg chg="add del mod">
          <ac:chgData name="김 남혁" userId="492584a0ac289ca9" providerId="LiveId" clId="{CE86E322-83AC-4557-A56E-E2A066842647}" dt="2020-05-11T11:39:40.092" v="204" actId="478"/>
          <ac:grpSpMkLst>
            <pc:docMk/>
            <pc:sldMk cId="3490269967" sldId="640"/>
            <ac:grpSpMk id="117" creationId="{DFCE7656-EB62-4D43-93CC-158B0F5415D1}"/>
          </ac:grpSpMkLst>
        </pc:grpChg>
        <pc:grpChg chg="add mod">
          <ac:chgData name="김 남혁" userId="492584a0ac289ca9" providerId="LiveId" clId="{CE86E322-83AC-4557-A56E-E2A066842647}" dt="2020-05-11T11:42:39.193" v="235" actId="164"/>
          <ac:grpSpMkLst>
            <pc:docMk/>
            <pc:sldMk cId="3490269967" sldId="640"/>
            <ac:grpSpMk id="121" creationId="{2571BCE0-2AC7-48E8-B9B4-BA1C8CCEFEE4}"/>
          </ac:grpSpMkLst>
        </pc:grpChg>
        <pc:picChg chg="mod modCrop">
          <ac:chgData name="김 남혁" userId="492584a0ac289ca9" providerId="LiveId" clId="{CE86E322-83AC-4557-A56E-E2A066842647}" dt="2020-05-11T11:38:59.827" v="190" actId="1038"/>
          <ac:picMkLst>
            <pc:docMk/>
            <pc:sldMk cId="3490269967" sldId="640"/>
            <ac:picMk id="36" creationId="{A45ADFFA-9E94-4C92-B989-BBDAABDFE10F}"/>
          </ac:picMkLst>
        </pc:picChg>
        <pc:picChg chg="add del">
          <ac:chgData name="김 남혁" userId="492584a0ac289ca9" providerId="LiveId" clId="{CE86E322-83AC-4557-A56E-E2A066842647}" dt="2020-05-11T11:41:35.479" v="225" actId="478"/>
          <ac:picMkLst>
            <pc:docMk/>
            <pc:sldMk cId="3490269967" sldId="640"/>
            <ac:picMk id="51" creationId="{5BC1CEB2-4FBF-47D3-BD72-BAF361885FA3}"/>
          </ac:picMkLst>
        </pc:picChg>
        <pc:picChg chg="mod modCrop">
          <ac:chgData name="김 남혁" userId="492584a0ac289ca9" providerId="LiveId" clId="{CE86E322-83AC-4557-A56E-E2A066842647}" dt="2020-05-11T11:55:55.372" v="241" actId="18131"/>
          <ac:picMkLst>
            <pc:docMk/>
            <pc:sldMk cId="3490269967" sldId="640"/>
            <ac:picMk id="63" creationId="{BBA60586-AAE4-45F7-AB4F-354005AD3939}"/>
          </ac:picMkLst>
        </pc:picChg>
        <pc:picChg chg="add mod modCrop">
          <ac:chgData name="김 남혁" userId="492584a0ac289ca9" providerId="LiveId" clId="{CE86E322-83AC-4557-A56E-E2A066842647}" dt="2020-05-11T11:38:44.739" v="185" actId="208"/>
          <ac:picMkLst>
            <pc:docMk/>
            <pc:sldMk cId="3490269967" sldId="640"/>
            <ac:picMk id="115" creationId="{D7C0ACDF-6071-4DD4-969A-5AD4EA271B11}"/>
          </ac:picMkLst>
        </pc:picChg>
        <pc:picChg chg="add mod modCrop">
          <ac:chgData name="김 남혁" userId="492584a0ac289ca9" providerId="LiveId" clId="{CE86E322-83AC-4557-A56E-E2A066842647}" dt="2020-05-11T11:39:02.808" v="191" actId="1037"/>
          <ac:picMkLst>
            <pc:docMk/>
            <pc:sldMk cId="3490269967" sldId="640"/>
            <ac:picMk id="116" creationId="{6A66FE83-9645-4C7F-BEE4-36ACFF0652B4}"/>
          </ac:picMkLst>
        </pc:picChg>
        <pc:picChg chg="mod">
          <ac:chgData name="김 남혁" userId="492584a0ac289ca9" providerId="LiveId" clId="{CE86E322-83AC-4557-A56E-E2A066842647}" dt="2020-05-11T11:39:38.341" v="203"/>
          <ac:picMkLst>
            <pc:docMk/>
            <pc:sldMk cId="3490269967" sldId="640"/>
            <ac:picMk id="118" creationId="{533928DA-86D0-4942-B0DF-439ED6C7F308}"/>
          </ac:picMkLst>
        </pc:picChg>
        <pc:picChg chg="mod">
          <ac:chgData name="김 남혁" userId="492584a0ac289ca9" providerId="LiveId" clId="{CE86E322-83AC-4557-A56E-E2A066842647}" dt="2020-05-11T11:39:38.341" v="203"/>
          <ac:picMkLst>
            <pc:docMk/>
            <pc:sldMk cId="3490269967" sldId="640"/>
            <ac:picMk id="119" creationId="{A6D88B8F-4E07-4098-871F-70C3FCA22B18}"/>
          </ac:picMkLst>
        </pc:picChg>
        <pc:picChg chg="mod">
          <ac:chgData name="김 남혁" userId="492584a0ac289ca9" providerId="LiveId" clId="{CE86E322-83AC-4557-A56E-E2A066842647}" dt="2020-05-11T11:39:38.341" v="203"/>
          <ac:picMkLst>
            <pc:docMk/>
            <pc:sldMk cId="3490269967" sldId="640"/>
            <ac:picMk id="120" creationId="{3C5EB9AD-0479-4F54-8A6C-2F524C3185BD}"/>
          </ac:picMkLst>
        </pc:picChg>
        <pc:picChg chg="mod modCrop">
          <ac:chgData name="김 남혁" userId="492584a0ac289ca9" providerId="LiveId" clId="{CE86E322-83AC-4557-A56E-E2A066842647}" dt="2020-05-11T11:41:04.579" v="219" actId="732"/>
          <ac:picMkLst>
            <pc:docMk/>
            <pc:sldMk cId="3490269967" sldId="640"/>
            <ac:picMk id="122" creationId="{BAB2B6FC-5AFA-4331-AA88-B4A54F0683FA}"/>
          </ac:picMkLst>
        </pc:picChg>
        <pc:picChg chg="mod modCrop">
          <ac:chgData name="김 남혁" userId="492584a0ac289ca9" providerId="LiveId" clId="{CE86E322-83AC-4557-A56E-E2A066842647}" dt="2020-05-11T11:40:58.251" v="218" actId="732"/>
          <ac:picMkLst>
            <pc:docMk/>
            <pc:sldMk cId="3490269967" sldId="640"/>
            <ac:picMk id="123" creationId="{4FC3BD9B-BA8C-4DAE-9516-8293FAE31CE3}"/>
          </ac:picMkLst>
        </pc:picChg>
        <pc:picChg chg="mod modCrop">
          <ac:chgData name="김 남혁" userId="492584a0ac289ca9" providerId="LiveId" clId="{CE86E322-83AC-4557-A56E-E2A066842647}" dt="2020-05-11T11:41:21.325" v="222" actId="732"/>
          <ac:picMkLst>
            <pc:docMk/>
            <pc:sldMk cId="3490269967" sldId="640"/>
            <ac:picMk id="124" creationId="{F509F79B-CA54-4709-8269-FF854A56B211}"/>
          </ac:picMkLst>
        </pc:picChg>
        <pc:cxnChg chg="mod">
          <ac:chgData name="김 남혁" userId="492584a0ac289ca9" providerId="LiveId" clId="{CE86E322-83AC-4557-A56E-E2A066842647}" dt="2020-05-11T12:06:44.590" v="285" actId="1036"/>
          <ac:cxnSpMkLst>
            <pc:docMk/>
            <pc:sldMk cId="3490269967" sldId="640"/>
            <ac:cxnSpMk id="57" creationId="{5F09FB74-4A73-42C9-B284-364D9F3781A6}"/>
          </ac:cxnSpMkLst>
        </pc:cxnChg>
        <pc:cxnChg chg="mod">
          <ac:chgData name="김 남혁" userId="492584a0ac289ca9" providerId="LiveId" clId="{CE86E322-83AC-4557-A56E-E2A066842647}" dt="2020-05-11T12:06:19.192" v="266" actId="1036"/>
          <ac:cxnSpMkLst>
            <pc:docMk/>
            <pc:sldMk cId="3490269967" sldId="640"/>
            <ac:cxnSpMk id="58" creationId="{B1A3E002-87AB-41C3-BC4B-46C7DA3FDFD7}"/>
          </ac:cxnSpMkLst>
        </pc:cxnChg>
        <pc:cxnChg chg="mod">
          <ac:chgData name="김 남혁" userId="492584a0ac289ca9" providerId="LiveId" clId="{CE86E322-83AC-4557-A56E-E2A066842647}" dt="2020-05-11T12:06:38.503" v="274" actId="1035"/>
          <ac:cxnSpMkLst>
            <pc:docMk/>
            <pc:sldMk cId="3490269967" sldId="640"/>
            <ac:cxnSpMk id="59" creationId="{3D6563E2-05DF-44A1-9BAB-7125BE7194C7}"/>
          </ac:cxnSpMkLst>
        </pc:cxnChg>
        <pc:cxnChg chg="mod">
          <ac:chgData name="김 남혁" userId="492584a0ac289ca9" providerId="LiveId" clId="{CE86E322-83AC-4557-A56E-E2A066842647}" dt="2020-05-11T12:06:49.334" v="301" actId="1035"/>
          <ac:cxnSpMkLst>
            <pc:docMk/>
            <pc:sldMk cId="3490269967" sldId="640"/>
            <ac:cxnSpMk id="60" creationId="{E76BC347-9B8F-4AA0-8EFE-F29B884A3976}"/>
          </ac:cxnSpMkLst>
        </pc:cxn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8EEC43-6F5E-4B28-A4CF-62BA4709CFA4}" type="datetimeFigureOut">
              <a:rPr lang="ko-KR" altLang="en-US" smtClean="0"/>
              <a:t>2020-10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6A9F55-083C-4192-995B-2CE0C95781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487215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09D7C8-102B-424F-969C-F464CCE2EE24}" type="datetimeFigureOut">
              <a:rPr lang="ko-KR" altLang="en-US" smtClean="0"/>
              <a:t>2020-10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BB9C59-AC2F-4D34-BF67-1EC3EDB96E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53011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BB9C59-AC2F-4D34-BF67-1EC3EDB96E1C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89932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8371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45978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1599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4883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6298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7381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7157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0190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74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6454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26891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457885-F50C-4DC0-8E7E-6128374DF3E7}" type="datetimeFigureOut">
              <a:rPr lang="ko-KR" altLang="en-US" smtClean="0"/>
              <a:pPr/>
              <a:t>2020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E0B34-C6BB-40C6-82EF-0BB59B6A336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179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7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377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2FB72DD9-B98A-4DBF-BC26-7DE84718C974}"/>
              </a:ext>
            </a:extLst>
          </p:cNvPr>
          <p:cNvSpPr txBox="1"/>
          <p:nvPr/>
        </p:nvSpPr>
        <p:spPr>
          <a:xfrm>
            <a:off x="1337673" y="1730307"/>
            <a:ext cx="543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AB16E8A-19E3-4C74-A53A-9EFD76360A44}"/>
              </a:ext>
            </a:extLst>
          </p:cNvPr>
          <p:cNvSpPr txBox="1"/>
          <p:nvPr/>
        </p:nvSpPr>
        <p:spPr>
          <a:xfrm>
            <a:off x="5955477" y="1730307"/>
            <a:ext cx="543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C0551AF-87B9-4411-9595-D1971A0A53A0}"/>
              </a:ext>
            </a:extLst>
          </p:cNvPr>
          <p:cNvSpPr txBox="1"/>
          <p:nvPr/>
        </p:nvSpPr>
        <p:spPr>
          <a:xfrm>
            <a:off x="2917" y="-7519"/>
            <a:ext cx="249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개체 2">
            <a:extLst>
              <a:ext uri="{FF2B5EF4-FFF2-40B4-BE49-F238E27FC236}">
                <a16:creationId xmlns:a16="http://schemas.microsoft.com/office/drawing/2014/main" id="{82BB93F1-2FDB-4D71-B0C4-91C9876898B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57714" y="2195826"/>
          <a:ext cx="3836987" cy="2709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0" name="Prism 8" r:id="rId4" imgW="3837113" imgH="2709431" progId="Prism8.Document">
                  <p:embed/>
                </p:oleObj>
              </mc:Choice>
              <mc:Fallback>
                <p:oleObj name="Prism 8" r:id="rId4" imgW="3837113" imgH="2709431" progId="Prism8.Document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82BB93F1-2FDB-4D71-B0C4-91C9876898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57714" y="2195826"/>
                        <a:ext cx="3836987" cy="2709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EF8C4590-4204-4E14-96E7-6D1831F7475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34843" y="2195826"/>
          <a:ext cx="4413250" cy="2709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1" name="Prism 8" r:id="rId6" imgW="4413040" imgH="2709431" progId="Prism8.Document">
                  <p:embed/>
                </p:oleObj>
              </mc:Choice>
              <mc:Fallback>
                <p:oleObj name="Prism 8" r:id="rId6" imgW="4413040" imgH="2709431" progId="Prism8.Document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EF8C4590-4204-4E14-96E7-6D1831F747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434843" y="2195826"/>
                        <a:ext cx="4413250" cy="2709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F4C4279D-8040-416A-A489-D8D99161E6FB}"/>
              </a:ext>
            </a:extLst>
          </p:cNvPr>
          <p:cNvSpPr txBox="1"/>
          <p:nvPr/>
        </p:nvSpPr>
        <p:spPr>
          <a:xfrm>
            <a:off x="0" y="300258"/>
            <a:ext cx="249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8844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2">
            <a:extLst>
              <a:ext uri="{FF2B5EF4-FFF2-40B4-BE49-F238E27FC236}">
                <a16:creationId xmlns:a16="http://schemas.microsoft.com/office/drawing/2014/main" id="{9B94B3E1-664E-435F-B30B-A211033169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3095903"/>
              </p:ext>
            </p:extLst>
          </p:nvPr>
        </p:nvGraphicFramePr>
        <p:xfrm>
          <a:off x="2495186" y="411480"/>
          <a:ext cx="3209364" cy="6035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69788">
                  <a:extLst>
                    <a:ext uri="{9D8B030D-6E8A-4147-A177-3AD203B41FA5}">
                      <a16:colId xmlns:a16="http://schemas.microsoft.com/office/drawing/2014/main" val="1381874549"/>
                    </a:ext>
                  </a:extLst>
                </a:gridCol>
                <a:gridCol w="1069788">
                  <a:extLst>
                    <a:ext uri="{9D8B030D-6E8A-4147-A177-3AD203B41FA5}">
                      <a16:colId xmlns:a16="http://schemas.microsoft.com/office/drawing/2014/main" val="3609676119"/>
                    </a:ext>
                  </a:extLst>
                </a:gridCol>
                <a:gridCol w="1069788">
                  <a:extLst>
                    <a:ext uri="{9D8B030D-6E8A-4147-A177-3AD203B41FA5}">
                      <a16:colId xmlns:a16="http://schemas.microsoft.com/office/drawing/2014/main" val="3156579135"/>
                    </a:ext>
                  </a:extLst>
                </a:gridCol>
              </a:tblGrid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(s)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cription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7861975"/>
                  </a:ext>
                </a:extLst>
              </a:tr>
              <a:tr h="213360"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9 (1-124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9179773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5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L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5602692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-71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 helix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8895696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-124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L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7606172"/>
                  </a:ext>
                </a:extLst>
              </a:tr>
              <a:tr h="213360">
                <a:tc gridSpan="3"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4 (125-488)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just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9899207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-146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term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1725544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-170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 1 helix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6064644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1-18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L 1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9576469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3-207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37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 2 helix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8926738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-21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L 1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265690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6-248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37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 3 helix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2993700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9-261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L 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5470731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2-286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37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 4 helix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1098988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7-308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L 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4670646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9-339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37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 5 helix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6059515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0-39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L 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4542339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4-42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37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 6 helix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381637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3-436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L 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8406969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7-460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377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 7 helix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4103175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1-477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lix 8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4956471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8-49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term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2572547"/>
                  </a:ext>
                </a:extLst>
              </a:tr>
            </a:tbl>
          </a:graphicData>
        </a:graphic>
      </p:graphicFrame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BF131C7E-034C-4029-A2C1-2822A8FA29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4416034"/>
              </p:ext>
            </p:extLst>
          </p:nvPr>
        </p:nvGraphicFramePr>
        <p:xfrm>
          <a:off x="5939681" y="1780970"/>
          <a:ext cx="4319451" cy="1188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02081">
                  <a:extLst>
                    <a:ext uri="{9D8B030D-6E8A-4147-A177-3AD203B41FA5}">
                      <a16:colId xmlns:a16="http://schemas.microsoft.com/office/drawing/2014/main" val="1962752129"/>
                    </a:ext>
                  </a:extLst>
                </a:gridCol>
                <a:gridCol w="1497874">
                  <a:extLst>
                    <a:ext uri="{9D8B030D-6E8A-4147-A177-3AD203B41FA5}">
                      <a16:colId xmlns:a16="http://schemas.microsoft.com/office/drawing/2014/main" val="360144330"/>
                    </a:ext>
                  </a:extLst>
                </a:gridCol>
                <a:gridCol w="1419496">
                  <a:extLst>
                    <a:ext uri="{9D8B030D-6E8A-4147-A177-3AD203B41FA5}">
                      <a16:colId xmlns:a16="http://schemas.microsoft.com/office/drawing/2014/main" val="1728620161"/>
                    </a:ext>
                  </a:extLst>
                </a:gridCol>
              </a:tblGrid>
              <a:tr h="213360">
                <a:tc>
                  <a:txBody>
                    <a:bodyPr/>
                    <a:lstStyle/>
                    <a:p>
                      <a:pPr algn="just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</a:t>
                      </a:r>
                    </a:p>
                    <a:p>
                      <a:pPr algn="ctr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ino acids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</a:t>
                      </a:r>
                      <a:r>
                        <a:rPr lang="en-US" altLang="ko-KR" sz="12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 of helical region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6775422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2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just" latinLnBrk="1"/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0575362"/>
                  </a:ext>
                </a:extLst>
              </a:tr>
              <a:tr h="213360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m of </a:t>
                      </a: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altLang="ko-KR" sz="12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helical</a:t>
                      </a:r>
                      <a:r>
                        <a:rPr lang="en-US" altLang="ko-KR" sz="12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gion</a:t>
                      </a:r>
                      <a:endParaRPr lang="ko-KR" altLang="en-US" sz="12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3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ko-KR" alt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1059994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025C43C-A6F4-4573-81C0-2B4039A97B45}"/>
              </a:ext>
            </a:extLst>
          </p:cNvPr>
          <p:cNvSpPr txBox="1"/>
          <p:nvPr/>
        </p:nvSpPr>
        <p:spPr>
          <a:xfrm>
            <a:off x="5939681" y="411480"/>
            <a:ext cx="3379694" cy="8891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*TM: Transmembrane</a:t>
            </a:r>
          </a:p>
          <a:p>
            <a:pPr>
              <a:lnSpc>
                <a:spcPct val="150000"/>
              </a:lnSpc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*ICL: Intracellular domain</a:t>
            </a:r>
          </a:p>
          <a:p>
            <a:pPr>
              <a:lnSpc>
                <a:spcPct val="150000"/>
              </a:lnSpc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*ECL: Extracellular doma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BEC7300-B861-4745-AE4E-67AF57713FD7}"/>
              </a:ext>
            </a:extLst>
          </p:cNvPr>
          <p:cNvSpPr txBox="1"/>
          <p:nvPr/>
        </p:nvSpPr>
        <p:spPr>
          <a:xfrm>
            <a:off x="2917" y="-7519"/>
            <a:ext cx="249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6047127-9382-4E2C-B592-356D97D96C1E}"/>
              </a:ext>
            </a:extLst>
          </p:cNvPr>
          <p:cNvSpPr txBox="1"/>
          <p:nvPr/>
        </p:nvSpPr>
        <p:spPr>
          <a:xfrm>
            <a:off x="0" y="300258"/>
            <a:ext cx="24951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5087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40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64</TotalTime>
  <Words>139</Words>
  <Application>Microsoft Office PowerPoint</Application>
  <PresentationFormat>와이드스크린</PresentationFormat>
  <Paragraphs>80</Paragraphs>
  <Slides>2</Slides>
  <Notes>1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Symbol</vt:lpstr>
      <vt:lpstr>Office 테마</vt:lpstr>
      <vt:lpstr>Prism 8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남혁</dc:creator>
  <cp:lastModifiedBy>김 남혁</cp:lastModifiedBy>
  <cp:revision>1080</cp:revision>
  <cp:lastPrinted>2018-08-13T06:58:08Z</cp:lastPrinted>
  <dcterms:created xsi:type="dcterms:W3CDTF">2017-07-09T12:00:16Z</dcterms:created>
  <dcterms:modified xsi:type="dcterms:W3CDTF">2020-10-15T06:10:22Z</dcterms:modified>
</cp:coreProperties>
</file>